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>
      <p:cViewPr>
        <p:scale>
          <a:sx n="208" d="100"/>
          <a:sy n="208" d="100"/>
        </p:scale>
        <p:origin x="-16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04664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4565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4654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61263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40111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7949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7028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7376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93105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5903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1824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C1E29-6ED7-403D-B3D3-0CDAE2FD2343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A6492-B31D-44F4-B460-DDC33CA271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4031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5"/>
          <p:cNvSpPr>
            <a:spLocks noEditPoints="1"/>
          </p:cNvSpPr>
          <p:nvPr/>
        </p:nvSpPr>
        <p:spPr bwMode="auto">
          <a:xfrm>
            <a:off x="1308885" y="1079806"/>
            <a:ext cx="4006850" cy="2049463"/>
          </a:xfrm>
          <a:custGeom>
            <a:avLst/>
            <a:gdLst>
              <a:gd name="T0" fmla="*/ 0 w 10097"/>
              <a:gd name="T1" fmla="*/ 0 h 5162"/>
              <a:gd name="T2" fmla="*/ 479 w 10097"/>
              <a:gd name="T3" fmla="*/ 0 h 5162"/>
              <a:gd name="T4" fmla="*/ 479 w 10097"/>
              <a:gd name="T5" fmla="*/ 5162 h 5162"/>
              <a:gd name="T6" fmla="*/ 0 w 10097"/>
              <a:gd name="T7" fmla="*/ 5162 h 5162"/>
              <a:gd name="T8" fmla="*/ 0 w 10097"/>
              <a:gd name="T9" fmla="*/ 0 h 5162"/>
              <a:gd name="T10" fmla="*/ 1213 w 10097"/>
              <a:gd name="T11" fmla="*/ 1072 h 5162"/>
              <a:gd name="T12" fmla="*/ 1692 w 10097"/>
              <a:gd name="T13" fmla="*/ 1072 h 5162"/>
              <a:gd name="T14" fmla="*/ 1692 w 10097"/>
              <a:gd name="T15" fmla="*/ 5162 h 5162"/>
              <a:gd name="T16" fmla="*/ 1213 w 10097"/>
              <a:gd name="T17" fmla="*/ 5162 h 5162"/>
              <a:gd name="T18" fmla="*/ 1213 w 10097"/>
              <a:gd name="T19" fmla="*/ 1072 h 5162"/>
              <a:gd name="T20" fmla="*/ 2426 w 10097"/>
              <a:gd name="T21" fmla="*/ 1354 h 5162"/>
              <a:gd name="T22" fmla="*/ 2905 w 10097"/>
              <a:gd name="T23" fmla="*/ 1354 h 5162"/>
              <a:gd name="T24" fmla="*/ 2905 w 10097"/>
              <a:gd name="T25" fmla="*/ 5162 h 5162"/>
              <a:gd name="T26" fmla="*/ 2426 w 10097"/>
              <a:gd name="T27" fmla="*/ 5162 h 5162"/>
              <a:gd name="T28" fmla="*/ 2426 w 10097"/>
              <a:gd name="T29" fmla="*/ 1354 h 5162"/>
              <a:gd name="T30" fmla="*/ 3610 w 10097"/>
              <a:gd name="T31" fmla="*/ 1975 h 5162"/>
              <a:gd name="T32" fmla="*/ 4089 w 10097"/>
              <a:gd name="T33" fmla="*/ 1975 h 5162"/>
              <a:gd name="T34" fmla="*/ 4089 w 10097"/>
              <a:gd name="T35" fmla="*/ 5162 h 5162"/>
              <a:gd name="T36" fmla="*/ 3610 w 10097"/>
              <a:gd name="T37" fmla="*/ 5162 h 5162"/>
              <a:gd name="T38" fmla="*/ 3610 w 10097"/>
              <a:gd name="T39" fmla="*/ 1975 h 5162"/>
              <a:gd name="T40" fmla="*/ 4823 w 10097"/>
              <a:gd name="T41" fmla="*/ 2257 h 5162"/>
              <a:gd name="T42" fmla="*/ 5302 w 10097"/>
              <a:gd name="T43" fmla="*/ 2257 h 5162"/>
              <a:gd name="T44" fmla="*/ 5302 w 10097"/>
              <a:gd name="T45" fmla="*/ 5162 h 5162"/>
              <a:gd name="T46" fmla="*/ 4823 w 10097"/>
              <a:gd name="T47" fmla="*/ 5162 h 5162"/>
              <a:gd name="T48" fmla="*/ 4823 w 10097"/>
              <a:gd name="T49" fmla="*/ 2257 h 5162"/>
              <a:gd name="T50" fmla="*/ 6007 w 10097"/>
              <a:gd name="T51" fmla="*/ 2539 h 5162"/>
              <a:gd name="T52" fmla="*/ 6515 w 10097"/>
              <a:gd name="T53" fmla="*/ 2539 h 5162"/>
              <a:gd name="T54" fmla="*/ 6515 w 10097"/>
              <a:gd name="T55" fmla="*/ 5162 h 5162"/>
              <a:gd name="T56" fmla="*/ 6007 w 10097"/>
              <a:gd name="T57" fmla="*/ 5162 h 5162"/>
              <a:gd name="T58" fmla="*/ 6007 w 10097"/>
              <a:gd name="T59" fmla="*/ 2539 h 5162"/>
              <a:gd name="T60" fmla="*/ 7220 w 10097"/>
              <a:gd name="T61" fmla="*/ 2369 h 5162"/>
              <a:gd name="T62" fmla="*/ 7700 w 10097"/>
              <a:gd name="T63" fmla="*/ 2369 h 5162"/>
              <a:gd name="T64" fmla="*/ 7700 w 10097"/>
              <a:gd name="T65" fmla="*/ 5162 h 5162"/>
              <a:gd name="T66" fmla="*/ 7220 w 10097"/>
              <a:gd name="T67" fmla="*/ 5162 h 5162"/>
              <a:gd name="T68" fmla="*/ 7220 w 10097"/>
              <a:gd name="T69" fmla="*/ 2369 h 5162"/>
              <a:gd name="T70" fmla="*/ 8433 w 10097"/>
              <a:gd name="T71" fmla="*/ 3272 h 5162"/>
              <a:gd name="T72" fmla="*/ 8913 w 10097"/>
              <a:gd name="T73" fmla="*/ 3272 h 5162"/>
              <a:gd name="T74" fmla="*/ 8913 w 10097"/>
              <a:gd name="T75" fmla="*/ 5162 h 5162"/>
              <a:gd name="T76" fmla="*/ 8433 w 10097"/>
              <a:gd name="T77" fmla="*/ 5162 h 5162"/>
              <a:gd name="T78" fmla="*/ 8433 w 10097"/>
              <a:gd name="T79" fmla="*/ 3272 h 5162"/>
              <a:gd name="T80" fmla="*/ 9618 w 10097"/>
              <a:gd name="T81" fmla="*/ 3356 h 5162"/>
              <a:gd name="T82" fmla="*/ 10097 w 10097"/>
              <a:gd name="T83" fmla="*/ 3356 h 5162"/>
              <a:gd name="T84" fmla="*/ 10097 w 10097"/>
              <a:gd name="T85" fmla="*/ 5162 h 5162"/>
              <a:gd name="T86" fmla="*/ 9618 w 10097"/>
              <a:gd name="T87" fmla="*/ 5162 h 5162"/>
              <a:gd name="T88" fmla="*/ 9618 w 10097"/>
              <a:gd name="T89" fmla="*/ 3356 h 5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0097" h="5162">
                <a:moveTo>
                  <a:pt x="0" y="0"/>
                </a:moveTo>
                <a:lnTo>
                  <a:pt x="479" y="0"/>
                </a:lnTo>
                <a:lnTo>
                  <a:pt x="479" y="5162"/>
                </a:lnTo>
                <a:lnTo>
                  <a:pt x="0" y="5162"/>
                </a:lnTo>
                <a:lnTo>
                  <a:pt x="0" y="0"/>
                </a:lnTo>
                <a:close/>
                <a:moveTo>
                  <a:pt x="1213" y="1072"/>
                </a:moveTo>
                <a:lnTo>
                  <a:pt x="1692" y="1072"/>
                </a:lnTo>
                <a:lnTo>
                  <a:pt x="1692" y="5162"/>
                </a:lnTo>
                <a:lnTo>
                  <a:pt x="1213" y="5162"/>
                </a:lnTo>
                <a:lnTo>
                  <a:pt x="1213" y="1072"/>
                </a:lnTo>
                <a:close/>
                <a:moveTo>
                  <a:pt x="2426" y="1354"/>
                </a:moveTo>
                <a:lnTo>
                  <a:pt x="2905" y="1354"/>
                </a:lnTo>
                <a:lnTo>
                  <a:pt x="2905" y="5162"/>
                </a:lnTo>
                <a:lnTo>
                  <a:pt x="2426" y="5162"/>
                </a:lnTo>
                <a:lnTo>
                  <a:pt x="2426" y="1354"/>
                </a:lnTo>
                <a:close/>
                <a:moveTo>
                  <a:pt x="3610" y="1975"/>
                </a:moveTo>
                <a:lnTo>
                  <a:pt x="4089" y="1975"/>
                </a:lnTo>
                <a:lnTo>
                  <a:pt x="4089" y="5162"/>
                </a:lnTo>
                <a:lnTo>
                  <a:pt x="3610" y="5162"/>
                </a:lnTo>
                <a:lnTo>
                  <a:pt x="3610" y="1975"/>
                </a:lnTo>
                <a:close/>
                <a:moveTo>
                  <a:pt x="4823" y="2257"/>
                </a:moveTo>
                <a:lnTo>
                  <a:pt x="5302" y="2257"/>
                </a:lnTo>
                <a:lnTo>
                  <a:pt x="5302" y="5162"/>
                </a:lnTo>
                <a:lnTo>
                  <a:pt x="4823" y="5162"/>
                </a:lnTo>
                <a:lnTo>
                  <a:pt x="4823" y="2257"/>
                </a:lnTo>
                <a:close/>
                <a:moveTo>
                  <a:pt x="6007" y="2539"/>
                </a:moveTo>
                <a:lnTo>
                  <a:pt x="6515" y="2539"/>
                </a:lnTo>
                <a:lnTo>
                  <a:pt x="6515" y="5162"/>
                </a:lnTo>
                <a:lnTo>
                  <a:pt x="6007" y="5162"/>
                </a:lnTo>
                <a:lnTo>
                  <a:pt x="6007" y="2539"/>
                </a:lnTo>
                <a:close/>
                <a:moveTo>
                  <a:pt x="7220" y="2369"/>
                </a:moveTo>
                <a:lnTo>
                  <a:pt x="7700" y="2369"/>
                </a:lnTo>
                <a:lnTo>
                  <a:pt x="7700" y="5162"/>
                </a:lnTo>
                <a:lnTo>
                  <a:pt x="7220" y="5162"/>
                </a:lnTo>
                <a:lnTo>
                  <a:pt x="7220" y="2369"/>
                </a:lnTo>
                <a:close/>
                <a:moveTo>
                  <a:pt x="8433" y="3272"/>
                </a:moveTo>
                <a:lnTo>
                  <a:pt x="8913" y="3272"/>
                </a:lnTo>
                <a:lnTo>
                  <a:pt x="8913" y="5162"/>
                </a:lnTo>
                <a:lnTo>
                  <a:pt x="8433" y="5162"/>
                </a:lnTo>
                <a:lnTo>
                  <a:pt x="8433" y="3272"/>
                </a:lnTo>
                <a:close/>
                <a:moveTo>
                  <a:pt x="9618" y="3356"/>
                </a:moveTo>
                <a:lnTo>
                  <a:pt x="10097" y="3356"/>
                </a:lnTo>
                <a:lnTo>
                  <a:pt x="10097" y="5162"/>
                </a:lnTo>
                <a:lnTo>
                  <a:pt x="9618" y="5162"/>
                </a:lnTo>
                <a:lnTo>
                  <a:pt x="9618" y="3356"/>
                </a:lnTo>
                <a:close/>
              </a:path>
            </a:pathLst>
          </a:custGeom>
          <a:solidFill>
            <a:srgbClr val="5B9BD5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Freeform 6"/>
          <p:cNvSpPr>
            <a:spLocks noEditPoints="1"/>
          </p:cNvSpPr>
          <p:nvPr/>
        </p:nvSpPr>
        <p:spPr bwMode="auto">
          <a:xfrm>
            <a:off x="1364448" y="1002019"/>
            <a:ext cx="66675" cy="144463"/>
          </a:xfrm>
          <a:custGeom>
            <a:avLst/>
            <a:gdLst>
              <a:gd name="T0" fmla="*/ 84 w 168"/>
              <a:gd name="T1" fmla="*/ 197 h 366"/>
              <a:gd name="T2" fmla="*/ 84 w 168"/>
              <a:gd name="T3" fmla="*/ 366 h 366"/>
              <a:gd name="T4" fmla="*/ 84 w 168"/>
              <a:gd name="T5" fmla="*/ 197 h 366"/>
              <a:gd name="T6" fmla="*/ 84 w 168"/>
              <a:gd name="T7" fmla="*/ 197 h 366"/>
              <a:gd name="T8" fmla="*/ 84 w 168"/>
              <a:gd name="T9" fmla="*/ 0 h 366"/>
              <a:gd name="T10" fmla="*/ 84 w 168"/>
              <a:gd name="T11" fmla="*/ 197 h 366"/>
              <a:gd name="T12" fmla="*/ 0 w 168"/>
              <a:gd name="T13" fmla="*/ 366 h 366"/>
              <a:gd name="T14" fmla="*/ 168 w 168"/>
              <a:gd name="T15" fmla="*/ 366 h 366"/>
              <a:gd name="T16" fmla="*/ 0 w 168"/>
              <a:gd name="T17" fmla="*/ 366 h 366"/>
              <a:gd name="T18" fmla="*/ 0 w 168"/>
              <a:gd name="T19" fmla="*/ 0 h 366"/>
              <a:gd name="T20" fmla="*/ 168 w 168"/>
              <a:gd name="T21" fmla="*/ 0 h 366"/>
              <a:gd name="T22" fmla="*/ 0 w 168"/>
              <a:gd name="T23" fmla="*/ 0 h 3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8" h="366">
                <a:moveTo>
                  <a:pt x="84" y="197"/>
                </a:moveTo>
                <a:lnTo>
                  <a:pt x="84" y="366"/>
                </a:lnTo>
                <a:lnTo>
                  <a:pt x="84" y="197"/>
                </a:lnTo>
                <a:close/>
                <a:moveTo>
                  <a:pt x="84" y="197"/>
                </a:moveTo>
                <a:lnTo>
                  <a:pt x="84" y="0"/>
                </a:lnTo>
                <a:lnTo>
                  <a:pt x="84" y="197"/>
                </a:lnTo>
                <a:close/>
                <a:moveTo>
                  <a:pt x="0" y="366"/>
                </a:moveTo>
                <a:lnTo>
                  <a:pt x="168" y="366"/>
                </a:lnTo>
                <a:lnTo>
                  <a:pt x="0" y="366"/>
                </a:lnTo>
                <a:close/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Freeform 7"/>
          <p:cNvSpPr>
            <a:spLocks/>
          </p:cNvSpPr>
          <p:nvPr/>
        </p:nvSpPr>
        <p:spPr bwMode="auto">
          <a:xfrm>
            <a:off x="1397785" y="1079806"/>
            <a:ext cx="0" cy="66675"/>
          </a:xfrm>
          <a:custGeom>
            <a:avLst/>
            <a:gdLst>
              <a:gd name="T0" fmla="*/ 0 h 169"/>
              <a:gd name="T1" fmla="*/ 169 h 169"/>
              <a:gd name="T2" fmla="*/ 0 h 16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9">
                <a:moveTo>
                  <a:pt x="0" y="0"/>
                </a:moveTo>
                <a:lnTo>
                  <a:pt x="0" y="169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Freeform 8"/>
          <p:cNvSpPr>
            <a:spLocks/>
          </p:cNvSpPr>
          <p:nvPr/>
        </p:nvSpPr>
        <p:spPr bwMode="auto">
          <a:xfrm>
            <a:off x="1397785" y="1002019"/>
            <a:ext cx="0" cy="77788"/>
          </a:xfrm>
          <a:custGeom>
            <a:avLst/>
            <a:gdLst>
              <a:gd name="T0" fmla="*/ 197 h 197"/>
              <a:gd name="T1" fmla="*/ 0 h 197"/>
              <a:gd name="T2" fmla="*/ 197 h 1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7">
                <a:moveTo>
                  <a:pt x="0" y="197"/>
                </a:moveTo>
                <a:lnTo>
                  <a:pt x="0" y="0"/>
                </a:lnTo>
                <a:lnTo>
                  <a:pt x="0" y="197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Freeform 9"/>
          <p:cNvSpPr>
            <a:spLocks/>
          </p:cNvSpPr>
          <p:nvPr/>
        </p:nvSpPr>
        <p:spPr bwMode="auto">
          <a:xfrm>
            <a:off x="1364448" y="1156007"/>
            <a:ext cx="66675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Freeform 10"/>
          <p:cNvSpPr>
            <a:spLocks/>
          </p:cNvSpPr>
          <p:nvPr/>
        </p:nvSpPr>
        <p:spPr bwMode="auto">
          <a:xfrm>
            <a:off x="1364448" y="1002019"/>
            <a:ext cx="66675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Freeform 11"/>
          <p:cNvSpPr>
            <a:spLocks noEditPoints="1"/>
          </p:cNvSpPr>
          <p:nvPr/>
        </p:nvSpPr>
        <p:spPr bwMode="auto">
          <a:xfrm>
            <a:off x="1845460" y="1381431"/>
            <a:ext cx="66675" cy="236538"/>
          </a:xfrm>
          <a:custGeom>
            <a:avLst/>
            <a:gdLst>
              <a:gd name="T0" fmla="*/ 83 w 168"/>
              <a:gd name="T1" fmla="*/ 311 h 593"/>
              <a:gd name="T2" fmla="*/ 83 w 168"/>
              <a:gd name="T3" fmla="*/ 593 h 593"/>
              <a:gd name="T4" fmla="*/ 83 w 168"/>
              <a:gd name="T5" fmla="*/ 311 h 593"/>
              <a:gd name="T6" fmla="*/ 83 w 168"/>
              <a:gd name="T7" fmla="*/ 311 h 593"/>
              <a:gd name="T8" fmla="*/ 83 w 168"/>
              <a:gd name="T9" fmla="*/ 0 h 593"/>
              <a:gd name="T10" fmla="*/ 83 w 168"/>
              <a:gd name="T11" fmla="*/ 311 h 593"/>
              <a:gd name="T12" fmla="*/ 0 w 168"/>
              <a:gd name="T13" fmla="*/ 593 h 593"/>
              <a:gd name="T14" fmla="*/ 168 w 168"/>
              <a:gd name="T15" fmla="*/ 593 h 593"/>
              <a:gd name="T16" fmla="*/ 0 w 168"/>
              <a:gd name="T17" fmla="*/ 593 h 593"/>
              <a:gd name="T18" fmla="*/ 0 w 168"/>
              <a:gd name="T19" fmla="*/ 0 h 593"/>
              <a:gd name="T20" fmla="*/ 168 w 168"/>
              <a:gd name="T21" fmla="*/ 0 h 593"/>
              <a:gd name="T22" fmla="*/ 0 w 168"/>
              <a:gd name="T23" fmla="*/ 0 h 5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8" h="593">
                <a:moveTo>
                  <a:pt x="83" y="311"/>
                </a:moveTo>
                <a:lnTo>
                  <a:pt x="83" y="593"/>
                </a:lnTo>
                <a:lnTo>
                  <a:pt x="83" y="311"/>
                </a:lnTo>
                <a:close/>
                <a:moveTo>
                  <a:pt x="83" y="311"/>
                </a:moveTo>
                <a:lnTo>
                  <a:pt x="83" y="0"/>
                </a:lnTo>
                <a:lnTo>
                  <a:pt x="83" y="311"/>
                </a:lnTo>
                <a:close/>
                <a:moveTo>
                  <a:pt x="0" y="593"/>
                </a:moveTo>
                <a:lnTo>
                  <a:pt x="168" y="593"/>
                </a:lnTo>
                <a:lnTo>
                  <a:pt x="0" y="593"/>
                </a:lnTo>
                <a:close/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Freeform 12"/>
          <p:cNvSpPr>
            <a:spLocks/>
          </p:cNvSpPr>
          <p:nvPr/>
        </p:nvSpPr>
        <p:spPr bwMode="auto">
          <a:xfrm>
            <a:off x="1878798" y="1505256"/>
            <a:ext cx="0" cy="112713"/>
          </a:xfrm>
          <a:custGeom>
            <a:avLst/>
            <a:gdLst>
              <a:gd name="T0" fmla="*/ 0 h 282"/>
              <a:gd name="T1" fmla="*/ 282 h 282"/>
              <a:gd name="T2" fmla="*/ 0 h 2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2">
                <a:moveTo>
                  <a:pt x="0" y="0"/>
                </a:moveTo>
                <a:lnTo>
                  <a:pt x="0" y="282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Freeform 13"/>
          <p:cNvSpPr>
            <a:spLocks/>
          </p:cNvSpPr>
          <p:nvPr/>
        </p:nvSpPr>
        <p:spPr bwMode="auto">
          <a:xfrm>
            <a:off x="1878798" y="1381431"/>
            <a:ext cx="0" cy="123825"/>
          </a:xfrm>
          <a:custGeom>
            <a:avLst/>
            <a:gdLst>
              <a:gd name="T0" fmla="*/ 311 h 311"/>
              <a:gd name="T1" fmla="*/ 0 h 311"/>
              <a:gd name="T2" fmla="*/ 311 h 31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1">
                <a:moveTo>
                  <a:pt x="0" y="311"/>
                </a:moveTo>
                <a:lnTo>
                  <a:pt x="0" y="0"/>
                </a:lnTo>
                <a:lnTo>
                  <a:pt x="0" y="311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Freeform 14"/>
          <p:cNvSpPr>
            <a:spLocks/>
          </p:cNvSpPr>
          <p:nvPr/>
        </p:nvSpPr>
        <p:spPr bwMode="auto">
          <a:xfrm>
            <a:off x="1845460" y="1627495"/>
            <a:ext cx="66675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Freeform 15"/>
          <p:cNvSpPr>
            <a:spLocks/>
          </p:cNvSpPr>
          <p:nvPr/>
        </p:nvSpPr>
        <p:spPr bwMode="auto">
          <a:xfrm>
            <a:off x="1845460" y="1381431"/>
            <a:ext cx="66675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Freeform 16"/>
          <p:cNvSpPr>
            <a:spLocks noEditPoints="1"/>
          </p:cNvSpPr>
          <p:nvPr/>
        </p:nvSpPr>
        <p:spPr bwMode="auto">
          <a:xfrm>
            <a:off x="2326473" y="1494144"/>
            <a:ext cx="68263" cy="234950"/>
          </a:xfrm>
          <a:custGeom>
            <a:avLst/>
            <a:gdLst>
              <a:gd name="T0" fmla="*/ 83 w 168"/>
              <a:gd name="T1" fmla="*/ 310 h 592"/>
              <a:gd name="T2" fmla="*/ 83 w 168"/>
              <a:gd name="T3" fmla="*/ 592 h 592"/>
              <a:gd name="T4" fmla="*/ 83 w 168"/>
              <a:gd name="T5" fmla="*/ 310 h 592"/>
              <a:gd name="T6" fmla="*/ 83 w 168"/>
              <a:gd name="T7" fmla="*/ 310 h 592"/>
              <a:gd name="T8" fmla="*/ 83 w 168"/>
              <a:gd name="T9" fmla="*/ 0 h 592"/>
              <a:gd name="T10" fmla="*/ 83 w 168"/>
              <a:gd name="T11" fmla="*/ 310 h 592"/>
              <a:gd name="T12" fmla="*/ 0 w 168"/>
              <a:gd name="T13" fmla="*/ 592 h 592"/>
              <a:gd name="T14" fmla="*/ 168 w 168"/>
              <a:gd name="T15" fmla="*/ 592 h 592"/>
              <a:gd name="T16" fmla="*/ 0 w 168"/>
              <a:gd name="T17" fmla="*/ 592 h 592"/>
              <a:gd name="T18" fmla="*/ 0 w 168"/>
              <a:gd name="T19" fmla="*/ 0 h 592"/>
              <a:gd name="T20" fmla="*/ 168 w 168"/>
              <a:gd name="T21" fmla="*/ 0 h 592"/>
              <a:gd name="T22" fmla="*/ 0 w 168"/>
              <a:gd name="T23" fmla="*/ 0 h 5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8" h="592">
                <a:moveTo>
                  <a:pt x="83" y="310"/>
                </a:moveTo>
                <a:lnTo>
                  <a:pt x="83" y="592"/>
                </a:lnTo>
                <a:lnTo>
                  <a:pt x="83" y="310"/>
                </a:lnTo>
                <a:close/>
                <a:moveTo>
                  <a:pt x="83" y="310"/>
                </a:moveTo>
                <a:lnTo>
                  <a:pt x="83" y="0"/>
                </a:lnTo>
                <a:lnTo>
                  <a:pt x="83" y="310"/>
                </a:lnTo>
                <a:close/>
                <a:moveTo>
                  <a:pt x="0" y="592"/>
                </a:moveTo>
                <a:lnTo>
                  <a:pt x="168" y="592"/>
                </a:lnTo>
                <a:lnTo>
                  <a:pt x="0" y="592"/>
                </a:lnTo>
                <a:close/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Freeform 17"/>
          <p:cNvSpPr>
            <a:spLocks/>
          </p:cNvSpPr>
          <p:nvPr/>
        </p:nvSpPr>
        <p:spPr bwMode="auto">
          <a:xfrm>
            <a:off x="2359810" y="1617969"/>
            <a:ext cx="0" cy="111125"/>
          </a:xfrm>
          <a:custGeom>
            <a:avLst/>
            <a:gdLst>
              <a:gd name="T0" fmla="*/ 0 h 282"/>
              <a:gd name="T1" fmla="*/ 282 h 282"/>
              <a:gd name="T2" fmla="*/ 0 h 2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2">
                <a:moveTo>
                  <a:pt x="0" y="0"/>
                </a:moveTo>
                <a:lnTo>
                  <a:pt x="0" y="282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Freeform 18"/>
          <p:cNvSpPr>
            <a:spLocks/>
          </p:cNvSpPr>
          <p:nvPr/>
        </p:nvSpPr>
        <p:spPr bwMode="auto">
          <a:xfrm>
            <a:off x="2359810" y="1494144"/>
            <a:ext cx="0" cy="123825"/>
          </a:xfrm>
          <a:custGeom>
            <a:avLst/>
            <a:gdLst>
              <a:gd name="T0" fmla="*/ 310 h 310"/>
              <a:gd name="T1" fmla="*/ 0 h 310"/>
              <a:gd name="T2" fmla="*/ 310 h 31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0">
                <a:moveTo>
                  <a:pt x="0" y="310"/>
                </a:moveTo>
                <a:lnTo>
                  <a:pt x="0" y="0"/>
                </a:lnTo>
                <a:lnTo>
                  <a:pt x="0" y="31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Freeform 19"/>
          <p:cNvSpPr>
            <a:spLocks/>
          </p:cNvSpPr>
          <p:nvPr/>
        </p:nvSpPr>
        <p:spPr bwMode="auto">
          <a:xfrm>
            <a:off x="2326473" y="1738620"/>
            <a:ext cx="68263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Freeform 20"/>
          <p:cNvSpPr>
            <a:spLocks/>
          </p:cNvSpPr>
          <p:nvPr/>
        </p:nvSpPr>
        <p:spPr bwMode="auto">
          <a:xfrm>
            <a:off x="2326473" y="1494144"/>
            <a:ext cx="68263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Freeform 21"/>
          <p:cNvSpPr>
            <a:spLocks noEditPoints="1"/>
          </p:cNvSpPr>
          <p:nvPr/>
        </p:nvSpPr>
        <p:spPr bwMode="auto">
          <a:xfrm>
            <a:off x="2797960" y="1762431"/>
            <a:ext cx="66675" cy="190500"/>
          </a:xfrm>
          <a:custGeom>
            <a:avLst/>
            <a:gdLst>
              <a:gd name="T0" fmla="*/ 85 w 169"/>
              <a:gd name="T1" fmla="*/ 255 h 480"/>
              <a:gd name="T2" fmla="*/ 85 w 169"/>
              <a:gd name="T3" fmla="*/ 480 h 480"/>
              <a:gd name="T4" fmla="*/ 85 w 169"/>
              <a:gd name="T5" fmla="*/ 255 h 480"/>
              <a:gd name="T6" fmla="*/ 85 w 169"/>
              <a:gd name="T7" fmla="*/ 255 h 480"/>
              <a:gd name="T8" fmla="*/ 85 w 169"/>
              <a:gd name="T9" fmla="*/ 0 h 480"/>
              <a:gd name="T10" fmla="*/ 85 w 169"/>
              <a:gd name="T11" fmla="*/ 255 h 480"/>
              <a:gd name="T12" fmla="*/ 0 w 169"/>
              <a:gd name="T13" fmla="*/ 480 h 480"/>
              <a:gd name="T14" fmla="*/ 169 w 169"/>
              <a:gd name="T15" fmla="*/ 480 h 480"/>
              <a:gd name="T16" fmla="*/ 0 w 169"/>
              <a:gd name="T17" fmla="*/ 480 h 480"/>
              <a:gd name="T18" fmla="*/ 0 w 169"/>
              <a:gd name="T19" fmla="*/ 0 h 480"/>
              <a:gd name="T20" fmla="*/ 169 w 169"/>
              <a:gd name="T21" fmla="*/ 0 h 480"/>
              <a:gd name="T22" fmla="*/ 0 w 169"/>
              <a:gd name="T23" fmla="*/ 0 h 4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9" h="480">
                <a:moveTo>
                  <a:pt x="85" y="255"/>
                </a:moveTo>
                <a:lnTo>
                  <a:pt x="85" y="480"/>
                </a:lnTo>
                <a:lnTo>
                  <a:pt x="85" y="255"/>
                </a:lnTo>
                <a:close/>
                <a:moveTo>
                  <a:pt x="85" y="255"/>
                </a:moveTo>
                <a:lnTo>
                  <a:pt x="85" y="0"/>
                </a:lnTo>
                <a:lnTo>
                  <a:pt x="85" y="255"/>
                </a:lnTo>
                <a:close/>
                <a:moveTo>
                  <a:pt x="0" y="480"/>
                </a:moveTo>
                <a:lnTo>
                  <a:pt x="169" y="480"/>
                </a:lnTo>
                <a:lnTo>
                  <a:pt x="0" y="480"/>
                </a:lnTo>
                <a:close/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Freeform 22"/>
          <p:cNvSpPr>
            <a:spLocks/>
          </p:cNvSpPr>
          <p:nvPr/>
        </p:nvSpPr>
        <p:spPr bwMode="auto">
          <a:xfrm>
            <a:off x="2831298" y="1864031"/>
            <a:ext cx="0" cy="88900"/>
          </a:xfrm>
          <a:custGeom>
            <a:avLst/>
            <a:gdLst>
              <a:gd name="T0" fmla="*/ 0 h 225"/>
              <a:gd name="T1" fmla="*/ 225 h 225"/>
              <a:gd name="T2" fmla="*/ 0 h 2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5">
                <a:moveTo>
                  <a:pt x="0" y="0"/>
                </a:moveTo>
                <a:lnTo>
                  <a:pt x="0" y="225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Freeform 23"/>
          <p:cNvSpPr>
            <a:spLocks/>
          </p:cNvSpPr>
          <p:nvPr/>
        </p:nvSpPr>
        <p:spPr bwMode="auto">
          <a:xfrm>
            <a:off x="2831298" y="1762431"/>
            <a:ext cx="0" cy="101600"/>
          </a:xfrm>
          <a:custGeom>
            <a:avLst/>
            <a:gdLst>
              <a:gd name="T0" fmla="*/ 255 h 255"/>
              <a:gd name="T1" fmla="*/ 0 h 255"/>
              <a:gd name="T2" fmla="*/ 255 h 25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5">
                <a:moveTo>
                  <a:pt x="0" y="255"/>
                </a:moveTo>
                <a:lnTo>
                  <a:pt x="0" y="0"/>
                </a:lnTo>
                <a:lnTo>
                  <a:pt x="0" y="255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Freeform 24"/>
          <p:cNvSpPr>
            <a:spLocks/>
          </p:cNvSpPr>
          <p:nvPr/>
        </p:nvSpPr>
        <p:spPr bwMode="auto">
          <a:xfrm>
            <a:off x="2797960" y="1962457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Freeform 25"/>
          <p:cNvSpPr>
            <a:spLocks/>
          </p:cNvSpPr>
          <p:nvPr/>
        </p:nvSpPr>
        <p:spPr bwMode="auto">
          <a:xfrm>
            <a:off x="2797960" y="1762431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Freeform 26"/>
          <p:cNvSpPr>
            <a:spLocks noEditPoints="1"/>
          </p:cNvSpPr>
          <p:nvPr/>
        </p:nvSpPr>
        <p:spPr bwMode="auto">
          <a:xfrm>
            <a:off x="3278973" y="1875144"/>
            <a:ext cx="66675" cy="190500"/>
          </a:xfrm>
          <a:custGeom>
            <a:avLst/>
            <a:gdLst>
              <a:gd name="T0" fmla="*/ 84 w 169"/>
              <a:gd name="T1" fmla="*/ 226 h 481"/>
              <a:gd name="T2" fmla="*/ 84 w 169"/>
              <a:gd name="T3" fmla="*/ 481 h 481"/>
              <a:gd name="T4" fmla="*/ 84 w 169"/>
              <a:gd name="T5" fmla="*/ 226 h 481"/>
              <a:gd name="T6" fmla="*/ 84 w 169"/>
              <a:gd name="T7" fmla="*/ 226 h 481"/>
              <a:gd name="T8" fmla="*/ 84 w 169"/>
              <a:gd name="T9" fmla="*/ 0 h 481"/>
              <a:gd name="T10" fmla="*/ 84 w 169"/>
              <a:gd name="T11" fmla="*/ 226 h 481"/>
              <a:gd name="T12" fmla="*/ 0 w 169"/>
              <a:gd name="T13" fmla="*/ 481 h 481"/>
              <a:gd name="T14" fmla="*/ 169 w 169"/>
              <a:gd name="T15" fmla="*/ 481 h 481"/>
              <a:gd name="T16" fmla="*/ 0 w 169"/>
              <a:gd name="T17" fmla="*/ 481 h 481"/>
              <a:gd name="T18" fmla="*/ 0 w 169"/>
              <a:gd name="T19" fmla="*/ 0 h 481"/>
              <a:gd name="T20" fmla="*/ 169 w 169"/>
              <a:gd name="T21" fmla="*/ 0 h 481"/>
              <a:gd name="T22" fmla="*/ 0 w 169"/>
              <a:gd name="T23" fmla="*/ 0 h 4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9" h="481">
                <a:moveTo>
                  <a:pt x="84" y="226"/>
                </a:moveTo>
                <a:lnTo>
                  <a:pt x="84" y="481"/>
                </a:lnTo>
                <a:lnTo>
                  <a:pt x="84" y="226"/>
                </a:lnTo>
                <a:close/>
                <a:moveTo>
                  <a:pt x="84" y="226"/>
                </a:moveTo>
                <a:lnTo>
                  <a:pt x="84" y="0"/>
                </a:lnTo>
                <a:lnTo>
                  <a:pt x="84" y="226"/>
                </a:lnTo>
                <a:close/>
                <a:moveTo>
                  <a:pt x="0" y="481"/>
                </a:moveTo>
                <a:lnTo>
                  <a:pt x="169" y="481"/>
                </a:lnTo>
                <a:lnTo>
                  <a:pt x="0" y="481"/>
                </a:lnTo>
                <a:close/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Freeform 27"/>
          <p:cNvSpPr>
            <a:spLocks/>
          </p:cNvSpPr>
          <p:nvPr/>
        </p:nvSpPr>
        <p:spPr bwMode="auto">
          <a:xfrm>
            <a:off x="3312310" y="1964044"/>
            <a:ext cx="0" cy="101600"/>
          </a:xfrm>
          <a:custGeom>
            <a:avLst/>
            <a:gdLst>
              <a:gd name="T0" fmla="*/ 0 h 255"/>
              <a:gd name="T1" fmla="*/ 255 h 255"/>
              <a:gd name="T2" fmla="*/ 0 h 25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5">
                <a:moveTo>
                  <a:pt x="0" y="0"/>
                </a:moveTo>
                <a:lnTo>
                  <a:pt x="0" y="255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Freeform 28"/>
          <p:cNvSpPr>
            <a:spLocks/>
          </p:cNvSpPr>
          <p:nvPr/>
        </p:nvSpPr>
        <p:spPr bwMode="auto">
          <a:xfrm>
            <a:off x="3312310" y="1875144"/>
            <a:ext cx="0" cy="88900"/>
          </a:xfrm>
          <a:custGeom>
            <a:avLst/>
            <a:gdLst>
              <a:gd name="T0" fmla="*/ 226 h 226"/>
              <a:gd name="T1" fmla="*/ 0 h 226"/>
              <a:gd name="T2" fmla="*/ 226 h 2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6">
                <a:moveTo>
                  <a:pt x="0" y="226"/>
                </a:moveTo>
                <a:lnTo>
                  <a:pt x="0" y="0"/>
                </a:lnTo>
                <a:lnTo>
                  <a:pt x="0" y="226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Freeform 29"/>
          <p:cNvSpPr>
            <a:spLocks/>
          </p:cNvSpPr>
          <p:nvPr/>
        </p:nvSpPr>
        <p:spPr bwMode="auto">
          <a:xfrm>
            <a:off x="3278973" y="2075170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Freeform 30"/>
          <p:cNvSpPr>
            <a:spLocks/>
          </p:cNvSpPr>
          <p:nvPr/>
        </p:nvSpPr>
        <p:spPr bwMode="auto">
          <a:xfrm>
            <a:off x="3278973" y="1875144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Freeform 31"/>
          <p:cNvSpPr>
            <a:spLocks noEditPoints="1"/>
          </p:cNvSpPr>
          <p:nvPr/>
        </p:nvSpPr>
        <p:spPr bwMode="auto">
          <a:xfrm>
            <a:off x="3759985" y="1952931"/>
            <a:ext cx="66675" cy="246063"/>
          </a:xfrm>
          <a:custGeom>
            <a:avLst/>
            <a:gdLst>
              <a:gd name="T0" fmla="*/ 85 w 170"/>
              <a:gd name="T1" fmla="*/ 310 h 621"/>
              <a:gd name="T2" fmla="*/ 85 w 170"/>
              <a:gd name="T3" fmla="*/ 621 h 621"/>
              <a:gd name="T4" fmla="*/ 85 w 170"/>
              <a:gd name="T5" fmla="*/ 310 h 621"/>
              <a:gd name="T6" fmla="*/ 85 w 170"/>
              <a:gd name="T7" fmla="*/ 310 h 621"/>
              <a:gd name="T8" fmla="*/ 85 w 170"/>
              <a:gd name="T9" fmla="*/ 0 h 621"/>
              <a:gd name="T10" fmla="*/ 85 w 170"/>
              <a:gd name="T11" fmla="*/ 310 h 621"/>
              <a:gd name="T12" fmla="*/ 0 w 170"/>
              <a:gd name="T13" fmla="*/ 621 h 621"/>
              <a:gd name="T14" fmla="*/ 170 w 170"/>
              <a:gd name="T15" fmla="*/ 621 h 621"/>
              <a:gd name="T16" fmla="*/ 0 w 170"/>
              <a:gd name="T17" fmla="*/ 621 h 621"/>
              <a:gd name="T18" fmla="*/ 0 w 170"/>
              <a:gd name="T19" fmla="*/ 0 h 621"/>
              <a:gd name="T20" fmla="*/ 170 w 170"/>
              <a:gd name="T21" fmla="*/ 0 h 621"/>
              <a:gd name="T22" fmla="*/ 0 w 170"/>
              <a:gd name="T23" fmla="*/ 0 h 6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70" h="621">
                <a:moveTo>
                  <a:pt x="85" y="310"/>
                </a:moveTo>
                <a:lnTo>
                  <a:pt x="85" y="621"/>
                </a:lnTo>
                <a:lnTo>
                  <a:pt x="85" y="310"/>
                </a:lnTo>
                <a:close/>
                <a:moveTo>
                  <a:pt x="85" y="310"/>
                </a:moveTo>
                <a:lnTo>
                  <a:pt x="85" y="0"/>
                </a:lnTo>
                <a:lnTo>
                  <a:pt x="85" y="310"/>
                </a:lnTo>
                <a:close/>
                <a:moveTo>
                  <a:pt x="0" y="621"/>
                </a:moveTo>
                <a:lnTo>
                  <a:pt x="170" y="621"/>
                </a:lnTo>
                <a:lnTo>
                  <a:pt x="0" y="621"/>
                </a:lnTo>
                <a:close/>
                <a:moveTo>
                  <a:pt x="0" y="0"/>
                </a:moveTo>
                <a:lnTo>
                  <a:pt x="170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32"/>
          <p:cNvSpPr>
            <a:spLocks/>
          </p:cNvSpPr>
          <p:nvPr/>
        </p:nvSpPr>
        <p:spPr bwMode="auto">
          <a:xfrm>
            <a:off x="3793323" y="2076756"/>
            <a:ext cx="0" cy="122238"/>
          </a:xfrm>
          <a:custGeom>
            <a:avLst/>
            <a:gdLst>
              <a:gd name="T0" fmla="*/ 0 h 311"/>
              <a:gd name="T1" fmla="*/ 311 h 311"/>
              <a:gd name="T2" fmla="*/ 0 h 31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1">
                <a:moveTo>
                  <a:pt x="0" y="0"/>
                </a:moveTo>
                <a:lnTo>
                  <a:pt x="0" y="311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Freeform 33"/>
          <p:cNvSpPr>
            <a:spLocks/>
          </p:cNvSpPr>
          <p:nvPr/>
        </p:nvSpPr>
        <p:spPr bwMode="auto">
          <a:xfrm>
            <a:off x="3793323" y="1952931"/>
            <a:ext cx="0" cy="123825"/>
          </a:xfrm>
          <a:custGeom>
            <a:avLst/>
            <a:gdLst>
              <a:gd name="T0" fmla="*/ 310 h 310"/>
              <a:gd name="T1" fmla="*/ 0 h 310"/>
              <a:gd name="T2" fmla="*/ 310 h 31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0">
                <a:moveTo>
                  <a:pt x="0" y="310"/>
                </a:moveTo>
                <a:lnTo>
                  <a:pt x="0" y="0"/>
                </a:lnTo>
                <a:lnTo>
                  <a:pt x="0" y="31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Freeform 34"/>
          <p:cNvSpPr>
            <a:spLocks/>
          </p:cNvSpPr>
          <p:nvPr/>
        </p:nvSpPr>
        <p:spPr bwMode="auto">
          <a:xfrm>
            <a:off x="3759985" y="2208520"/>
            <a:ext cx="66675" cy="0"/>
          </a:xfrm>
          <a:custGeom>
            <a:avLst/>
            <a:gdLst>
              <a:gd name="T0" fmla="*/ 0 w 170"/>
              <a:gd name="T1" fmla="*/ 170 w 170"/>
              <a:gd name="T2" fmla="*/ 0 w 17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0">
                <a:moveTo>
                  <a:pt x="0" y="0"/>
                </a:moveTo>
                <a:lnTo>
                  <a:pt x="170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 35"/>
          <p:cNvSpPr>
            <a:spLocks/>
          </p:cNvSpPr>
          <p:nvPr/>
        </p:nvSpPr>
        <p:spPr bwMode="auto">
          <a:xfrm>
            <a:off x="3759985" y="1952931"/>
            <a:ext cx="66675" cy="0"/>
          </a:xfrm>
          <a:custGeom>
            <a:avLst/>
            <a:gdLst>
              <a:gd name="T0" fmla="*/ 0 w 170"/>
              <a:gd name="T1" fmla="*/ 170 w 170"/>
              <a:gd name="T2" fmla="*/ 0 w 17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0">
                <a:moveTo>
                  <a:pt x="0" y="0"/>
                </a:moveTo>
                <a:lnTo>
                  <a:pt x="170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6"/>
          <p:cNvSpPr>
            <a:spLocks noEditPoints="1"/>
          </p:cNvSpPr>
          <p:nvPr/>
        </p:nvSpPr>
        <p:spPr bwMode="auto">
          <a:xfrm>
            <a:off x="4229885" y="1864031"/>
            <a:ext cx="66675" cy="301625"/>
          </a:xfrm>
          <a:custGeom>
            <a:avLst/>
            <a:gdLst>
              <a:gd name="T0" fmla="*/ 85 w 169"/>
              <a:gd name="T1" fmla="*/ 366 h 761"/>
              <a:gd name="T2" fmla="*/ 85 w 169"/>
              <a:gd name="T3" fmla="*/ 761 h 761"/>
              <a:gd name="T4" fmla="*/ 85 w 169"/>
              <a:gd name="T5" fmla="*/ 366 h 761"/>
              <a:gd name="T6" fmla="*/ 85 w 169"/>
              <a:gd name="T7" fmla="*/ 366 h 761"/>
              <a:gd name="T8" fmla="*/ 85 w 169"/>
              <a:gd name="T9" fmla="*/ 0 h 761"/>
              <a:gd name="T10" fmla="*/ 85 w 169"/>
              <a:gd name="T11" fmla="*/ 366 h 761"/>
              <a:gd name="T12" fmla="*/ 0 w 169"/>
              <a:gd name="T13" fmla="*/ 761 h 761"/>
              <a:gd name="T14" fmla="*/ 169 w 169"/>
              <a:gd name="T15" fmla="*/ 761 h 761"/>
              <a:gd name="T16" fmla="*/ 0 w 169"/>
              <a:gd name="T17" fmla="*/ 761 h 761"/>
              <a:gd name="T18" fmla="*/ 0 w 169"/>
              <a:gd name="T19" fmla="*/ 0 h 761"/>
              <a:gd name="T20" fmla="*/ 169 w 169"/>
              <a:gd name="T21" fmla="*/ 0 h 761"/>
              <a:gd name="T22" fmla="*/ 0 w 169"/>
              <a:gd name="T23" fmla="*/ 0 h 7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9" h="761">
                <a:moveTo>
                  <a:pt x="85" y="366"/>
                </a:moveTo>
                <a:lnTo>
                  <a:pt x="85" y="761"/>
                </a:lnTo>
                <a:lnTo>
                  <a:pt x="85" y="366"/>
                </a:lnTo>
                <a:close/>
                <a:moveTo>
                  <a:pt x="85" y="366"/>
                </a:moveTo>
                <a:lnTo>
                  <a:pt x="85" y="0"/>
                </a:lnTo>
                <a:lnTo>
                  <a:pt x="85" y="366"/>
                </a:lnTo>
                <a:close/>
                <a:moveTo>
                  <a:pt x="0" y="761"/>
                </a:moveTo>
                <a:lnTo>
                  <a:pt x="169" y="761"/>
                </a:lnTo>
                <a:lnTo>
                  <a:pt x="0" y="761"/>
                </a:lnTo>
                <a:close/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Freeform 37"/>
          <p:cNvSpPr>
            <a:spLocks/>
          </p:cNvSpPr>
          <p:nvPr/>
        </p:nvSpPr>
        <p:spPr bwMode="auto">
          <a:xfrm>
            <a:off x="4263223" y="2008494"/>
            <a:ext cx="0" cy="157163"/>
          </a:xfrm>
          <a:custGeom>
            <a:avLst/>
            <a:gdLst>
              <a:gd name="T0" fmla="*/ 0 h 395"/>
              <a:gd name="T1" fmla="*/ 395 h 395"/>
              <a:gd name="T2" fmla="*/ 0 h 3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95">
                <a:moveTo>
                  <a:pt x="0" y="0"/>
                </a:moveTo>
                <a:lnTo>
                  <a:pt x="0" y="395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Freeform 38"/>
          <p:cNvSpPr>
            <a:spLocks/>
          </p:cNvSpPr>
          <p:nvPr/>
        </p:nvSpPr>
        <p:spPr bwMode="auto">
          <a:xfrm>
            <a:off x="4263223" y="1864031"/>
            <a:ext cx="0" cy="144463"/>
          </a:xfrm>
          <a:custGeom>
            <a:avLst/>
            <a:gdLst>
              <a:gd name="T0" fmla="*/ 366 h 366"/>
              <a:gd name="T1" fmla="*/ 0 h 366"/>
              <a:gd name="T2" fmla="*/ 366 h 3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66">
                <a:moveTo>
                  <a:pt x="0" y="366"/>
                </a:moveTo>
                <a:lnTo>
                  <a:pt x="0" y="0"/>
                </a:lnTo>
                <a:lnTo>
                  <a:pt x="0" y="366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Freeform 39"/>
          <p:cNvSpPr>
            <a:spLocks/>
          </p:cNvSpPr>
          <p:nvPr/>
        </p:nvSpPr>
        <p:spPr bwMode="auto">
          <a:xfrm>
            <a:off x="4229885" y="2175182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Freeform 40"/>
          <p:cNvSpPr>
            <a:spLocks/>
          </p:cNvSpPr>
          <p:nvPr/>
        </p:nvSpPr>
        <p:spPr bwMode="auto">
          <a:xfrm>
            <a:off x="4229885" y="1864031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Freeform 41"/>
          <p:cNvSpPr>
            <a:spLocks noEditPoints="1"/>
          </p:cNvSpPr>
          <p:nvPr/>
        </p:nvSpPr>
        <p:spPr bwMode="auto">
          <a:xfrm>
            <a:off x="4710898" y="2243444"/>
            <a:ext cx="66675" cy="269875"/>
          </a:xfrm>
          <a:custGeom>
            <a:avLst/>
            <a:gdLst>
              <a:gd name="T0" fmla="*/ 84 w 169"/>
              <a:gd name="T1" fmla="*/ 339 h 678"/>
              <a:gd name="T2" fmla="*/ 84 w 169"/>
              <a:gd name="T3" fmla="*/ 678 h 678"/>
              <a:gd name="T4" fmla="*/ 84 w 169"/>
              <a:gd name="T5" fmla="*/ 339 h 678"/>
              <a:gd name="T6" fmla="*/ 84 w 169"/>
              <a:gd name="T7" fmla="*/ 339 h 678"/>
              <a:gd name="T8" fmla="*/ 84 w 169"/>
              <a:gd name="T9" fmla="*/ 0 h 678"/>
              <a:gd name="T10" fmla="*/ 84 w 169"/>
              <a:gd name="T11" fmla="*/ 339 h 678"/>
              <a:gd name="T12" fmla="*/ 0 w 169"/>
              <a:gd name="T13" fmla="*/ 678 h 678"/>
              <a:gd name="T14" fmla="*/ 169 w 169"/>
              <a:gd name="T15" fmla="*/ 678 h 678"/>
              <a:gd name="T16" fmla="*/ 0 w 169"/>
              <a:gd name="T17" fmla="*/ 678 h 678"/>
              <a:gd name="T18" fmla="*/ 0 w 169"/>
              <a:gd name="T19" fmla="*/ 0 h 678"/>
              <a:gd name="T20" fmla="*/ 169 w 169"/>
              <a:gd name="T21" fmla="*/ 0 h 678"/>
              <a:gd name="T22" fmla="*/ 0 w 169"/>
              <a:gd name="T23" fmla="*/ 0 h 6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9" h="678">
                <a:moveTo>
                  <a:pt x="84" y="339"/>
                </a:moveTo>
                <a:lnTo>
                  <a:pt x="84" y="678"/>
                </a:lnTo>
                <a:lnTo>
                  <a:pt x="84" y="339"/>
                </a:lnTo>
                <a:close/>
                <a:moveTo>
                  <a:pt x="84" y="339"/>
                </a:moveTo>
                <a:lnTo>
                  <a:pt x="84" y="0"/>
                </a:lnTo>
                <a:lnTo>
                  <a:pt x="84" y="339"/>
                </a:lnTo>
                <a:close/>
                <a:moveTo>
                  <a:pt x="0" y="678"/>
                </a:moveTo>
                <a:lnTo>
                  <a:pt x="169" y="678"/>
                </a:lnTo>
                <a:lnTo>
                  <a:pt x="0" y="678"/>
                </a:lnTo>
                <a:close/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Freeform 42"/>
          <p:cNvSpPr>
            <a:spLocks/>
          </p:cNvSpPr>
          <p:nvPr/>
        </p:nvSpPr>
        <p:spPr bwMode="auto">
          <a:xfrm>
            <a:off x="4744235" y="2378381"/>
            <a:ext cx="0" cy="134938"/>
          </a:xfrm>
          <a:custGeom>
            <a:avLst/>
            <a:gdLst>
              <a:gd name="T0" fmla="*/ 0 h 339"/>
              <a:gd name="T1" fmla="*/ 339 h 339"/>
              <a:gd name="T2" fmla="*/ 0 h 33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9">
                <a:moveTo>
                  <a:pt x="0" y="0"/>
                </a:moveTo>
                <a:lnTo>
                  <a:pt x="0" y="339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Freeform 43"/>
          <p:cNvSpPr>
            <a:spLocks/>
          </p:cNvSpPr>
          <p:nvPr/>
        </p:nvSpPr>
        <p:spPr bwMode="auto">
          <a:xfrm>
            <a:off x="4744235" y="2243444"/>
            <a:ext cx="0" cy="134938"/>
          </a:xfrm>
          <a:custGeom>
            <a:avLst/>
            <a:gdLst>
              <a:gd name="T0" fmla="*/ 339 h 339"/>
              <a:gd name="T1" fmla="*/ 0 h 339"/>
              <a:gd name="T2" fmla="*/ 339 h 33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9">
                <a:moveTo>
                  <a:pt x="0" y="339"/>
                </a:moveTo>
                <a:lnTo>
                  <a:pt x="0" y="0"/>
                </a:lnTo>
                <a:lnTo>
                  <a:pt x="0" y="339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Freeform 44"/>
          <p:cNvSpPr>
            <a:spLocks/>
          </p:cNvSpPr>
          <p:nvPr/>
        </p:nvSpPr>
        <p:spPr bwMode="auto">
          <a:xfrm>
            <a:off x="4710898" y="2522845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Freeform 45"/>
          <p:cNvSpPr>
            <a:spLocks/>
          </p:cNvSpPr>
          <p:nvPr/>
        </p:nvSpPr>
        <p:spPr bwMode="auto">
          <a:xfrm>
            <a:off x="4710898" y="2243444"/>
            <a:ext cx="66675" cy="0"/>
          </a:xfrm>
          <a:custGeom>
            <a:avLst/>
            <a:gdLst>
              <a:gd name="T0" fmla="*/ 0 w 169"/>
              <a:gd name="T1" fmla="*/ 169 w 169"/>
              <a:gd name="T2" fmla="*/ 0 w 16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9">
                <a:moveTo>
                  <a:pt x="0" y="0"/>
                </a:moveTo>
                <a:lnTo>
                  <a:pt x="169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Freeform 46"/>
          <p:cNvSpPr>
            <a:spLocks noEditPoints="1"/>
          </p:cNvSpPr>
          <p:nvPr/>
        </p:nvSpPr>
        <p:spPr bwMode="auto">
          <a:xfrm>
            <a:off x="5180798" y="2345044"/>
            <a:ext cx="68263" cy="111125"/>
          </a:xfrm>
          <a:custGeom>
            <a:avLst/>
            <a:gdLst>
              <a:gd name="T0" fmla="*/ 85 w 168"/>
              <a:gd name="T1" fmla="*/ 141 h 282"/>
              <a:gd name="T2" fmla="*/ 85 w 168"/>
              <a:gd name="T3" fmla="*/ 282 h 282"/>
              <a:gd name="T4" fmla="*/ 85 w 168"/>
              <a:gd name="T5" fmla="*/ 141 h 282"/>
              <a:gd name="T6" fmla="*/ 85 w 168"/>
              <a:gd name="T7" fmla="*/ 141 h 282"/>
              <a:gd name="T8" fmla="*/ 85 w 168"/>
              <a:gd name="T9" fmla="*/ 0 h 282"/>
              <a:gd name="T10" fmla="*/ 85 w 168"/>
              <a:gd name="T11" fmla="*/ 141 h 282"/>
              <a:gd name="T12" fmla="*/ 0 w 168"/>
              <a:gd name="T13" fmla="*/ 282 h 282"/>
              <a:gd name="T14" fmla="*/ 168 w 168"/>
              <a:gd name="T15" fmla="*/ 282 h 282"/>
              <a:gd name="T16" fmla="*/ 0 w 168"/>
              <a:gd name="T17" fmla="*/ 282 h 282"/>
              <a:gd name="T18" fmla="*/ 0 w 168"/>
              <a:gd name="T19" fmla="*/ 0 h 282"/>
              <a:gd name="T20" fmla="*/ 168 w 168"/>
              <a:gd name="T21" fmla="*/ 0 h 282"/>
              <a:gd name="T22" fmla="*/ 0 w 168"/>
              <a:gd name="T23" fmla="*/ 0 h 2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8" h="282">
                <a:moveTo>
                  <a:pt x="85" y="141"/>
                </a:moveTo>
                <a:lnTo>
                  <a:pt x="85" y="282"/>
                </a:lnTo>
                <a:lnTo>
                  <a:pt x="85" y="141"/>
                </a:lnTo>
                <a:close/>
                <a:moveTo>
                  <a:pt x="85" y="141"/>
                </a:moveTo>
                <a:lnTo>
                  <a:pt x="85" y="0"/>
                </a:lnTo>
                <a:lnTo>
                  <a:pt x="85" y="141"/>
                </a:lnTo>
                <a:close/>
                <a:moveTo>
                  <a:pt x="0" y="282"/>
                </a:moveTo>
                <a:lnTo>
                  <a:pt x="168" y="282"/>
                </a:lnTo>
                <a:lnTo>
                  <a:pt x="0" y="282"/>
                </a:lnTo>
                <a:close/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Freeform 47"/>
          <p:cNvSpPr>
            <a:spLocks/>
          </p:cNvSpPr>
          <p:nvPr/>
        </p:nvSpPr>
        <p:spPr bwMode="auto">
          <a:xfrm>
            <a:off x="5215723" y="2400606"/>
            <a:ext cx="0" cy="55563"/>
          </a:xfrm>
          <a:custGeom>
            <a:avLst/>
            <a:gdLst>
              <a:gd name="T0" fmla="*/ 0 h 141"/>
              <a:gd name="T1" fmla="*/ 141 h 141"/>
              <a:gd name="T2" fmla="*/ 0 h 14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1">
                <a:moveTo>
                  <a:pt x="0" y="0"/>
                </a:moveTo>
                <a:lnTo>
                  <a:pt x="0" y="141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Freeform 48"/>
          <p:cNvSpPr>
            <a:spLocks/>
          </p:cNvSpPr>
          <p:nvPr/>
        </p:nvSpPr>
        <p:spPr bwMode="auto">
          <a:xfrm>
            <a:off x="5215723" y="2345044"/>
            <a:ext cx="0" cy="55563"/>
          </a:xfrm>
          <a:custGeom>
            <a:avLst/>
            <a:gdLst>
              <a:gd name="T0" fmla="*/ 141 h 141"/>
              <a:gd name="T1" fmla="*/ 0 h 141"/>
              <a:gd name="T2" fmla="*/ 141 h 14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1">
                <a:moveTo>
                  <a:pt x="0" y="141"/>
                </a:moveTo>
                <a:lnTo>
                  <a:pt x="0" y="0"/>
                </a:lnTo>
                <a:lnTo>
                  <a:pt x="0" y="141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Freeform 49"/>
          <p:cNvSpPr>
            <a:spLocks/>
          </p:cNvSpPr>
          <p:nvPr/>
        </p:nvSpPr>
        <p:spPr bwMode="auto">
          <a:xfrm>
            <a:off x="5180798" y="2465695"/>
            <a:ext cx="68263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Freeform 50"/>
          <p:cNvSpPr>
            <a:spLocks/>
          </p:cNvSpPr>
          <p:nvPr/>
        </p:nvSpPr>
        <p:spPr bwMode="auto">
          <a:xfrm>
            <a:off x="5180798" y="2345044"/>
            <a:ext cx="68263" cy="0"/>
          </a:xfrm>
          <a:custGeom>
            <a:avLst/>
            <a:gdLst>
              <a:gd name="T0" fmla="*/ 0 w 168"/>
              <a:gd name="T1" fmla="*/ 168 w 168"/>
              <a:gd name="T2" fmla="*/ 0 w 16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8">
                <a:moveTo>
                  <a:pt x="0" y="0"/>
                </a:moveTo>
                <a:lnTo>
                  <a:pt x="168" y="0"/>
                </a:ln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1"/>
          <p:cNvSpPr>
            <a:spLocks noChangeArrowheads="1"/>
          </p:cNvSpPr>
          <p:nvPr/>
        </p:nvSpPr>
        <p:spPr bwMode="auto">
          <a:xfrm>
            <a:off x="1140610" y="676581"/>
            <a:ext cx="44450" cy="2452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2"/>
          <p:cNvSpPr>
            <a:spLocks noChangeArrowheads="1"/>
          </p:cNvSpPr>
          <p:nvPr/>
        </p:nvSpPr>
        <p:spPr bwMode="auto">
          <a:xfrm>
            <a:off x="1129498" y="3105456"/>
            <a:ext cx="33338" cy="46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3"/>
          <p:cNvSpPr>
            <a:spLocks noChangeArrowheads="1"/>
          </p:cNvSpPr>
          <p:nvPr/>
        </p:nvSpPr>
        <p:spPr bwMode="auto">
          <a:xfrm>
            <a:off x="1129498" y="2691119"/>
            <a:ext cx="33338" cy="46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4"/>
          <p:cNvSpPr>
            <a:spLocks noChangeArrowheads="1"/>
          </p:cNvSpPr>
          <p:nvPr/>
        </p:nvSpPr>
        <p:spPr bwMode="auto">
          <a:xfrm>
            <a:off x="1129498" y="2289481"/>
            <a:ext cx="33338" cy="44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55"/>
          <p:cNvSpPr>
            <a:spLocks noChangeArrowheads="1"/>
          </p:cNvSpPr>
          <p:nvPr/>
        </p:nvSpPr>
        <p:spPr bwMode="auto">
          <a:xfrm>
            <a:off x="1129498" y="1875144"/>
            <a:ext cx="33338" cy="44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6"/>
          <p:cNvSpPr>
            <a:spLocks noChangeArrowheads="1"/>
          </p:cNvSpPr>
          <p:nvPr/>
        </p:nvSpPr>
        <p:spPr bwMode="auto">
          <a:xfrm>
            <a:off x="1129498" y="1471919"/>
            <a:ext cx="33338" cy="44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7"/>
          <p:cNvSpPr>
            <a:spLocks noChangeArrowheads="1"/>
          </p:cNvSpPr>
          <p:nvPr/>
        </p:nvSpPr>
        <p:spPr bwMode="auto">
          <a:xfrm>
            <a:off x="1129498" y="1057581"/>
            <a:ext cx="33338" cy="44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58"/>
          <p:cNvSpPr>
            <a:spLocks noChangeArrowheads="1"/>
          </p:cNvSpPr>
          <p:nvPr/>
        </p:nvSpPr>
        <p:spPr bwMode="auto">
          <a:xfrm>
            <a:off x="1129498" y="654356"/>
            <a:ext cx="33338" cy="44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Rectangle 59"/>
          <p:cNvSpPr>
            <a:spLocks noChangeArrowheads="1"/>
          </p:cNvSpPr>
          <p:nvPr/>
        </p:nvSpPr>
        <p:spPr bwMode="auto">
          <a:xfrm>
            <a:off x="1162835" y="3105456"/>
            <a:ext cx="4298950" cy="46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ectangle 60"/>
          <p:cNvSpPr>
            <a:spLocks noChangeArrowheads="1"/>
          </p:cNvSpPr>
          <p:nvPr/>
        </p:nvSpPr>
        <p:spPr bwMode="auto">
          <a:xfrm>
            <a:off x="1386673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61"/>
          <p:cNvSpPr>
            <a:spLocks noChangeArrowheads="1"/>
          </p:cNvSpPr>
          <p:nvPr/>
        </p:nvSpPr>
        <p:spPr bwMode="auto">
          <a:xfrm>
            <a:off x="1856573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62"/>
          <p:cNvSpPr>
            <a:spLocks noChangeArrowheads="1"/>
          </p:cNvSpPr>
          <p:nvPr/>
        </p:nvSpPr>
        <p:spPr bwMode="auto">
          <a:xfrm>
            <a:off x="2337585" y="3094344"/>
            <a:ext cx="46038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63"/>
          <p:cNvSpPr>
            <a:spLocks noChangeArrowheads="1"/>
          </p:cNvSpPr>
          <p:nvPr/>
        </p:nvSpPr>
        <p:spPr bwMode="auto">
          <a:xfrm>
            <a:off x="2820185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64"/>
          <p:cNvSpPr>
            <a:spLocks noChangeArrowheads="1"/>
          </p:cNvSpPr>
          <p:nvPr/>
        </p:nvSpPr>
        <p:spPr bwMode="auto">
          <a:xfrm>
            <a:off x="3290085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65"/>
          <p:cNvSpPr>
            <a:spLocks noChangeArrowheads="1"/>
          </p:cNvSpPr>
          <p:nvPr/>
        </p:nvSpPr>
        <p:spPr bwMode="auto">
          <a:xfrm>
            <a:off x="3771098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66"/>
          <p:cNvSpPr>
            <a:spLocks noChangeArrowheads="1"/>
          </p:cNvSpPr>
          <p:nvPr/>
        </p:nvSpPr>
        <p:spPr bwMode="auto">
          <a:xfrm>
            <a:off x="4252110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ctangle 67"/>
          <p:cNvSpPr>
            <a:spLocks noChangeArrowheads="1"/>
          </p:cNvSpPr>
          <p:nvPr/>
        </p:nvSpPr>
        <p:spPr bwMode="auto">
          <a:xfrm>
            <a:off x="4722010" y="3094344"/>
            <a:ext cx="46038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8"/>
          <p:cNvSpPr>
            <a:spLocks noChangeArrowheads="1"/>
          </p:cNvSpPr>
          <p:nvPr/>
        </p:nvSpPr>
        <p:spPr bwMode="auto">
          <a:xfrm>
            <a:off x="5203023" y="3094344"/>
            <a:ext cx="46038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69"/>
          <p:cNvSpPr>
            <a:spLocks noChangeArrowheads="1"/>
          </p:cNvSpPr>
          <p:nvPr/>
        </p:nvSpPr>
        <p:spPr bwMode="auto">
          <a:xfrm>
            <a:off x="5439560" y="3094344"/>
            <a:ext cx="44450" cy="682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70"/>
          <p:cNvSpPr>
            <a:spLocks noChangeArrowheads="1"/>
          </p:cNvSpPr>
          <p:nvPr/>
        </p:nvSpPr>
        <p:spPr bwMode="auto">
          <a:xfrm>
            <a:off x="1756560" y="1165531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ectangle 71"/>
          <p:cNvSpPr>
            <a:spLocks noChangeArrowheads="1"/>
          </p:cNvSpPr>
          <p:nvPr/>
        </p:nvSpPr>
        <p:spPr bwMode="auto">
          <a:xfrm>
            <a:off x="2248685" y="1333806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72"/>
          <p:cNvSpPr>
            <a:spLocks noChangeArrowheads="1"/>
          </p:cNvSpPr>
          <p:nvPr/>
        </p:nvSpPr>
        <p:spPr bwMode="auto">
          <a:xfrm>
            <a:off x="2718585" y="1602094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73"/>
          <p:cNvSpPr>
            <a:spLocks noChangeArrowheads="1"/>
          </p:cNvSpPr>
          <p:nvPr/>
        </p:nvSpPr>
        <p:spPr bwMode="auto">
          <a:xfrm>
            <a:off x="3188485" y="1737031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74"/>
          <p:cNvSpPr>
            <a:spLocks noChangeArrowheads="1"/>
          </p:cNvSpPr>
          <p:nvPr/>
        </p:nvSpPr>
        <p:spPr bwMode="auto">
          <a:xfrm>
            <a:off x="3658385" y="1792594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75"/>
          <p:cNvSpPr>
            <a:spLocks noChangeArrowheads="1"/>
          </p:cNvSpPr>
          <p:nvPr/>
        </p:nvSpPr>
        <p:spPr bwMode="auto">
          <a:xfrm>
            <a:off x="4140985" y="1692581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ectangle 76"/>
          <p:cNvSpPr>
            <a:spLocks noChangeArrowheads="1"/>
          </p:cNvSpPr>
          <p:nvPr/>
        </p:nvSpPr>
        <p:spPr bwMode="auto">
          <a:xfrm>
            <a:off x="4633110" y="2060881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tangle 77"/>
          <p:cNvSpPr>
            <a:spLocks noChangeArrowheads="1"/>
          </p:cNvSpPr>
          <p:nvPr/>
        </p:nvSpPr>
        <p:spPr bwMode="auto">
          <a:xfrm>
            <a:off x="5080785" y="2162481"/>
            <a:ext cx="2500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78"/>
          <p:cNvSpPr>
            <a:spLocks noChangeArrowheads="1"/>
          </p:cNvSpPr>
          <p:nvPr/>
        </p:nvSpPr>
        <p:spPr bwMode="auto">
          <a:xfrm>
            <a:off x="807235" y="648006"/>
            <a:ext cx="17312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916773" y="3064181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864385" y="2673656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>
            <a:off x="864385" y="2292656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ectangle 82"/>
          <p:cNvSpPr>
            <a:spLocks noChangeArrowheads="1"/>
          </p:cNvSpPr>
          <p:nvPr/>
        </p:nvSpPr>
        <p:spPr bwMode="auto">
          <a:xfrm>
            <a:off x="862798" y="1910069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Rectangle 83"/>
          <p:cNvSpPr>
            <a:spLocks noChangeArrowheads="1"/>
          </p:cNvSpPr>
          <p:nvPr/>
        </p:nvSpPr>
        <p:spPr bwMode="auto">
          <a:xfrm>
            <a:off x="862798" y="148938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84"/>
          <p:cNvSpPr>
            <a:spLocks noChangeArrowheads="1"/>
          </p:cNvSpPr>
          <p:nvPr/>
        </p:nvSpPr>
        <p:spPr bwMode="auto">
          <a:xfrm>
            <a:off x="807235" y="1070281"/>
            <a:ext cx="17312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33" name="Picture 85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9805" y="1149657"/>
            <a:ext cx="4200525" cy="432000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35" name="Picture 87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8428" y="1700856"/>
            <a:ext cx="4200525" cy="432000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Rectangle 89"/>
          <p:cNvSpPr>
            <a:spLocks noChangeArrowheads="1"/>
          </p:cNvSpPr>
          <p:nvPr/>
        </p:nvSpPr>
        <p:spPr bwMode="auto">
          <a:xfrm>
            <a:off x="1340635" y="3092756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94"/>
          <p:cNvSpPr>
            <a:spLocks noChangeArrowheads="1"/>
          </p:cNvSpPr>
          <p:nvPr/>
        </p:nvSpPr>
        <p:spPr bwMode="auto">
          <a:xfrm>
            <a:off x="6366167" y="1811907"/>
            <a:ext cx="45845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l-GR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0" lang="en-US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TW" sz="1200" b="1" dirty="0" smtClean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zh-TW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tin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Freeform 95"/>
          <p:cNvSpPr>
            <a:spLocks/>
          </p:cNvSpPr>
          <p:nvPr/>
        </p:nvSpPr>
        <p:spPr bwMode="auto">
          <a:xfrm>
            <a:off x="521485" y="2470456"/>
            <a:ext cx="125413" cy="111125"/>
          </a:xfrm>
          <a:custGeom>
            <a:avLst/>
            <a:gdLst>
              <a:gd name="T0" fmla="*/ 105 w 317"/>
              <a:gd name="T1" fmla="*/ 9 h 281"/>
              <a:gd name="T2" fmla="*/ 77 w 317"/>
              <a:gd name="T3" fmla="*/ 19 h 281"/>
              <a:gd name="T4" fmla="*/ 54 w 317"/>
              <a:gd name="T5" fmla="*/ 33 h 281"/>
              <a:gd name="T6" fmla="*/ 37 w 317"/>
              <a:gd name="T7" fmla="*/ 52 h 281"/>
              <a:gd name="T8" fmla="*/ 26 w 317"/>
              <a:gd name="T9" fmla="*/ 73 h 281"/>
              <a:gd name="T10" fmla="*/ 21 w 317"/>
              <a:gd name="T11" fmla="*/ 96 h 281"/>
              <a:gd name="T12" fmla="*/ 21 w 317"/>
              <a:gd name="T13" fmla="*/ 117 h 281"/>
              <a:gd name="T14" fmla="*/ 27 w 317"/>
              <a:gd name="T15" fmla="*/ 136 h 281"/>
              <a:gd name="T16" fmla="*/ 36 w 317"/>
              <a:gd name="T17" fmla="*/ 155 h 281"/>
              <a:gd name="T18" fmla="*/ 67 w 317"/>
              <a:gd name="T19" fmla="*/ 182 h 281"/>
              <a:gd name="T20" fmla="*/ 115 w 317"/>
              <a:gd name="T21" fmla="*/ 199 h 281"/>
              <a:gd name="T22" fmla="*/ 174 w 317"/>
              <a:gd name="T23" fmla="*/ 201 h 281"/>
              <a:gd name="T24" fmla="*/ 228 w 317"/>
              <a:gd name="T25" fmla="*/ 192 h 281"/>
              <a:gd name="T26" fmla="*/ 252 w 317"/>
              <a:gd name="T27" fmla="*/ 182 h 281"/>
              <a:gd name="T28" fmla="*/ 270 w 317"/>
              <a:gd name="T29" fmla="*/ 170 h 281"/>
              <a:gd name="T30" fmla="*/ 283 w 317"/>
              <a:gd name="T31" fmla="*/ 155 h 281"/>
              <a:gd name="T32" fmla="*/ 291 w 317"/>
              <a:gd name="T33" fmla="*/ 136 h 281"/>
              <a:gd name="T34" fmla="*/ 295 w 317"/>
              <a:gd name="T35" fmla="*/ 114 h 281"/>
              <a:gd name="T36" fmla="*/ 293 w 317"/>
              <a:gd name="T37" fmla="*/ 78 h 281"/>
              <a:gd name="T38" fmla="*/ 276 w 317"/>
              <a:gd name="T39" fmla="*/ 42 h 281"/>
              <a:gd name="T40" fmla="*/ 240 w 317"/>
              <a:gd name="T41" fmla="*/ 6 h 281"/>
              <a:gd name="T42" fmla="*/ 289 w 317"/>
              <a:gd name="T43" fmla="*/ 31 h 281"/>
              <a:gd name="T44" fmla="*/ 311 w 317"/>
              <a:gd name="T45" fmla="*/ 71 h 281"/>
              <a:gd name="T46" fmla="*/ 317 w 317"/>
              <a:gd name="T47" fmla="*/ 120 h 281"/>
              <a:gd name="T48" fmla="*/ 315 w 317"/>
              <a:gd name="T49" fmla="*/ 154 h 281"/>
              <a:gd name="T50" fmla="*/ 306 w 317"/>
              <a:gd name="T51" fmla="*/ 184 h 281"/>
              <a:gd name="T52" fmla="*/ 292 w 317"/>
              <a:gd name="T53" fmla="*/ 213 h 281"/>
              <a:gd name="T54" fmla="*/ 274 w 317"/>
              <a:gd name="T55" fmla="*/ 237 h 281"/>
              <a:gd name="T56" fmla="*/ 251 w 317"/>
              <a:gd name="T57" fmla="*/ 255 h 281"/>
              <a:gd name="T58" fmla="*/ 223 w 317"/>
              <a:gd name="T59" fmla="*/ 269 h 281"/>
              <a:gd name="T60" fmla="*/ 194 w 317"/>
              <a:gd name="T61" fmla="*/ 277 h 281"/>
              <a:gd name="T62" fmla="*/ 165 w 317"/>
              <a:gd name="T63" fmla="*/ 281 h 281"/>
              <a:gd name="T64" fmla="*/ 132 w 317"/>
              <a:gd name="T65" fmla="*/ 277 h 281"/>
              <a:gd name="T66" fmla="*/ 101 w 317"/>
              <a:gd name="T67" fmla="*/ 268 h 281"/>
              <a:gd name="T68" fmla="*/ 73 w 317"/>
              <a:gd name="T69" fmla="*/ 252 h 281"/>
              <a:gd name="T70" fmla="*/ 47 w 317"/>
              <a:gd name="T71" fmla="*/ 232 h 281"/>
              <a:gd name="T72" fmla="*/ 28 w 317"/>
              <a:gd name="T73" fmla="*/ 208 h 281"/>
              <a:gd name="T74" fmla="*/ 12 w 317"/>
              <a:gd name="T75" fmla="*/ 179 h 281"/>
              <a:gd name="T76" fmla="*/ 3 w 317"/>
              <a:gd name="T77" fmla="*/ 150 h 281"/>
              <a:gd name="T78" fmla="*/ 0 w 317"/>
              <a:gd name="T79" fmla="*/ 119 h 281"/>
              <a:gd name="T80" fmla="*/ 8 w 317"/>
              <a:gd name="T81" fmla="*/ 70 h 281"/>
              <a:gd name="T82" fmla="*/ 23 w 317"/>
              <a:gd name="T83" fmla="*/ 28 h 281"/>
              <a:gd name="T84" fmla="*/ 20 w 317"/>
              <a:gd name="T85" fmla="*/ 19 h 281"/>
              <a:gd name="T86" fmla="*/ 10 w 317"/>
              <a:gd name="T87" fmla="*/ 12 h 281"/>
              <a:gd name="T88" fmla="*/ 0 w 317"/>
              <a:gd name="T89" fmla="*/ 0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317" h="281">
                <a:moveTo>
                  <a:pt x="0" y="0"/>
                </a:moveTo>
                <a:lnTo>
                  <a:pt x="105" y="0"/>
                </a:lnTo>
                <a:lnTo>
                  <a:pt x="105" y="9"/>
                </a:lnTo>
                <a:lnTo>
                  <a:pt x="95" y="12"/>
                </a:lnTo>
                <a:lnTo>
                  <a:pt x="86" y="15"/>
                </a:lnTo>
                <a:lnTo>
                  <a:pt x="77" y="19"/>
                </a:lnTo>
                <a:lnTo>
                  <a:pt x="69" y="23"/>
                </a:lnTo>
                <a:lnTo>
                  <a:pt x="61" y="27"/>
                </a:lnTo>
                <a:lnTo>
                  <a:pt x="54" y="33"/>
                </a:lnTo>
                <a:lnTo>
                  <a:pt x="48" y="38"/>
                </a:lnTo>
                <a:lnTo>
                  <a:pt x="42" y="44"/>
                </a:lnTo>
                <a:lnTo>
                  <a:pt x="37" y="52"/>
                </a:lnTo>
                <a:lnTo>
                  <a:pt x="33" y="58"/>
                </a:lnTo>
                <a:lnTo>
                  <a:pt x="29" y="65"/>
                </a:lnTo>
                <a:lnTo>
                  <a:pt x="26" y="73"/>
                </a:lnTo>
                <a:lnTo>
                  <a:pt x="23" y="80"/>
                </a:lnTo>
                <a:lnTo>
                  <a:pt x="22" y="87"/>
                </a:lnTo>
                <a:lnTo>
                  <a:pt x="21" y="96"/>
                </a:lnTo>
                <a:lnTo>
                  <a:pt x="20" y="104"/>
                </a:lnTo>
                <a:lnTo>
                  <a:pt x="21" y="111"/>
                </a:lnTo>
                <a:lnTo>
                  <a:pt x="21" y="117"/>
                </a:lnTo>
                <a:lnTo>
                  <a:pt x="23" y="124"/>
                </a:lnTo>
                <a:lnTo>
                  <a:pt x="24" y="130"/>
                </a:lnTo>
                <a:lnTo>
                  <a:pt x="27" y="136"/>
                </a:lnTo>
                <a:lnTo>
                  <a:pt x="29" y="143"/>
                </a:lnTo>
                <a:lnTo>
                  <a:pt x="33" y="149"/>
                </a:lnTo>
                <a:lnTo>
                  <a:pt x="36" y="155"/>
                </a:lnTo>
                <a:lnTo>
                  <a:pt x="45" y="165"/>
                </a:lnTo>
                <a:lnTo>
                  <a:pt x="55" y="174"/>
                </a:lnTo>
                <a:lnTo>
                  <a:pt x="67" y="182"/>
                </a:lnTo>
                <a:lnTo>
                  <a:pt x="79" y="189"/>
                </a:lnTo>
                <a:lnTo>
                  <a:pt x="96" y="194"/>
                </a:lnTo>
                <a:lnTo>
                  <a:pt x="115" y="199"/>
                </a:lnTo>
                <a:lnTo>
                  <a:pt x="134" y="201"/>
                </a:lnTo>
                <a:lnTo>
                  <a:pt x="154" y="202"/>
                </a:lnTo>
                <a:lnTo>
                  <a:pt x="174" y="201"/>
                </a:lnTo>
                <a:lnTo>
                  <a:pt x="193" y="200"/>
                </a:lnTo>
                <a:lnTo>
                  <a:pt x="212" y="196"/>
                </a:lnTo>
                <a:lnTo>
                  <a:pt x="228" y="192"/>
                </a:lnTo>
                <a:lnTo>
                  <a:pt x="236" y="190"/>
                </a:lnTo>
                <a:lnTo>
                  <a:pt x="244" y="186"/>
                </a:lnTo>
                <a:lnTo>
                  <a:pt x="252" y="182"/>
                </a:lnTo>
                <a:lnTo>
                  <a:pt x="258" y="179"/>
                </a:lnTo>
                <a:lnTo>
                  <a:pt x="264" y="175"/>
                </a:lnTo>
                <a:lnTo>
                  <a:pt x="270" y="170"/>
                </a:lnTo>
                <a:lnTo>
                  <a:pt x="274" y="166"/>
                </a:lnTo>
                <a:lnTo>
                  <a:pt x="279" y="161"/>
                </a:lnTo>
                <a:lnTo>
                  <a:pt x="283" y="155"/>
                </a:lnTo>
                <a:lnTo>
                  <a:pt x="286" y="149"/>
                </a:lnTo>
                <a:lnTo>
                  <a:pt x="289" y="143"/>
                </a:lnTo>
                <a:lnTo>
                  <a:pt x="291" y="136"/>
                </a:lnTo>
                <a:lnTo>
                  <a:pt x="293" y="129"/>
                </a:lnTo>
                <a:lnTo>
                  <a:pt x="295" y="121"/>
                </a:lnTo>
                <a:lnTo>
                  <a:pt x="295" y="114"/>
                </a:lnTo>
                <a:lnTo>
                  <a:pt x="296" y="106"/>
                </a:lnTo>
                <a:lnTo>
                  <a:pt x="295" y="91"/>
                </a:lnTo>
                <a:lnTo>
                  <a:pt x="293" y="78"/>
                </a:lnTo>
                <a:lnTo>
                  <a:pt x="289" y="66"/>
                </a:lnTo>
                <a:lnTo>
                  <a:pt x="283" y="55"/>
                </a:lnTo>
                <a:lnTo>
                  <a:pt x="276" y="42"/>
                </a:lnTo>
                <a:lnTo>
                  <a:pt x="267" y="30"/>
                </a:lnTo>
                <a:lnTo>
                  <a:pt x="255" y="18"/>
                </a:lnTo>
                <a:lnTo>
                  <a:pt x="240" y="6"/>
                </a:lnTo>
                <a:lnTo>
                  <a:pt x="267" y="6"/>
                </a:lnTo>
                <a:lnTo>
                  <a:pt x="279" y="18"/>
                </a:lnTo>
                <a:lnTo>
                  <a:pt x="289" y="31"/>
                </a:lnTo>
                <a:lnTo>
                  <a:pt x="299" y="44"/>
                </a:lnTo>
                <a:lnTo>
                  <a:pt x="305" y="58"/>
                </a:lnTo>
                <a:lnTo>
                  <a:pt x="311" y="71"/>
                </a:lnTo>
                <a:lnTo>
                  <a:pt x="314" y="86"/>
                </a:lnTo>
                <a:lnTo>
                  <a:pt x="316" y="103"/>
                </a:lnTo>
                <a:lnTo>
                  <a:pt x="317" y="120"/>
                </a:lnTo>
                <a:lnTo>
                  <a:pt x="317" y="131"/>
                </a:lnTo>
                <a:lnTo>
                  <a:pt x="316" y="143"/>
                </a:lnTo>
                <a:lnTo>
                  <a:pt x="315" y="154"/>
                </a:lnTo>
                <a:lnTo>
                  <a:pt x="312" y="165"/>
                </a:lnTo>
                <a:lnTo>
                  <a:pt x="310" y="175"/>
                </a:lnTo>
                <a:lnTo>
                  <a:pt x="306" y="184"/>
                </a:lnTo>
                <a:lnTo>
                  <a:pt x="303" y="195"/>
                </a:lnTo>
                <a:lnTo>
                  <a:pt x="298" y="204"/>
                </a:lnTo>
                <a:lnTo>
                  <a:pt x="292" y="213"/>
                </a:lnTo>
                <a:lnTo>
                  <a:pt x="287" y="221"/>
                </a:lnTo>
                <a:lnTo>
                  <a:pt x="281" y="229"/>
                </a:lnTo>
                <a:lnTo>
                  <a:pt x="274" y="237"/>
                </a:lnTo>
                <a:lnTo>
                  <a:pt x="267" y="243"/>
                </a:lnTo>
                <a:lnTo>
                  <a:pt x="259" y="250"/>
                </a:lnTo>
                <a:lnTo>
                  <a:pt x="251" y="255"/>
                </a:lnTo>
                <a:lnTo>
                  <a:pt x="242" y="260"/>
                </a:lnTo>
                <a:lnTo>
                  <a:pt x="233" y="265"/>
                </a:lnTo>
                <a:lnTo>
                  <a:pt x="223" y="269"/>
                </a:lnTo>
                <a:lnTo>
                  <a:pt x="214" y="272"/>
                </a:lnTo>
                <a:lnTo>
                  <a:pt x="205" y="275"/>
                </a:lnTo>
                <a:lnTo>
                  <a:pt x="194" y="277"/>
                </a:lnTo>
                <a:lnTo>
                  <a:pt x="184" y="279"/>
                </a:lnTo>
                <a:lnTo>
                  <a:pt x="175" y="279"/>
                </a:lnTo>
                <a:lnTo>
                  <a:pt x="165" y="281"/>
                </a:lnTo>
                <a:lnTo>
                  <a:pt x="153" y="279"/>
                </a:lnTo>
                <a:lnTo>
                  <a:pt x="143" y="278"/>
                </a:lnTo>
                <a:lnTo>
                  <a:pt x="132" y="277"/>
                </a:lnTo>
                <a:lnTo>
                  <a:pt x="122" y="274"/>
                </a:lnTo>
                <a:lnTo>
                  <a:pt x="112" y="271"/>
                </a:lnTo>
                <a:lnTo>
                  <a:pt x="101" y="268"/>
                </a:lnTo>
                <a:lnTo>
                  <a:pt x="92" y="263"/>
                </a:lnTo>
                <a:lnTo>
                  <a:pt x="82" y="258"/>
                </a:lnTo>
                <a:lnTo>
                  <a:pt x="73" y="252"/>
                </a:lnTo>
                <a:lnTo>
                  <a:pt x="64" y="246"/>
                </a:lnTo>
                <a:lnTo>
                  <a:pt x="55" y="240"/>
                </a:lnTo>
                <a:lnTo>
                  <a:pt x="47" y="232"/>
                </a:lnTo>
                <a:lnTo>
                  <a:pt x="40" y="224"/>
                </a:lnTo>
                <a:lnTo>
                  <a:pt x="34" y="216"/>
                </a:lnTo>
                <a:lnTo>
                  <a:pt x="28" y="208"/>
                </a:lnTo>
                <a:lnTo>
                  <a:pt x="22" y="199"/>
                </a:lnTo>
                <a:lnTo>
                  <a:pt x="16" y="190"/>
                </a:lnTo>
                <a:lnTo>
                  <a:pt x="12" y="179"/>
                </a:lnTo>
                <a:lnTo>
                  <a:pt x="8" y="170"/>
                </a:lnTo>
                <a:lnTo>
                  <a:pt x="5" y="160"/>
                </a:lnTo>
                <a:lnTo>
                  <a:pt x="3" y="150"/>
                </a:lnTo>
                <a:lnTo>
                  <a:pt x="1" y="139"/>
                </a:lnTo>
                <a:lnTo>
                  <a:pt x="1" y="129"/>
                </a:lnTo>
                <a:lnTo>
                  <a:pt x="0" y="119"/>
                </a:lnTo>
                <a:lnTo>
                  <a:pt x="1" y="103"/>
                </a:lnTo>
                <a:lnTo>
                  <a:pt x="4" y="87"/>
                </a:lnTo>
                <a:lnTo>
                  <a:pt x="8" y="70"/>
                </a:lnTo>
                <a:lnTo>
                  <a:pt x="14" y="54"/>
                </a:lnTo>
                <a:lnTo>
                  <a:pt x="21" y="37"/>
                </a:lnTo>
                <a:lnTo>
                  <a:pt x="23" y="28"/>
                </a:lnTo>
                <a:lnTo>
                  <a:pt x="22" y="25"/>
                </a:lnTo>
                <a:lnTo>
                  <a:pt x="21" y="21"/>
                </a:lnTo>
                <a:lnTo>
                  <a:pt x="20" y="19"/>
                </a:lnTo>
                <a:lnTo>
                  <a:pt x="18" y="16"/>
                </a:lnTo>
                <a:lnTo>
                  <a:pt x="14" y="14"/>
                </a:lnTo>
                <a:lnTo>
                  <a:pt x="10" y="12"/>
                </a:lnTo>
                <a:lnTo>
                  <a:pt x="5" y="10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2" name="Freeform 96"/>
          <p:cNvSpPr>
            <a:spLocks noEditPoints="1"/>
          </p:cNvSpPr>
          <p:nvPr/>
        </p:nvSpPr>
        <p:spPr bwMode="auto">
          <a:xfrm>
            <a:off x="559585" y="2376794"/>
            <a:ext cx="87313" cy="68263"/>
          </a:xfrm>
          <a:custGeom>
            <a:avLst/>
            <a:gdLst>
              <a:gd name="T0" fmla="*/ 103 w 221"/>
              <a:gd name="T1" fmla="*/ 112 h 170"/>
              <a:gd name="T2" fmla="*/ 123 w 221"/>
              <a:gd name="T3" fmla="*/ 110 h 170"/>
              <a:gd name="T4" fmla="*/ 140 w 221"/>
              <a:gd name="T5" fmla="*/ 106 h 170"/>
              <a:gd name="T6" fmla="*/ 156 w 221"/>
              <a:gd name="T7" fmla="*/ 100 h 170"/>
              <a:gd name="T8" fmla="*/ 169 w 221"/>
              <a:gd name="T9" fmla="*/ 90 h 170"/>
              <a:gd name="T10" fmla="*/ 177 w 221"/>
              <a:gd name="T11" fmla="*/ 82 h 170"/>
              <a:gd name="T12" fmla="*/ 183 w 221"/>
              <a:gd name="T13" fmla="*/ 74 h 170"/>
              <a:gd name="T14" fmla="*/ 186 w 221"/>
              <a:gd name="T15" fmla="*/ 65 h 170"/>
              <a:gd name="T16" fmla="*/ 187 w 221"/>
              <a:gd name="T17" fmla="*/ 55 h 170"/>
              <a:gd name="T18" fmla="*/ 185 w 221"/>
              <a:gd name="T19" fmla="*/ 41 h 170"/>
              <a:gd name="T20" fmla="*/ 180 w 221"/>
              <a:gd name="T21" fmla="*/ 30 h 170"/>
              <a:gd name="T22" fmla="*/ 170 w 221"/>
              <a:gd name="T23" fmla="*/ 19 h 170"/>
              <a:gd name="T24" fmla="*/ 153 w 221"/>
              <a:gd name="T25" fmla="*/ 8 h 170"/>
              <a:gd name="T26" fmla="*/ 174 w 221"/>
              <a:gd name="T27" fmla="*/ 9 h 170"/>
              <a:gd name="T28" fmla="*/ 193 w 221"/>
              <a:gd name="T29" fmla="*/ 22 h 170"/>
              <a:gd name="T30" fmla="*/ 203 w 221"/>
              <a:gd name="T31" fmla="*/ 32 h 170"/>
              <a:gd name="T32" fmla="*/ 213 w 221"/>
              <a:gd name="T33" fmla="*/ 47 h 170"/>
              <a:gd name="T34" fmla="*/ 220 w 221"/>
              <a:gd name="T35" fmla="*/ 70 h 170"/>
              <a:gd name="T36" fmla="*/ 221 w 221"/>
              <a:gd name="T37" fmla="*/ 94 h 170"/>
              <a:gd name="T38" fmla="*/ 216 w 221"/>
              <a:gd name="T39" fmla="*/ 114 h 170"/>
              <a:gd name="T40" fmla="*/ 208 w 221"/>
              <a:gd name="T41" fmla="*/ 131 h 170"/>
              <a:gd name="T42" fmla="*/ 194 w 221"/>
              <a:gd name="T43" fmla="*/ 146 h 170"/>
              <a:gd name="T44" fmla="*/ 178 w 221"/>
              <a:gd name="T45" fmla="*/ 156 h 170"/>
              <a:gd name="T46" fmla="*/ 162 w 221"/>
              <a:gd name="T47" fmla="*/ 163 h 170"/>
              <a:gd name="T48" fmla="*/ 144 w 221"/>
              <a:gd name="T49" fmla="*/ 168 h 170"/>
              <a:gd name="T50" fmla="*/ 125 w 221"/>
              <a:gd name="T51" fmla="*/ 170 h 170"/>
              <a:gd name="T52" fmla="*/ 101 w 221"/>
              <a:gd name="T53" fmla="*/ 170 h 170"/>
              <a:gd name="T54" fmla="*/ 78 w 221"/>
              <a:gd name="T55" fmla="*/ 167 h 170"/>
              <a:gd name="T56" fmla="*/ 57 w 221"/>
              <a:gd name="T57" fmla="*/ 160 h 170"/>
              <a:gd name="T58" fmla="*/ 39 w 221"/>
              <a:gd name="T59" fmla="*/ 150 h 170"/>
              <a:gd name="T60" fmla="*/ 24 w 221"/>
              <a:gd name="T61" fmla="*/ 135 h 170"/>
              <a:gd name="T62" fmla="*/ 12 w 221"/>
              <a:gd name="T63" fmla="*/ 121 h 170"/>
              <a:gd name="T64" fmla="*/ 4 w 221"/>
              <a:gd name="T65" fmla="*/ 105 h 170"/>
              <a:gd name="T66" fmla="*/ 1 w 221"/>
              <a:gd name="T67" fmla="*/ 87 h 170"/>
              <a:gd name="T68" fmla="*/ 1 w 221"/>
              <a:gd name="T69" fmla="*/ 71 h 170"/>
              <a:gd name="T70" fmla="*/ 4 w 221"/>
              <a:gd name="T71" fmla="*/ 57 h 170"/>
              <a:gd name="T72" fmla="*/ 10 w 221"/>
              <a:gd name="T73" fmla="*/ 42 h 170"/>
              <a:gd name="T74" fmla="*/ 21 w 221"/>
              <a:gd name="T75" fmla="*/ 30 h 170"/>
              <a:gd name="T76" fmla="*/ 33 w 221"/>
              <a:gd name="T77" fmla="*/ 19 h 170"/>
              <a:gd name="T78" fmla="*/ 49 w 221"/>
              <a:gd name="T79" fmla="*/ 11 h 170"/>
              <a:gd name="T80" fmla="*/ 69 w 221"/>
              <a:gd name="T81" fmla="*/ 5 h 170"/>
              <a:gd name="T82" fmla="*/ 91 w 221"/>
              <a:gd name="T83" fmla="*/ 0 h 170"/>
              <a:gd name="T84" fmla="*/ 89 w 221"/>
              <a:gd name="T85" fmla="*/ 54 h 170"/>
              <a:gd name="T86" fmla="*/ 58 w 221"/>
              <a:gd name="T87" fmla="*/ 55 h 170"/>
              <a:gd name="T88" fmla="*/ 39 w 221"/>
              <a:gd name="T89" fmla="*/ 58 h 170"/>
              <a:gd name="T90" fmla="*/ 28 w 221"/>
              <a:gd name="T91" fmla="*/ 63 h 170"/>
              <a:gd name="T92" fmla="*/ 19 w 221"/>
              <a:gd name="T93" fmla="*/ 69 h 170"/>
              <a:gd name="T94" fmla="*/ 17 w 221"/>
              <a:gd name="T95" fmla="*/ 75 h 170"/>
              <a:gd name="T96" fmla="*/ 16 w 221"/>
              <a:gd name="T97" fmla="*/ 81 h 170"/>
              <a:gd name="T98" fmla="*/ 18 w 221"/>
              <a:gd name="T99" fmla="*/ 91 h 170"/>
              <a:gd name="T100" fmla="*/ 27 w 221"/>
              <a:gd name="T101" fmla="*/ 100 h 170"/>
              <a:gd name="T102" fmla="*/ 37 w 221"/>
              <a:gd name="T103" fmla="*/ 106 h 170"/>
              <a:gd name="T104" fmla="*/ 50 w 221"/>
              <a:gd name="T105" fmla="*/ 110 h 170"/>
              <a:gd name="T106" fmla="*/ 81 w 221"/>
              <a:gd name="T107" fmla="*/ 113 h 170"/>
              <a:gd name="T108" fmla="*/ 89 w 221"/>
              <a:gd name="T109" fmla="*/ 54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221" h="170">
                <a:moveTo>
                  <a:pt x="103" y="0"/>
                </a:moveTo>
                <a:lnTo>
                  <a:pt x="103" y="112"/>
                </a:lnTo>
                <a:lnTo>
                  <a:pt x="114" y="111"/>
                </a:lnTo>
                <a:lnTo>
                  <a:pt x="123" y="110"/>
                </a:lnTo>
                <a:lnTo>
                  <a:pt x="132" y="108"/>
                </a:lnTo>
                <a:lnTo>
                  <a:pt x="140" y="106"/>
                </a:lnTo>
                <a:lnTo>
                  <a:pt x="148" y="103"/>
                </a:lnTo>
                <a:lnTo>
                  <a:pt x="156" y="100"/>
                </a:lnTo>
                <a:lnTo>
                  <a:pt x="163" y="95"/>
                </a:lnTo>
                <a:lnTo>
                  <a:pt x="169" y="90"/>
                </a:lnTo>
                <a:lnTo>
                  <a:pt x="173" y="86"/>
                </a:lnTo>
                <a:lnTo>
                  <a:pt x="177" y="82"/>
                </a:lnTo>
                <a:lnTo>
                  <a:pt x="180" y="78"/>
                </a:lnTo>
                <a:lnTo>
                  <a:pt x="183" y="74"/>
                </a:lnTo>
                <a:lnTo>
                  <a:pt x="185" y="69"/>
                </a:lnTo>
                <a:lnTo>
                  <a:pt x="186" y="65"/>
                </a:lnTo>
                <a:lnTo>
                  <a:pt x="187" y="60"/>
                </a:lnTo>
                <a:lnTo>
                  <a:pt x="187" y="55"/>
                </a:lnTo>
                <a:lnTo>
                  <a:pt x="187" y="47"/>
                </a:lnTo>
                <a:lnTo>
                  <a:pt x="185" y="41"/>
                </a:lnTo>
                <a:lnTo>
                  <a:pt x="183" y="36"/>
                </a:lnTo>
                <a:lnTo>
                  <a:pt x="180" y="30"/>
                </a:lnTo>
                <a:lnTo>
                  <a:pt x="176" y="25"/>
                </a:lnTo>
                <a:lnTo>
                  <a:pt x="170" y="19"/>
                </a:lnTo>
                <a:lnTo>
                  <a:pt x="162" y="14"/>
                </a:lnTo>
                <a:lnTo>
                  <a:pt x="153" y="8"/>
                </a:lnTo>
                <a:lnTo>
                  <a:pt x="159" y="0"/>
                </a:lnTo>
                <a:lnTo>
                  <a:pt x="174" y="9"/>
                </a:lnTo>
                <a:lnTo>
                  <a:pt x="187" y="18"/>
                </a:lnTo>
                <a:lnTo>
                  <a:pt x="193" y="22"/>
                </a:lnTo>
                <a:lnTo>
                  <a:pt x="198" y="27"/>
                </a:lnTo>
                <a:lnTo>
                  <a:pt x="203" y="32"/>
                </a:lnTo>
                <a:lnTo>
                  <a:pt x="207" y="36"/>
                </a:lnTo>
                <a:lnTo>
                  <a:pt x="213" y="47"/>
                </a:lnTo>
                <a:lnTo>
                  <a:pt x="218" y="59"/>
                </a:lnTo>
                <a:lnTo>
                  <a:pt x="220" y="70"/>
                </a:lnTo>
                <a:lnTo>
                  <a:pt x="221" y="83"/>
                </a:lnTo>
                <a:lnTo>
                  <a:pt x="221" y="94"/>
                </a:lnTo>
                <a:lnTo>
                  <a:pt x="219" y="105"/>
                </a:lnTo>
                <a:lnTo>
                  <a:pt x="216" y="114"/>
                </a:lnTo>
                <a:lnTo>
                  <a:pt x="213" y="123"/>
                </a:lnTo>
                <a:lnTo>
                  <a:pt x="208" y="131"/>
                </a:lnTo>
                <a:lnTo>
                  <a:pt x="201" y="138"/>
                </a:lnTo>
                <a:lnTo>
                  <a:pt x="194" y="146"/>
                </a:lnTo>
                <a:lnTo>
                  <a:pt x="185" y="152"/>
                </a:lnTo>
                <a:lnTo>
                  <a:pt x="178" y="156"/>
                </a:lnTo>
                <a:lnTo>
                  <a:pt x="171" y="160"/>
                </a:lnTo>
                <a:lnTo>
                  <a:pt x="162" y="163"/>
                </a:lnTo>
                <a:lnTo>
                  <a:pt x="153" y="166"/>
                </a:lnTo>
                <a:lnTo>
                  <a:pt x="144" y="168"/>
                </a:lnTo>
                <a:lnTo>
                  <a:pt x="135" y="169"/>
                </a:lnTo>
                <a:lnTo>
                  <a:pt x="125" y="170"/>
                </a:lnTo>
                <a:lnTo>
                  <a:pt x="115" y="170"/>
                </a:lnTo>
                <a:lnTo>
                  <a:pt x="101" y="170"/>
                </a:lnTo>
                <a:lnTo>
                  <a:pt x="89" y="169"/>
                </a:lnTo>
                <a:lnTo>
                  <a:pt x="78" y="167"/>
                </a:lnTo>
                <a:lnTo>
                  <a:pt x="68" y="164"/>
                </a:lnTo>
                <a:lnTo>
                  <a:pt x="57" y="160"/>
                </a:lnTo>
                <a:lnTo>
                  <a:pt x="48" y="155"/>
                </a:lnTo>
                <a:lnTo>
                  <a:pt x="39" y="150"/>
                </a:lnTo>
                <a:lnTo>
                  <a:pt x="31" y="142"/>
                </a:lnTo>
                <a:lnTo>
                  <a:pt x="24" y="135"/>
                </a:lnTo>
                <a:lnTo>
                  <a:pt x="18" y="128"/>
                </a:lnTo>
                <a:lnTo>
                  <a:pt x="12" y="121"/>
                </a:lnTo>
                <a:lnTo>
                  <a:pt x="8" y="113"/>
                </a:lnTo>
                <a:lnTo>
                  <a:pt x="4" y="105"/>
                </a:lnTo>
                <a:lnTo>
                  <a:pt x="2" y="97"/>
                </a:lnTo>
                <a:lnTo>
                  <a:pt x="1" y="87"/>
                </a:lnTo>
                <a:lnTo>
                  <a:pt x="0" y="78"/>
                </a:lnTo>
                <a:lnTo>
                  <a:pt x="1" y="71"/>
                </a:lnTo>
                <a:lnTo>
                  <a:pt x="2" y="64"/>
                </a:lnTo>
                <a:lnTo>
                  <a:pt x="4" y="57"/>
                </a:lnTo>
                <a:lnTo>
                  <a:pt x="7" y="49"/>
                </a:lnTo>
                <a:lnTo>
                  <a:pt x="10" y="42"/>
                </a:lnTo>
                <a:lnTo>
                  <a:pt x="14" y="36"/>
                </a:lnTo>
                <a:lnTo>
                  <a:pt x="21" y="30"/>
                </a:lnTo>
                <a:lnTo>
                  <a:pt x="27" y="25"/>
                </a:lnTo>
                <a:lnTo>
                  <a:pt x="33" y="19"/>
                </a:lnTo>
                <a:lnTo>
                  <a:pt x="41" y="15"/>
                </a:lnTo>
                <a:lnTo>
                  <a:pt x="49" y="11"/>
                </a:lnTo>
                <a:lnTo>
                  <a:pt x="58" y="8"/>
                </a:lnTo>
                <a:lnTo>
                  <a:pt x="69" y="5"/>
                </a:lnTo>
                <a:lnTo>
                  <a:pt x="79" y="2"/>
                </a:lnTo>
                <a:lnTo>
                  <a:pt x="91" y="0"/>
                </a:lnTo>
                <a:lnTo>
                  <a:pt x="103" y="0"/>
                </a:lnTo>
                <a:close/>
                <a:moveTo>
                  <a:pt x="89" y="54"/>
                </a:moveTo>
                <a:lnTo>
                  <a:pt x="72" y="54"/>
                </a:lnTo>
                <a:lnTo>
                  <a:pt x="58" y="55"/>
                </a:lnTo>
                <a:lnTo>
                  <a:pt x="47" y="56"/>
                </a:lnTo>
                <a:lnTo>
                  <a:pt x="39" y="58"/>
                </a:lnTo>
                <a:lnTo>
                  <a:pt x="33" y="60"/>
                </a:lnTo>
                <a:lnTo>
                  <a:pt x="28" y="63"/>
                </a:lnTo>
                <a:lnTo>
                  <a:pt x="23" y="66"/>
                </a:lnTo>
                <a:lnTo>
                  <a:pt x="19" y="69"/>
                </a:lnTo>
                <a:lnTo>
                  <a:pt x="18" y="72"/>
                </a:lnTo>
                <a:lnTo>
                  <a:pt x="17" y="75"/>
                </a:lnTo>
                <a:lnTo>
                  <a:pt x="16" y="78"/>
                </a:lnTo>
                <a:lnTo>
                  <a:pt x="16" y="81"/>
                </a:lnTo>
                <a:lnTo>
                  <a:pt x="16" y="87"/>
                </a:lnTo>
                <a:lnTo>
                  <a:pt x="18" y="91"/>
                </a:lnTo>
                <a:lnTo>
                  <a:pt x="22" y="97"/>
                </a:lnTo>
                <a:lnTo>
                  <a:pt x="27" y="100"/>
                </a:lnTo>
                <a:lnTo>
                  <a:pt x="32" y="103"/>
                </a:lnTo>
                <a:lnTo>
                  <a:pt x="37" y="106"/>
                </a:lnTo>
                <a:lnTo>
                  <a:pt x="43" y="108"/>
                </a:lnTo>
                <a:lnTo>
                  <a:pt x="50" y="110"/>
                </a:lnTo>
                <a:lnTo>
                  <a:pt x="65" y="112"/>
                </a:lnTo>
                <a:lnTo>
                  <a:pt x="81" y="113"/>
                </a:lnTo>
                <a:lnTo>
                  <a:pt x="89" y="113"/>
                </a:lnTo>
                <a:lnTo>
                  <a:pt x="89" y="54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3" name="Freeform 97"/>
          <p:cNvSpPr>
            <a:spLocks/>
          </p:cNvSpPr>
          <p:nvPr/>
        </p:nvSpPr>
        <p:spPr bwMode="auto">
          <a:xfrm>
            <a:off x="524660" y="2316469"/>
            <a:ext cx="119063" cy="44450"/>
          </a:xfrm>
          <a:custGeom>
            <a:avLst/>
            <a:gdLst>
              <a:gd name="T0" fmla="*/ 0 w 303"/>
              <a:gd name="T1" fmla="*/ 25 h 111"/>
              <a:gd name="T2" fmla="*/ 260 w 303"/>
              <a:gd name="T3" fmla="*/ 25 h 111"/>
              <a:gd name="T4" fmla="*/ 270 w 303"/>
              <a:gd name="T5" fmla="*/ 25 h 111"/>
              <a:gd name="T6" fmla="*/ 278 w 303"/>
              <a:gd name="T7" fmla="*/ 24 h 111"/>
              <a:gd name="T8" fmla="*/ 284 w 303"/>
              <a:gd name="T9" fmla="*/ 22 h 111"/>
              <a:gd name="T10" fmla="*/ 288 w 303"/>
              <a:gd name="T11" fmla="*/ 20 h 111"/>
              <a:gd name="T12" fmla="*/ 292 w 303"/>
              <a:gd name="T13" fmla="*/ 17 h 111"/>
              <a:gd name="T14" fmla="*/ 294 w 303"/>
              <a:gd name="T15" fmla="*/ 12 h 111"/>
              <a:gd name="T16" fmla="*/ 295 w 303"/>
              <a:gd name="T17" fmla="*/ 6 h 111"/>
              <a:gd name="T18" fmla="*/ 296 w 303"/>
              <a:gd name="T19" fmla="*/ 0 h 111"/>
              <a:gd name="T20" fmla="*/ 303 w 303"/>
              <a:gd name="T21" fmla="*/ 0 h 111"/>
              <a:gd name="T22" fmla="*/ 303 w 303"/>
              <a:gd name="T23" fmla="*/ 111 h 111"/>
              <a:gd name="T24" fmla="*/ 296 w 303"/>
              <a:gd name="T25" fmla="*/ 111 h 111"/>
              <a:gd name="T26" fmla="*/ 295 w 303"/>
              <a:gd name="T27" fmla="*/ 104 h 111"/>
              <a:gd name="T28" fmla="*/ 294 w 303"/>
              <a:gd name="T29" fmla="*/ 98 h 111"/>
              <a:gd name="T30" fmla="*/ 291 w 303"/>
              <a:gd name="T31" fmla="*/ 94 h 111"/>
              <a:gd name="T32" fmla="*/ 287 w 303"/>
              <a:gd name="T33" fmla="*/ 90 h 111"/>
              <a:gd name="T34" fmla="*/ 283 w 303"/>
              <a:gd name="T35" fmla="*/ 88 h 111"/>
              <a:gd name="T36" fmla="*/ 278 w 303"/>
              <a:gd name="T37" fmla="*/ 87 h 111"/>
              <a:gd name="T38" fmla="*/ 270 w 303"/>
              <a:gd name="T39" fmla="*/ 86 h 111"/>
              <a:gd name="T40" fmla="*/ 260 w 303"/>
              <a:gd name="T41" fmla="*/ 86 h 111"/>
              <a:gd name="T42" fmla="*/ 43 w 303"/>
              <a:gd name="T43" fmla="*/ 86 h 111"/>
              <a:gd name="T44" fmla="*/ 33 w 303"/>
              <a:gd name="T45" fmla="*/ 86 h 111"/>
              <a:gd name="T46" fmla="*/ 26 w 303"/>
              <a:gd name="T47" fmla="*/ 87 h 111"/>
              <a:gd name="T48" fmla="*/ 20 w 303"/>
              <a:gd name="T49" fmla="*/ 89 h 111"/>
              <a:gd name="T50" fmla="*/ 16 w 303"/>
              <a:gd name="T51" fmla="*/ 91 h 111"/>
              <a:gd name="T52" fmla="*/ 13 w 303"/>
              <a:gd name="T53" fmla="*/ 94 h 111"/>
              <a:gd name="T54" fmla="*/ 11 w 303"/>
              <a:gd name="T55" fmla="*/ 98 h 111"/>
              <a:gd name="T56" fmla="*/ 8 w 303"/>
              <a:gd name="T57" fmla="*/ 104 h 111"/>
              <a:gd name="T58" fmla="*/ 7 w 303"/>
              <a:gd name="T59" fmla="*/ 111 h 111"/>
              <a:gd name="T60" fmla="*/ 0 w 303"/>
              <a:gd name="T61" fmla="*/ 111 h 111"/>
              <a:gd name="T62" fmla="*/ 0 w 303"/>
              <a:gd name="T63" fmla="*/ 25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03" h="111">
                <a:moveTo>
                  <a:pt x="0" y="25"/>
                </a:moveTo>
                <a:lnTo>
                  <a:pt x="260" y="25"/>
                </a:lnTo>
                <a:lnTo>
                  <a:pt x="270" y="25"/>
                </a:lnTo>
                <a:lnTo>
                  <a:pt x="278" y="24"/>
                </a:lnTo>
                <a:lnTo>
                  <a:pt x="284" y="22"/>
                </a:lnTo>
                <a:lnTo>
                  <a:pt x="288" y="20"/>
                </a:lnTo>
                <a:lnTo>
                  <a:pt x="292" y="17"/>
                </a:lnTo>
                <a:lnTo>
                  <a:pt x="294" y="12"/>
                </a:lnTo>
                <a:lnTo>
                  <a:pt x="295" y="6"/>
                </a:lnTo>
                <a:lnTo>
                  <a:pt x="296" y="0"/>
                </a:lnTo>
                <a:lnTo>
                  <a:pt x="303" y="0"/>
                </a:lnTo>
                <a:lnTo>
                  <a:pt x="303" y="111"/>
                </a:lnTo>
                <a:lnTo>
                  <a:pt x="296" y="111"/>
                </a:lnTo>
                <a:lnTo>
                  <a:pt x="295" y="104"/>
                </a:lnTo>
                <a:lnTo>
                  <a:pt x="294" y="98"/>
                </a:lnTo>
                <a:lnTo>
                  <a:pt x="291" y="94"/>
                </a:lnTo>
                <a:lnTo>
                  <a:pt x="287" y="90"/>
                </a:lnTo>
                <a:lnTo>
                  <a:pt x="283" y="88"/>
                </a:lnTo>
                <a:lnTo>
                  <a:pt x="278" y="87"/>
                </a:lnTo>
                <a:lnTo>
                  <a:pt x="270" y="86"/>
                </a:lnTo>
                <a:lnTo>
                  <a:pt x="260" y="86"/>
                </a:lnTo>
                <a:lnTo>
                  <a:pt x="43" y="86"/>
                </a:lnTo>
                <a:lnTo>
                  <a:pt x="33" y="86"/>
                </a:lnTo>
                <a:lnTo>
                  <a:pt x="26" y="87"/>
                </a:lnTo>
                <a:lnTo>
                  <a:pt x="20" y="89"/>
                </a:lnTo>
                <a:lnTo>
                  <a:pt x="16" y="91"/>
                </a:lnTo>
                <a:lnTo>
                  <a:pt x="13" y="94"/>
                </a:lnTo>
                <a:lnTo>
                  <a:pt x="11" y="98"/>
                </a:lnTo>
                <a:lnTo>
                  <a:pt x="8" y="104"/>
                </a:lnTo>
                <a:lnTo>
                  <a:pt x="7" y="111"/>
                </a:lnTo>
                <a:lnTo>
                  <a:pt x="0" y="111"/>
                </a:lnTo>
                <a:lnTo>
                  <a:pt x="0" y="25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4" name="Freeform 98"/>
          <p:cNvSpPr>
            <a:spLocks/>
          </p:cNvSpPr>
          <p:nvPr/>
        </p:nvSpPr>
        <p:spPr bwMode="auto">
          <a:xfrm>
            <a:off x="524660" y="2259319"/>
            <a:ext cx="119063" cy="42863"/>
          </a:xfrm>
          <a:custGeom>
            <a:avLst/>
            <a:gdLst>
              <a:gd name="T0" fmla="*/ 0 w 303"/>
              <a:gd name="T1" fmla="*/ 25 h 110"/>
              <a:gd name="T2" fmla="*/ 260 w 303"/>
              <a:gd name="T3" fmla="*/ 25 h 110"/>
              <a:gd name="T4" fmla="*/ 270 w 303"/>
              <a:gd name="T5" fmla="*/ 25 h 110"/>
              <a:gd name="T6" fmla="*/ 278 w 303"/>
              <a:gd name="T7" fmla="*/ 24 h 110"/>
              <a:gd name="T8" fmla="*/ 284 w 303"/>
              <a:gd name="T9" fmla="*/ 21 h 110"/>
              <a:gd name="T10" fmla="*/ 288 w 303"/>
              <a:gd name="T11" fmla="*/ 19 h 110"/>
              <a:gd name="T12" fmla="*/ 292 w 303"/>
              <a:gd name="T13" fmla="*/ 16 h 110"/>
              <a:gd name="T14" fmla="*/ 294 w 303"/>
              <a:gd name="T15" fmla="*/ 12 h 110"/>
              <a:gd name="T16" fmla="*/ 295 w 303"/>
              <a:gd name="T17" fmla="*/ 6 h 110"/>
              <a:gd name="T18" fmla="*/ 296 w 303"/>
              <a:gd name="T19" fmla="*/ 0 h 110"/>
              <a:gd name="T20" fmla="*/ 303 w 303"/>
              <a:gd name="T21" fmla="*/ 0 h 110"/>
              <a:gd name="T22" fmla="*/ 303 w 303"/>
              <a:gd name="T23" fmla="*/ 110 h 110"/>
              <a:gd name="T24" fmla="*/ 296 w 303"/>
              <a:gd name="T25" fmla="*/ 110 h 110"/>
              <a:gd name="T26" fmla="*/ 295 w 303"/>
              <a:gd name="T27" fmla="*/ 104 h 110"/>
              <a:gd name="T28" fmla="*/ 294 w 303"/>
              <a:gd name="T29" fmla="*/ 98 h 110"/>
              <a:gd name="T30" fmla="*/ 291 w 303"/>
              <a:gd name="T31" fmla="*/ 94 h 110"/>
              <a:gd name="T32" fmla="*/ 287 w 303"/>
              <a:gd name="T33" fmla="*/ 90 h 110"/>
              <a:gd name="T34" fmla="*/ 283 w 303"/>
              <a:gd name="T35" fmla="*/ 88 h 110"/>
              <a:gd name="T36" fmla="*/ 278 w 303"/>
              <a:gd name="T37" fmla="*/ 87 h 110"/>
              <a:gd name="T38" fmla="*/ 270 w 303"/>
              <a:gd name="T39" fmla="*/ 86 h 110"/>
              <a:gd name="T40" fmla="*/ 260 w 303"/>
              <a:gd name="T41" fmla="*/ 86 h 110"/>
              <a:gd name="T42" fmla="*/ 43 w 303"/>
              <a:gd name="T43" fmla="*/ 86 h 110"/>
              <a:gd name="T44" fmla="*/ 33 w 303"/>
              <a:gd name="T45" fmla="*/ 86 h 110"/>
              <a:gd name="T46" fmla="*/ 26 w 303"/>
              <a:gd name="T47" fmla="*/ 87 h 110"/>
              <a:gd name="T48" fmla="*/ 20 w 303"/>
              <a:gd name="T49" fmla="*/ 89 h 110"/>
              <a:gd name="T50" fmla="*/ 16 w 303"/>
              <a:gd name="T51" fmla="*/ 91 h 110"/>
              <a:gd name="T52" fmla="*/ 13 w 303"/>
              <a:gd name="T53" fmla="*/ 94 h 110"/>
              <a:gd name="T54" fmla="*/ 11 w 303"/>
              <a:gd name="T55" fmla="*/ 98 h 110"/>
              <a:gd name="T56" fmla="*/ 8 w 303"/>
              <a:gd name="T57" fmla="*/ 104 h 110"/>
              <a:gd name="T58" fmla="*/ 7 w 303"/>
              <a:gd name="T59" fmla="*/ 110 h 110"/>
              <a:gd name="T60" fmla="*/ 0 w 303"/>
              <a:gd name="T61" fmla="*/ 110 h 110"/>
              <a:gd name="T62" fmla="*/ 0 w 303"/>
              <a:gd name="T63" fmla="*/ 25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03" h="110">
                <a:moveTo>
                  <a:pt x="0" y="25"/>
                </a:moveTo>
                <a:lnTo>
                  <a:pt x="260" y="25"/>
                </a:lnTo>
                <a:lnTo>
                  <a:pt x="270" y="25"/>
                </a:lnTo>
                <a:lnTo>
                  <a:pt x="278" y="24"/>
                </a:lnTo>
                <a:lnTo>
                  <a:pt x="284" y="21"/>
                </a:lnTo>
                <a:lnTo>
                  <a:pt x="288" y="19"/>
                </a:lnTo>
                <a:lnTo>
                  <a:pt x="292" y="16"/>
                </a:lnTo>
                <a:lnTo>
                  <a:pt x="294" y="12"/>
                </a:lnTo>
                <a:lnTo>
                  <a:pt x="295" y="6"/>
                </a:lnTo>
                <a:lnTo>
                  <a:pt x="296" y="0"/>
                </a:lnTo>
                <a:lnTo>
                  <a:pt x="303" y="0"/>
                </a:lnTo>
                <a:lnTo>
                  <a:pt x="303" y="110"/>
                </a:lnTo>
                <a:lnTo>
                  <a:pt x="296" y="110"/>
                </a:lnTo>
                <a:lnTo>
                  <a:pt x="295" y="104"/>
                </a:lnTo>
                <a:lnTo>
                  <a:pt x="294" y="98"/>
                </a:lnTo>
                <a:lnTo>
                  <a:pt x="291" y="94"/>
                </a:lnTo>
                <a:lnTo>
                  <a:pt x="287" y="90"/>
                </a:lnTo>
                <a:lnTo>
                  <a:pt x="283" y="88"/>
                </a:lnTo>
                <a:lnTo>
                  <a:pt x="278" y="87"/>
                </a:lnTo>
                <a:lnTo>
                  <a:pt x="270" y="86"/>
                </a:lnTo>
                <a:lnTo>
                  <a:pt x="260" y="86"/>
                </a:lnTo>
                <a:lnTo>
                  <a:pt x="43" y="86"/>
                </a:lnTo>
                <a:lnTo>
                  <a:pt x="33" y="86"/>
                </a:lnTo>
                <a:lnTo>
                  <a:pt x="26" y="87"/>
                </a:lnTo>
                <a:lnTo>
                  <a:pt x="20" y="89"/>
                </a:lnTo>
                <a:lnTo>
                  <a:pt x="16" y="91"/>
                </a:lnTo>
                <a:lnTo>
                  <a:pt x="13" y="94"/>
                </a:lnTo>
                <a:lnTo>
                  <a:pt x="11" y="98"/>
                </a:lnTo>
                <a:lnTo>
                  <a:pt x="8" y="104"/>
                </a:lnTo>
                <a:lnTo>
                  <a:pt x="7" y="110"/>
                </a:lnTo>
                <a:lnTo>
                  <a:pt x="0" y="110"/>
                </a:lnTo>
                <a:lnTo>
                  <a:pt x="0" y="25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5" name="Freeform 99"/>
          <p:cNvSpPr>
            <a:spLocks/>
          </p:cNvSpPr>
          <p:nvPr/>
        </p:nvSpPr>
        <p:spPr bwMode="auto">
          <a:xfrm>
            <a:off x="561173" y="2125969"/>
            <a:ext cx="85725" cy="84138"/>
          </a:xfrm>
          <a:custGeom>
            <a:avLst/>
            <a:gdLst>
              <a:gd name="T0" fmla="*/ 215 w 215"/>
              <a:gd name="T1" fmla="*/ 111 h 214"/>
              <a:gd name="T2" fmla="*/ 53 w 215"/>
              <a:gd name="T3" fmla="*/ 181 h 214"/>
              <a:gd name="T4" fmla="*/ 40 w 215"/>
              <a:gd name="T5" fmla="*/ 187 h 214"/>
              <a:gd name="T6" fmla="*/ 29 w 215"/>
              <a:gd name="T7" fmla="*/ 192 h 214"/>
              <a:gd name="T8" fmla="*/ 22 w 215"/>
              <a:gd name="T9" fmla="*/ 196 h 214"/>
              <a:gd name="T10" fmla="*/ 16 w 215"/>
              <a:gd name="T11" fmla="*/ 200 h 214"/>
              <a:gd name="T12" fmla="*/ 14 w 215"/>
              <a:gd name="T13" fmla="*/ 203 h 214"/>
              <a:gd name="T14" fmla="*/ 12 w 215"/>
              <a:gd name="T15" fmla="*/ 206 h 214"/>
              <a:gd name="T16" fmla="*/ 10 w 215"/>
              <a:gd name="T17" fmla="*/ 210 h 214"/>
              <a:gd name="T18" fmla="*/ 8 w 215"/>
              <a:gd name="T19" fmla="*/ 214 h 214"/>
              <a:gd name="T20" fmla="*/ 0 w 215"/>
              <a:gd name="T21" fmla="*/ 214 h 214"/>
              <a:gd name="T22" fmla="*/ 0 w 215"/>
              <a:gd name="T23" fmla="*/ 107 h 214"/>
              <a:gd name="T24" fmla="*/ 8 w 215"/>
              <a:gd name="T25" fmla="*/ 107 h 214"/>
              <a:gd name="T26" fmla="*/ 8 w 215"/>
              <a:gd name="T27" fmla="*/ 111 h 214"/>
              <a:gd name="T28" fmla="*/ 10 w 215"/>
              <a:gd name="T29" fmla="*/ 115 h 214"/>
              <a:gd name="T30" fmla="*/ 11 w 215"/>
              <a:gd name="T31" fmla="*/ 118 h 214"/>
              <a:gd name="T32" fmla="*/ 12 w 215"/>
              <a:gd name="T33" fmla="*/ 120 h 214"/>
              <a:gd name="T34" fmla="*/ 15 w 215"/>
              <a:gd name="T35" fmla="*/ 122 h 214"/>
              <a:gd name="T36" fmla="*/ 18 w 215"/>
              <a:gd name="T37" fmla="*/ 124 h 214"/>
              <a:gd name="T38" fmla="*/ 21 w 215"/>
              <a:gd name="T39" fmla="*/ 126 h 214"/>
              <a:gd name="T40" fmla="*/ 24 w 215"/>
              <a:gd name="T41" fmla="*/ 126 h 214"/>
              <a:gd name="T42" fmla="*/ 29 w 215"/>
              <a:gd name="T43" fmla="*/ 126 h 214"/>
              <a:gd name="T44" fmla="*/ 36 w 215"/>
              <a:gd name="T45" fmla="*/ 123 h 214"/>
              <a:gd name="T46" fmla="*/ 44 w 215"/>
              <a:gd name="T47" fmla="*/ 120 h 214"/>
              <a:gd name="T48" fmla="*/ 55 w 215"/>
              <a:gd name="T49" fmla="*/ 116 h 214"/>
              <a:gd name="T50" fmla="*/ 133 w 215"/>
              <a:gd name="T51" fmla="*/ 83 h 214"/>
              <a:gd name="T52" fmla="*/ 66 w 215"/>
              <a:gd name="T53" fmla="*/ 56 h 214"/>
              <a:gd name="T54" fmla="*/ 52 w 215"/>
              <a:gd name="T55" fmla="*/ 51 h 214"/>
              <a:gd name="T56" fmla="*/ 41 w 215"/>
              <a:gd name="T57" fmla="*/ 47 h 214"/>
              <a:gd name="T58" fmla="*/ 32 w 215"/>
              <a:gd name="T59" fmla="*/ 45 h 214"/>
              <a:gd name="T60" fmla="*/ 25 w 215"/>
              <a:gd name="T61" fmla="*/ 45 h 214"/>
              <a:gd name="T62" fmla="*/ 21 w 215"/>
              <a:gd name="T63" fmla="*/ 45 h 214"/>
              <a:gd name="T64" fmla="*/ 18 w 215"/>
              <a:gd name="T65" fmla="*/ 46 h 214"/>
              <a:gd name="T66" fmla="*/ 16 w 215"/>
              <a:gd name="T67" fmla="*/ 47 h 214"/>
              <a:gd name="T68" fmla="*/ 13 w 215"/>
              <a:gd name="T69" fmla="*/ 49 h 214"/>
              <a:gd name="T70" fmla="*/ 11 w 215"/>
              <a:gd name="T71" fmla="*/ 52 h 214"/>
              <a:gd name="T72" fmla="*/ 10 w 215"/>
              <a:gd name="T73" fmla="*/ 56 h 214"/>
              <a:gd name="T74" fmla="*/ 8 w 215"/>
              <a:gd name="T75" fmla="*/ 61 h 214"/>
              <a:gd name="T76" fmla="*/ 8 w 215"/>
              <a:gd name="T77" fmla="*/ 66 h 214"/>
              <a:gd name="T78" fmla="*/ 0 w 215"/>
              <a:gd name="T79" fmla="*/ 66 h 214"/>
              <a:gd name="T80" fmla="*/ 0 w 215"/>
              <a:gd name="T81" fmla="*/ 0 h 214"/>
              <a:gd name="T82" fmla="*/ 8 w 215"/>
              <a:gd name="T83" fmla="*/ 0 h 214"/>
              <a:gd name="T84" fmla="*/ 10 w 215"/>
              <a:gd name="T85" fmla="*/ 5 h 214"/>
              <a:gd name="T86" fmla="*/ 11 w 215"/>
              <a:gd name="T87" fmla="*/ 9 h 214"/>
              <a:gd name="T88" fmla="*/ 13 w 215"/>
              <a:gd name="T89" fmla="*/ 12 h 214"/>
              <a:gd name="T90" fmla="*/ 16 w 215"/>
              <a:gd name="T91" fmla="*/ 16 h 214"/>
              <a:gd name="T92" fmla="*/ 20 w 215"/>
              <a:gd name="T93" fmla="*/ 19 h 214"/>
              <a:gd name="T94" fmla="*/ 28 w 215"/>
              <a:gd name="T95" fmla="*/ 23 h 214"/>
              <a:gd name="T96" fmla="*/ 38 w 215"/>
              <a:gd name="T97" fmla="*/ 28 h 214"/>
              <a:gd name="T98" fmla="*/ 51 w 215"/>
              <a:gd name="T99" fmla="*/ 35 h 214"/>
              <a:gd name="T100" fmla="*/ 215 w 215"/>
              <a:gd name="T101" fmla="*/ 102 h 214"/>
              <a:gd name="T102" fmla="*/ 215 w 215"/>
              <a:gd name="T103" fmla="*/ 111 h 2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215" h="214">
                <a:moveTo>
                  <a:pt x="215" y="111"/>
                </a:moveTo>
                <a:lnTo>
                  <a:pt x="53" y="181"/>
                </a:lnTo>
                <a:lnTo>
                  <a:pt x="40" y="187"/>
                </a:lnTo>
                <a:lnTo>
                  <a:pt x="29" y="192"/>
                </a:lnTo>
                <a:lnTo>
                  <a:pt x="22" y="196"/>
                </a:lnTo>
                <a:lnTo>
                  <a:pt x="16" y="200"/>
                </a:lnTo>
                <a:lnTo>
                  <a:pt x="14" y="203"/>
                </a:lnTo>
                <a:lnTo>
                  <a:pt x="12" y="206"/>
                </a:lnTo>
                <a:lnTo>
                  <a:pt x="10" y="210"/>
                </a:lnTo>
                <a:lnTo>
                  <a:pt x="8" y="214"/>
                </a:lnTo>
                <a:lnTo>
                  <a:pt x="0" y="214"/>
                </a:lnTo>
                <a:lnTo>
                  <a:pt x="0" y="107"/>
                </a:lnTo>
                <a:lnTo>
                  <a:pt x="8" y="107"/>
                </a:lnTo>
                <a:lnTo>
                  <a:pt x="8" y="111"/>
                </a:lnTo>
                <a:lnTo>
                  <a:pt x="10" y="115"/>
                </a:lnTo>
                <a:lnTo>
                  <a:pt x="11" y="118"/>
                </a:lnTo>
                <a:lnTo>
                  <a:pt x="12" y="120"/>
                </a:lnTo>
                <a:lnTo>
                  <a:pt x="15" y="122"/>
                </a:lnTo>
                <a:lnTo>
                  <a:pt x="18" y="124"/>
                </a:lnTo>
                <a:lnTo>
                  <a:pt x="21" y="126"/>
                </a:lnTo>
                <a:lnTo>
                  <a:pt x="24" y="126"/>
                </a:lnTo>
                <a:lnTo>
                  <a:pt x="29" y="126"/>
                </a:lnTo>
                <a:lnTo>
                  <a:pt x="36" y="123"/>
                </a:lnTo>
                <a:lnTo>
                  <a:pt x="44" y="120"/>
                </a:lnTo>
                <a:lnTo>
                  <a:pt x="55" y="116"/>
                </a:lnTo>
                <a:lnTo>
                  <a:pt x="133" y="83"/>
                </a:lnTo>
                <a:lnTo>
                  <a:pt x="66" y="56"/>
                </a:lnTo>
                <a:lnTo>
                  <a:pt x="52" y="51"/>
                </a:lnTo>
                <a:lnTo>
                  <a:pt x="41" y="47"/>
                </a:lnTo>
                <a:lnTo>
                  <a:pt x="32" y="45"/>
                </a:lnTo>
                <a:lnTo>
                  <a:pt x="25" y="45"/>
                </a:lnTo>
                <a:lnTo>
                  <a:pt x="21" y="45"/>
                </a:lnTo>
                <a:lnTo>
                  <a:pt x="18" y="46"/>
                </a:lnTo>
                <a:lnTo>
                  <a:pt x="16" y="47"/>
                </a:lnTo>
                <a:lnTo>
                  <a:pt x="13" y="49"/>
                </a:lnTo>
                <a:lnTo>
                  <a:pt x="11" y="52"/>
                </a:lnTo>
                <a:lnTo>
                  <a:pt x="10" y="56"/>
                </a:lnTo>
                <a:lnTo>
                  <a:pt x="8" y="61"/>
                </a:lnTo>
                <a:lnTo>
                  <a:pt x="8" y="66"/>
                </a:lnTo>
                <a:lnTo>
                  <a:pt x="0" y="66"/>
                </a:lnTo>
                <a:lnTo>
                  <a:pt x="0" y="0"/>
                </a:lnTo>
                <a:lnTo>
                  <a:pt x="8" y="0"/>
                </a:lnTo>
                <a:lnTo>
                  <a:pt x="10" y="5"/>
                </a:lnTo>
                <a:lnTo>
                  <a:pt x="11" y="9"/>
                </a:lnTo>
                <a:lnTo>
                  <a:pt x="13" y="12"/>
                </a:lnTo>
                <a:lnTo>
                  <a:pt x="16" y="16"/>
                </a:lnTo>
                <a:lnTo>
                  <a:pt x="20" y="19"/>
                </a:lnTo>
                <a:lnTo>
                  <a:pt x="28" y="23"/>
                </a:lnTo>
                <a:lnTo>
                  <a:pt x="38" y="28"/>
                </a:lnTo>
                <a:lnTo>
                  <a:pt x="51" y="35"/>
                </a:lnTo>
                <a:lnTo>
                  <a:pt x="215" y="102"/>
                </a:lnTo>
                <a:lnTo>
                  <a:pt x="215" y="111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6" name="Freeform 100"/>
          <p:cNvSpPr>
            <a:spLocks noEditPoints="1"/>
          </p:cNvSpPr>
          <p:nvPr/>
        </p:nvSpPr>
        <p:spPr bwMode="auto">
          <a:xfrm>
            <a:off x="521485" y="2067231"/>
            <a:ext cx="122238" cy="44450"/>
          </a:xfrm>
          <a:custGeom>
            <a:avLst/>
            <a:gdLst>
              <a:gd name="T0" fmla="*/ 1 w 310"/>
              <a:gd name="T1" fmla="*/ 48 h 110"/>
              <a:gd name="T2" fmla="*/ 6 w 310"/>
              <a:gd name="T3" fmla="*/ 36 h 110"/>
              <a:gd name="T4" fmla="*/ 15 w 310"/>
              <a:gd name="T5" fmla="*/ 27 h 110"/>
              <a:gd name="T6" fmla="*/ 28 w 310"/>
              <a:gd name="T7" fmla="*/ 22 h 110"/>
              <a:gd name="T8" fmla="*/ 42 w 310"/>
              <a:gd name="T9" fmla="*/ 22 h 110"/>
              <a:gd name="T10" fmla="*/ 54 w 310"/>
              <a:gd name="T11" fmla="*/ 27 h 110"/>
              <a:gd name="T12" fmla="*/ 64 w 310"/>
              <a:gd name="T13" fmla="*/ 36 h 110"/>
              <a:gd name="T14" fmla="*/ 69 w 310"/>
              <a:gd name="T15" fmla="*/ 49 h 110"/>
              <a:gd name="T16" fmla="*/ 69 w 310"/>
              <a:gd name="T17" fmla="*/ 62 h 110"/>
              <a:gd name="T18" fmla="*/ 64 w 310"/>
              <a:gd name="T19" fmla="*/ 73 h 110"/>
              <a:gd name="T20" fmla="*/ 54 w 310"/>
              <a:gd name="T21" fmla="*/ 83 h 110"/>
              <a:gd name="T22" fmla="*/ 42 w 310"/>
              <a:gd name="T23" fmla="*/ 88 h 110"/>
              <a:gd name="T24" fmla="*/ 28 w 310"/>
              <a:gd name="T25" fmla="*/ 88 h 110"/>
              <a:gd name="T26" fmla="*/ 15 w 310"/>
              <a:gd name="T27" fmla="*/ 83 h 110"/>
              <a:gd name="T28" fmla="*/ 6 w 310"/>
              <a:gd name="T29" fmla="*/ 73 h 110"/>
              <a:gd name="T30" fmla="*/ 1 w 310"/>
              <a:gd name="T31" fmla="*/ 62 h 110"/>
              <a:gd name="T32" fmla="*/ 101 w 310"/>
              <a:gd name="T33" fmla="*/ 24 h 110"/>
              <a:gd name="T34" fmla="*/ 277 w 310"/>
              <a:gd name="T35" fmla="*/ 24 h 110"/>
              <a:gd name="T36" fmla="*/ 291 w 310"/>
              <a:gd name="T37" fmla="*/ 21 h 110"/>
              <a:gd name="T38" fmla="*/ 299 w 310"/>
              <a:gd name="T39" fmla="*/ 16 h 110"/>
              <a:gd name="T40" fmla="*/ 302 w 310"/>
              <a:gd name="T41" fmla="*/ 6 h 110"/>
              <a:gd name="T42" fmla="*/ 310 w 310"/>
              <a:gd name="T43" fmla="*/ 0 h 110"/>
              <a:gd name="T44" fmla="*/ 303 w 310"/>
              <a:gd name="T45" fmla="*/ 110 h 110"/>
              <a:gd name="T46" fmla="*/ 301 w 310"/>
              <a:gd name="T47" fmla="*/ 99 h 110"/>
              <a:gd name="T48" fmla="*/ 294 w 310"/>
              <a:gd name="T49" fmla="*/ 90 h 110"/>
              <a:gd name="T50" fmla="*/ 285 w 310"/>
              <a:gd name="T51" fmla="*/ 87 h 110"/>
              <a:gd name="T52" fmla="*/ 267 w 310"/>
              <a:gd name="T53" fmla="*/ 86 h 110"/>
              <a:gd name="T54" fmla="*/ 135 w 310"/>
              <a:gd name="T55" fmla="*/ 86 h 110"/>
              <a:gd name="T56" fmla="*/ 121 w 310"/>
              <a:gd name="T57" fmla="*/ 89 h 110"/>
              <a:gd name="T58" fmla="*/ 114 w 310"/>
              <a:gd name="T59" fmla="*/ 94 h 110"/>
              <a:gd name="T60" fmla="*/ 109 w 310"/>
              <a:gd name="T61" fmla="*/ 104 h 110"/>
              <a:gd name="T62" fmla="*/ 101 w 310"/>
              <a:gd name="T63" fmla="*/ 11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10" h="110">
                <a:moveTo>
                  <a:pt x="0" y="55"/>
                </a:moveTo>
                <a:lnTo>
                  <a:pt x="1" y="48"/>
                </a:lnTo>
                <a:lnTo>
                  <a:pt x="3" y="42"/>
                </a:lnTo>
                <a:lnTo>
                  <a:pt x="6" y="36"/>
                </a:lnTo>
                <a:lnTo>
                  <a:pt x="10" y="31"/>
                </a:lnTo>
                <a:lnTo>
                  <a:pt x="15" y="27"/>
                </a:lnTo>
                <a:lnTo>
                  <a:pt x="22" y="24"/>
                </a:lnTo>
                <a:lnTo>
                  <a:pt x="28" y="22"/>
                </a:lnTo>
                <a:lnTo>
                  <a:pt x="35" y="21"/>
                </a:lnTo>
                <a:lnTo>
                  <a:pt x="42" y="22"/>
                </a:lnTo>
                <a:lnTo>
                  <a:pt x="48" y="24"/>
                </a:lnTo>
                <a:lnTo>
                  <a:pt x="54" y="27"/>
                </a:lnTo>
                <a:lnTo>
                  <a:pt x="59" y="31"/>
                </a:lnTo>
                <a:lnTo>
                  <a:pt x="64" y="36"/>
                </a:lnTo>
                <a:lnTo>
                  <a:pt x="67" y="43"/>
                </a:lnTo>
                <a:lnTo>
                  <a:pt x="69" y="49"/>
                </a:lnTo>
                <a:lnTo>
                  <a:pt x="70" y="55"/>
                </a:lnTo>
                <a:lnTo>
                  <a:pt x="69" y="62"/>
                </a:lnTo>
                <a:lnTo>
                  <a:pt x="67" y="68"/>
                </a:lnTo>
                <a:lnTo>
                  <a:pt x="64" y="73"/>
                </a:lnTo>
                <a:lnTo>
                  <a:pt x="59" y="78"/>
                </a:lnTo>
                <a:lnTo>
                  <a:pt x="54" y="83"/>
                </a:lnTo>
                <a:lnTo>
                  <a:pt x="48" y="87"/>
                </a:lnTo>
                <a:lnTo>
                  <a:pt x="42" y="88"/>
                </a:lnTo>
                <a:lnTo>
                  <a:pt x="35" y="89"/>
                </a:lnTo>
                <a:lnTo>
                  <a:pt x="28" y="88"/>
                </a:lnTo>
                <a:lnTo>
                  <a:pt x="22" y="87"/>
                </a:lnTo>
                <a:lnTo>
                  <a:pt x="15" y="83"/>
                </a:lnTo>
                <a:lnTo>
                  <a:pt x="10" y="78"/>
                </a:lnTo>
                <a:lnTo>
                  <a:pt x="6" y="73"/>
                </a:lnTo>
                <a:lnTo>
                  <a:pt x="3" y="68"/>
                </a:lnTo>
                <a:lnTo>
                  <a:pt x="1" y="62"/>
                </a:lnTo>
                <a:lnTo>
                  <a:pt x="0" y="55"/>
                </a:lnTo>
                <a:close/>
                <a:moveTo>
                  <a:pt x="101" y="24"/>
                </a:moveTo>
                <a:lnTo>
                  <a:pt x="267" y="24"/>
                </a:lnTo>
                <a:lnTo>
                  <a:pt x="277" y="24"/>
                </a:lnTo>
                <a:lnTo>
                  <a:pt x="285" y="23"/>
                </a:lnTo>
                <a:lnTo>
                  <a:pt x="291" y="21"/>
                </a:lnTo>
                <a:lnTo>
                  <a:pt x="295" y="19"/>
                </a:lnTo>
                <a:lnTo>
                  <a:pt x="299" y="16"/>
                </a:lnTo>
                <a:lnTo>
                  <a:pt x="301" y="12"/>
                </a:lnTo>
                <a:lnTo>
                  <a:pt x="302" y="6"/>
                </a:lnTo>
                <a:lnTo>
                  <a:pt x="303" y="0"/>
                </a:lnTo>
                <a:lnTo>
                  <a:pt x="310" y="0"/>
                </a:lnTo>
                <a:lnTo>
                  <a:pt x="310" y="110"/>
                </a:lnTo>
                <a:lnTo>
                  <a:pt x="303" y="110"/>
                </a:lnTo>
                <a:lnTo>
                  <a:pt x="302" y="104"/>
                </a:lnTo>
                <a:lnTo>
                  <a:pt x="301" y="99"/>
                </a:lnTo>
                <a:lnTo>
                  <a:pt x="298" y="94"/>
                </a:lnTo>
                <a:lnTo>
                  <a:pt x="294" y="90"/>
                </a:lnTo>
                <a:lnTo>
                  <a:pt x="290" y="88"/>
                </a:lnTo>
                <a:lnTo>
                  <a:pt x="285" y="87"/>
                </a:lnTo>
                <a:lnTo>
                  <a:pt x="277" y="86"/>
                </a:lnTo>
                <a:lnTo>
                  <a:pt x="267" y="86"/>
                </a:lnTo>
                <a:lnTo>
                  <a:pt x="145" y="86"/>
                </a:lnTo>
                <a:lnTo>
                  <a:pt x="135" y="86"/>
                </a:lnTo>
                <a:lnTo>
                  <a:pt x="127" y="87"/>
                </a:lnTo>
                <a:lnTo>
                  <a:pt x="121" y="89"/>
                </a:lnTo>
                <a:lnTo>
                  <a:pt x="117" y="91"/>
                </a:lnTo>
                <a:lnTo>
                  <a:pt x="114" y="94"/>
                </a:lnTo>
                <a:lnTo>
                  <a:pt x="112" y="98"/>
                </a:lnTo>
                <a:lnTo>
                  <a:pt x="109" y="104"/>
                </a:lnTo>
                <a:lnTo>
                  <a:pt x="109" y="110"/>
                </a:lnTo>
                <a:lnTo>
                  <a:pt x="101" y="110"/>
                </a:lnTo>
                <a:lnTo>
                  <a:pt x="101" y="24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7" name="Freeform 101"/>
          <p:cNvSpPr>
            <a:spLocks noEditPoints="1"/>
          </p:cNvSpPr>
          <p:nvPr/>
        </p:nvSpPr>
        <p:spPr bwMode="auto">
          <a:xfrm>
            <a:off x="559585" y="1971981"/>
            <a:ext cx="85725" cy="77788"/>
          </a:xfrm>
          <a:custGeom>
            <a:avLst/>
            <a:gdLst>
              <a:gd name="T0" fmla="*/ 199 w 218"/>
              <a:gd name="T1" fmla="*/ 107 h 196"/>
              <a:gd name="T2" fmla="*/ 213 w 218"/>
              <a:gd name="T3" fmla="*/ 132 h 196"/>
              <a:gd name="T4" fmla="*/ 218 w 218"/>
              <a:gd name="T5" fmla="*/ 155 h 196"/>
              <a:gd name="T6" fmla="*/ 212 w 218"/>
              <a:gd name="T7" fmla="*/ 178 h 196"/>
              <a:gd name="T8" fmla="*/ 193 w 218"/>
              <a:gd name="T9" fmla="*/ 193 h 196"/>
              <a:gd name="T10" fmla="*/ 171 w 218"/>
              <a:gd name="T11" fmla="*/ 196 h 196"/>
              <a:gd name="T12" fmla="*/ 154 w 218"/>
              <a:gd name="T13" fmla="*/ 191 h 196"/>
              <a:gd name="T14" fmla="*/ 139 w 218"/>
              <a:gd name="T15" fmla="*/ 180 h 196"/>
              <a:gd name="T16" fmla="*/ 124 w 218"/>
              <a:gd name="T17" fmla="*/ 163 h 196"/>
              <a:gd name="T18" fmla="*/ 98 w 218"/>
              <a:gd name="T19" fmla="*/ 119 h 196"/>
              <a:gd name="T20" fmla="*/ 43 w 218"/>
              <a:gd name="T21" fmla="*/ 89 h 196"/>
              <a:gd name="T22" fmla="*/ 27 w 218"/>
              <a:gd name="T23" fmla="*/ 94 h 196"/>
              <a:gd name="T24" fmla="*/ 20 w 218"/>
              <a:gd name="T25" fmla="*/ 104 h 196"/>
              <a:gd name="T26" fmla="*/ 18 w 218"/>
              <a:gd name="T27" fmla="*/ 116 h 196"/>
              <a:gd name="T28" fmla="*/ 21 w 218"/>
              <a:gd name="T29" fmla="*/ 134 h 196"/>
              <a:gd name="T30" fmla="*/ 28 w 218"/>
              <a:gd name="T31" fmla="*/ 144 h 196"/>
              <a:gd name="T32" fmla="*/ 36 w 218"/>
              <a:gd name="T33" fmla="*/ 145 h 196"/>
              <a:gd name="T34" fmla="*/ 45 w 218"/>
              <a:gd name="T35" fmla="*/ 139 h 196"/>
              <a:gd name="T36" fmla="*/ 58 w 218"/>
              <a:gd name="T37" fmla="*/ 131 h 196"/>
              <a:gd name="T38" fmla="*/ 74 w 218"/>
              <a:gd name="T39" fmla="*/ 132 h 196"/>
              <a:gd name="T40" fmla="*/ 85 w 218"/>
              <a:gd name="T41" fmla="*/ 143 h 196"/>
              <a:gd name="T42" fmla="*/ 89 w 218"/>
              <a:gd name="T43" fmla="*/ 160 h 196"/>
              <a:gd name="T44" fmla="*/ 85 w 218"/>
              <a:gd name="T45" fmla="*/ 177 h 196"/>
              <a:gd name="T46" fmla="*/ 72 w 218"/>
              <a:gd name="T47" fmla="*/ 190 h 196"/>
              <a:gd name="T48" fmla="*/ 53 w 218"/>
              <a:gd name="T49" fmla="*/ 191 h 196"/>
              <a:gd name="T50" fmla="*/ 31 w 218"/>
              <a:gd name="T51" fmla="*/ 179 h 196"/>
              <a:gd name="T52" fmla="*/ 12 w 218"/>
              <a:gd name="T53" fmla="*/ 155 h 196"/>
              <a:gd name="T54" fmla="*/ 2 w 218"/>
              <a:gd name="T55" fmla="*/ 122 h 196"/>
              <a:gd name="T56" fmla="*/ 1 w 218"/>
              <a:gd name="T57" fmla="*/ 84 h 196"/>
              <a:gd name="T58" fmla="*/ 7 w 218"/>
              <a:gd name="T59" fmla="*/ 62 h 196"/>
              <a:gd name="T60" fmla="*/ 20 w 218"/>
              <a:gd name="T61" fmla="*/ 44 h 196"/>
              <a:gd name="T62" fmla="*/ 40 w 218"/>
              <a:gd name="T63" fmla="*/ 31 h 196"/>
              <a:gd name="T64" fmla="*/ 68 w 218"/>
              <a:gd name="T65" fmla="*/ 28 h 196"/>
              <a:gd name="T66" fmla="*/ 176 w 218"/>
              <a:gd name="T67" fmla="*/ 27 h 196"/>
              <a:gd name="T68" fmla="*/ 187 w 218"/>
              <a:gd name="T69" fmla="*/ 23 h 196"/>
              <a:gd name="T70" fmla="*/ 188 w 218"/>
              <a:gd name="T71" fmla="*/ 16 h 196"/>
              <a:gd name="T72" fmla="*/ 181 w 218"/>
              <a:gd name="T73" fmla="*/ 7 h 196"/>
              <a:gd name="T74" fmla="*/ 200 w 218"/>
              <a:gd name="T75" fmla="*/ 11 h 196"/>
              <a:gd name="T76" fmla="*/ 214 w 218"/>
              <a:gd name="T77" fmla="*/ 28 h 196"/>
              <a:gd name="T78" fmla="*/ 218 w 218"/>
              <a:gd name="T79" fmla="*/ 50 h 196"/>
              <a:gd name="T80" fmla="*/ 214 w 218"/>
              <a:gd name="T81" fmla="*/ 71 h 196"/>
              <a:gd name="T82" fmla="*/ 199 w 218"/>
              <a:gd name="T83" fmla="*/ 84 h 196"/>
              <a:gd name="T84" fmla="*/ 168 w 218"/>
              <a:gd name="T85" fmla="*/ 88 h 196"/>
              <a:gd name="T86" fmla="*/ 115 w 218"/>
              <a:gd name="T87" fmla="*/ 111 h 196"/>
              <a:gd name="T88" fmla="*/ 138 w 218"/>
              <a:gd name="T89" fmla="*/ 131 h 196"/>
              <a:gd name="T90" fmla="*/ 157 w 218"/>
              <a:gd name="T91" fmla="*/ 136 h 196"/>
              <a:gd name="T92" fmla="*/ 171 w 218"/>
              <a:gd name="T93" fmla="*/ 132 h 196"/>
              <a:gd name="T94" fmla="*/ 179 w 218"/>
              <a:gd name="T95" fmla="*/ 122 h 196"/>
              <a:gd name="T96" fmla="*/ 180 w 218"/>
              <a:gd name="T97" fmla="*/ 108 h 196"/>
              <a:gd name="T98" fmla="*/ 168 w 218"/>
              <a:gd name="T99" fmla="*/ 88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218" h="196">
                <a:moveTo>
                  <a:pt x="184" y="88"/>
                </a:moveTo>
                <a:lnTo>
                  <a:pt x="192" y="98"/>
                </a:lnTo>
                <a:lnTo>
                  <a:pt x="199" y="107"/>
                </a:lnTo>
                <a:lnTo>
                  <a:pt x="205" y="115"/>
                </a:lnTo>
                <a:lnTo>
                  <a:pt x="210" y="124"/>
                </a:lnTo>
                <a:lnTo>
                  <a:pt x="213" y="132"/>
                </a:lnTo>
                <a:lnTo>
                  <a:pt x="216" y="139"/>
                </a:lnTo>
                <a:lnTo>
                  <a:pt x="218" y="148"/>
                </a:lnTo>
                <a:lnTo>
                  <a:pt x="218" y="155"/>
                </a:lnTo>
                <a:lnTo>
                  <a:pt x="217" y="164"/>
                </a:lnTo>
                <a:lnTo>
                  <a:pt x="215" y="171"/>
                </a:lnTo>
                <a:lnTo>
                  <a:pt x="212" y="178"/>
                </a:lnTo>
                <a:lnTo>
                  <a:pt x="207" y="184"/>
                </a:lnTo>
                <a:lnTo>
                  <a:pt x="200" y="190"/>
                </a:lnTo>
                <a:lnTo>
                  <a:pt x="193" y="193"/>
                </a:lnTo>
                <a:lnTo>
                  <a:pt x="185" y="195"/>
                </a:lnTo>
                <a:lnTo>
                  <a:pt x="177" y="196"/>
                </a:lnTo>
                <a:lnTo>
                  <a:pt x="171" y="196"/>
                </a:lnTo>
                <a:lnTo>
                  <a:pt x="166" y="195"/>
                </a:lnTo>
                <a:lnTo>
                  <a:pt x="160" y="193"/>
                </a:lnTo>
                <a:lnTo>
                  <a:pt x="154" y="191"/>
                </a:lnTo>
                <a:lnTo>
                  <a:pt x="149" y="187"/>
                </a:lnTo>
                <a:lnTo>
                  <a:pt x="144" y="184"/>
                </a:lnTo>
                <a:lnTo>
                  <a:pt x="139" y="180"/>
                </a:lnTo>
                <a:lnTo>
                  <a:pt x="134" y="175"/>
                </a:lnTo>
                <a:lnTo>
                  <a:pt x="129" y="170"/>
                </a:lnTo>
                <a:lnTo>
                  <a:pt x="124" y="163"/>
                </a:lnTo>
                <a:lnTo>
                  <a:pt x="118" y="154"/>
                </a:lnTo>
                <a:lnTo>
                  <a:pt x="112" y="144"/>
                </a:lnTo>
                <a:lnTo>
                  <a:pt x="98" y="119"/>
                </a:lnTo>
                <a:lnTo>
                  <a:pt x="83" y="88"/>
                </a:lnTo>
                <a:lnTo>
                  <a:pt x="63" y="88"/>
                </a:lnTo>
                <a:lnTo>
                  <a:pt x="43" y="89"/>
                </a:lnTo>
                <a:lnTo>
                  <a:pt x="33" y="90"/>
                </a:lnTo>
                <a:lnTo>
                  <a:pt x="30" y="92"/>
                </a:lnTo>
                <a:lnTo>
                  <a:pt x="27" y="94"/>
                </a:lnTo>
                <a:lnTo>
                  <a:pt x="25" y="98"/>
                </a:lnTo>
                <a:lnTo>
                  <a:pt x="22" y="101"/>
                </a:lnTo>
                <a:lnTo>
                  <a:pt x="20" y="104"/>
                </a:lnTo>
                <a:lnTo>
                  <a:pt x="19" y="108"/>
                </a:lnTo>
                <a:lnTo>
                  <a:pt x="18" y="112"/>
                </a:lnTo>
                <a:lnTo>
                  <a:pt x="18" y="116"/>
                </a:lnTo>
                <a:lnTo>
                  <a:pt x="18" y="123"/>
                </a:lnTo>
                <a:lnTo>
                  <a:pt x="19" y="129"/>
                </a:lnTo>
                <a:lnTo>
                  <a:pt x="21" y="134"/>
                </a:lnTo>
                <a:lnTo>
                  <a:pt x="24" y="139"/>
                </a:lnTo>
                <a:lnTo>
                  <a:pt x="26" y="141"/>
                </a:lnTo>
                <a:lnTo>
                  <a:pt x="28" y="144"/>
                </a:lnTo>
                <a:lnTo>
                  <a:pt x="31" y="145"/>
                </a:lnTo>
                <a:lnTo>
                  <a:pt x="33" y="146"/>
                </a:lnTo>
                <a:lnTo>
                  <a:pt x="36" y="145"/>
                </a:lnTo>
                <a:lnTo>
                  <a:pt x="38" y="144"/>
                </a:lnTo>
                <a:lnTo>
                  <a:pt x="41" y="141"/>
                </a:lnTo>
                <a:lnTo>
                  <a:pt x="45" y="139"/>
                </a:lnTo>
                <a:lnTo>
                  <a:pt x="49" y="135"/>
                </a:lnTo>
                <a:lnTo>
                  <a:pt x="54" y="133"/>
                </a:lnTo>
                <a:lnTo>
                  <a:pt x="58" y="131"/>
                </a:lnTo>
                <a:lnTo>
                  <a:pt x="64" y="130"/>
                </a:lnTo>
                <a:lnTo>
                  <a:pt x="69" y="131"/>
                </a:lnTo>
                <a:lnTo>
                  <a:pt x="74" y="132"/>
                </a:lnTo>
                <a:lnTo>
                  <a:pt x="78" y="135"/>
                </a:lnTo>
                <a:lnTo>
                  <a:pt x="82" y="138"/>
                </a:lnTo>
                <a:lnTo>
                  <a:pt x="85" y="143"/>
                </a:lnTo>
                <a:lnTo>
                  <a:pt x="88" y="148"/>
                </a:lnTo>
                <a:lnTo>
                  <a:pt x="89" y="154"/>
                </a:lnTo>
                <a:lnTo>
                  <a:pt x="89" y="160"/>
                </a:lnTo>
                <a:lnTo>
                  <a:pt x="89" y="166"/>
                </a:lnTo>
                <a:lnTo>
                  <a:pt x="87" y="172"/>
                </a:lnTo>
                <a:lnTo>
                  <a:pt x="85" y="177"/>
                </a:lnTo>
                <a:lnTo>
                  <a:pt x="81" y="182"/>
                </a:lnTo>
                <a:lnTo>
                  <a:pt x="77" y="186"/>
                </a:lnTo>
                <a:lnTo>
                  <a:pt x="72" y="190"/>
                </a:lnTo>
                <a:lnTo>
                  <a:pt x="67" y="192"/>
                </a:lnTo>
                <a:lnTo>
                  <a:pt x="61" y="192"/>
                </a:lnTo>
                <a:lnTo>
                  <a:pt x="53" y="191"/>
                </a:lnTo>
                <a:lnTo>
                  <a:pt x="45" y="189"/>
                </a:lnTo>
                <a:lnTo>
                  <a:pt x="38" y="184"/>
                </a:lnTo>
                <a:lnTo>
                  <a:pt x="31" y="179"/>
                </a:lnTo>
                <a:lnTo>
                  <a:pt x="24" y="172"/>
                </a:lnTo>
                <a:lnTo>
                  <a:pt x="18" y="164"/>
                </a:lnTo>
                <a:lnTo>
                  <a:pt x="12" y="155"/>
                </a:lnTo>
                <a:lnTo>
                  <a:pt x="8" y="145"/>
                </a:lnTo>
                <a:lnTo>
                  <a:pt x="5" y="133"/>
                </a:lnTo>
                <a:lnTo>
                  <a:pt x="2" y="122"/>
                </a:lnTo>
                <a:lnTo>
                  <a:pt x="1" y="110"/>
                </a:lnTo>
                <a:lnTo>
                  <a:pt x="0" y="99"/>
                </a:lnTo>
                <a:lnTo>
                  <a:pt x="1" y="84"/>
                </a:lnTo>
                <a:lnTo>
                  <a:pt x="3" y="72"/>
                </a:lnTo>
                <a:lnTo>
                  <a:pt x="5" y="67"/>
                </a:lnTo>
                <a:lnTo>
                  <a:pt x="7" y="62"/>
                </a:lnTo>
                <a:lnTo>
                  <a:pt x="10" y="57"/>
                </a:lnTo>
                <a:lnTo>
                  <a:pt x="13" y="53"/>
                </a:lnTo>
                <a:lnTo>
                  <a:pt x="20" y="44"/>
                </a:lnTo>
                <a:lnTo>
                  <a:pt x="26" y="38"/>
                </a:lnTo>
                <a:lnTo>
                  <a:pt x="33" y="34"/>
                </a:lnTo>
                <a:lnTo>
                  <a:pt x="40" y="31"/>
                </a:lnTo>
                <a:lnTo>
                  <a:pt x="46" y="29"/>
                </a:lnTo>
                <a:lnTo>
                  <a:pt x="55" y="28"/>
                </a:lnTo>
                <a:lnTo>
                  <a:pt x="68" y="28"/>
                </a:lnTo>
                <a:lnTo>
                  <a:pt x="83" y="28"/>
                </a:lnTo>
                <a:lnTo>
                  <a:pt x="164" y="28"/>
                </a:lnTo>
                <a:lnTo>
                  <a:pt x="176" y="27"/>
                </a:lnTo>
                <a:lnTo>
                  <a:pt x="182" y="26"/>
                </a:lnTo>
                <a:lnTo>
                  <a:pt x="185" y="25"/>
                </a:lnTo>
                <a:lnTo>
                  <a:pt x="187" y="23"/>
                </a:lnTo>
                <a:lnTo>
                  <a:pt x="189" y="21"/>
                </a:lnTo>
                <a:lnTo>
                  <a:pt x="189" y="18"/>
                </a:lnTo>
                <a:lnTo>
                  <a:pt x="188" y="16"/>
                </a:lnTo>
                <a:lnTo>
                  <a:pt x="187" y="13"/>
                </a:lnTo>
                <a:lnTo>
                  <a:pt x="185" y="10"/>
                </a:lnTo>
                <a:lnTo>
                  <a:pt x="181" y="7"/>
                </a:lnTo>
                <a:lnTo>
                  <a:pt x="186" y="0"/>
                </a:lnTo>
                <a:lnTo>
                  <a:pt x="194" y="6"/>
                </a:lnTo>
                <a:lnTo>
                  <a:pt x="200" y="11"/>
                </a:lnTo>
                <a:lnTo>
                  <a:pt x="207" y="17"/>
                </a:lnTo>
                <a:lnTo>
                  <a:pt x="211" y="23"/>
                </a:lnTo>
                <a:lnTo>
                  <a:pt x="214" y="28"/>
                </a:lnTo>
                <a:lnTo>
                  <a:pt x="216" y="35"/>
                </a:lnTo>
                <a:lnTo>
                  <a:pt x="218" y="41"/>
                </a:lnTo>
                <a:lnTo>
                  <a:pt x="218" y="50"/>
                </a:lnTo>
                <a:lnTo>
                  <a:pt x="218" y="58"/>
                </a:lnTo>
                <a:lnTo>
                  <a:pt x="216" y="65"/>
                </a:lnTo>
                <a:lnTo>
                  <a:pt x="214" y="71"/>
                </a:lnTo>
                <a:lnTo>
                  <a:pt x="210" y="76"/>
                </a:lnTo>
                <a:lnTo>
                  <a:pt x="205" y="81"/>
                </a:lnTo>
                <a:lnTo>
                  <a:pt x="199" y="84"/>
                </a:lnTo>
                <a:lnTo>
                  <a:pt x="192" y="86"/>
                </a:lnTo>
                <a:lnTo>
                  <a:pt x="184" y="88"/>
                </a:lnTo>
                <a:close/>
                <a:moveTo>
                  <a:pt x="168" y="88"/>
                </a:moveTo>
                <a:lnTo>
                  <a:pt x="98" y="88"/>
                </a:lnTo>
                <a:lnTo>
                  <a:pt x="106" y="101"/>
                </a:lnTo>
                <a:lnTo>
                  <a:pt x="115" y="111"/>
                </a:lnTo>
                <a:lnTo>
                  <a:pt x="123" y="120"/>
                </a:lnTo>
                <a:lnTo>
                  <a:pt x="132" y="127"/>
                </a:lnTo>
                <a:lnTo>
                  <a:pt x="138" y="131"/>
                </a:lnTo>
                <a:lnTo>
                  <a:pt x="144" y="134"/>
                </a:lnTo>
                <a:lnTo>
                  <a:pt x="150" y="135"/>
                </a:lnTo>
                <a:lnTo>
                  <a:pt x="157" y="136"/>
                </a:lnTo>
                <a:lnTo>
                  <a:pt x="162" y="135"/>
                </a:lnTo>
                <a:lnTo>
                  <a:pt x="166" y="134"/>
                </a:lnTo>
                <a:lnTo>
                  <a:pt x="171" y="132"/>
                </a:lnTo>
                <a:lnTo>
                  <a:pt x="175" y="129"/>
                </a:lnTo>
                <a:lnTo>
                  <a:pt x="177" y="126"/>
                </a:lnTo>
                <a:lnTo>
                  <a:pt x="179" y="122"/>
                </a:lnTo>
                <a:lnTo>
                  <a:pt x="180" y="118"/>
                </a:lnTo>
                <a:lnTo>
                  <a:pt x="180" y="114"/>
                </a:lnTo>
                <a:lnTo>
                  <a:pt x="180" y="108"/>
                </a:lnTo>
                <a:lnTo>
                  <a:pt x="177" y="102"/>
                </a:lnTo>
                <a:lnTo>
                  <a:pt x="173" y="96"/>
                </a:lnTo>
                <a:lnTo>
                  <a:pt x="168" y="88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8" name="Freeform 102"/>
          <p:cNvSpPr>
            <a:spLocks noEditPoints="1"/>
          </p:cNvSpPr>
          <p:nvPr/>
        </p:nvSpPr>
        <p:spPr bwMode="auto">
          <a:xfrm>
            <a:off x="524660" y="1868794"/>
            <a:ext cx="122238" cy="87313"/>
          </a:xfrm>
          <a:custGeom>
            <a:avLst/>
            <a:gdLst>
              <a:gd name="T0" fmla="*/ 116 w 309"/>
              <a:gd name="T1" fmla="*/ 135 h 220"/>
              <a:gd name="T2" fmla="*/ 104 w 309"/>
              <a:gd name="T3" fmla="*/ 122 h 220"/>
              <a:gd name="T4" fmla="*/ 95 w 309"/>
              <a:gd name="T5" fmla="*/ 108 h 220"/>
              <a:gd name="T6" fmla="*/ 90 w 309"/>
              <a:gd name="T7" fmla="*/ 94 h 220"/>
              <a:gd name="T8" fmla="*/ 88 w 309"/>
              <a:gd name="T9" fmla="*/ 79 h 220"/>
              <a:gd name="T10" fmla="*/ 91 w 309"/>
              <a:gd name="T11" fmla="*/ 58 h 220"/>
              <a:gd name="T12" fmla="*/ 101 w 309"/>
              <a:gd name="T13" fmla="*/ 40 h 220"/>
              <a:gd name="T14" fmla="*/ 116 w 309"/>
              <a:gd name="T15" fmla="*/ 22 h 220"/>
              <a:gd name="T16" fmla="*/ 137 w 309"/>
              <a:gd name="T17" fmla="*/ 10 h 220"/>
              <a:gd name="T18" fmla="*/ 162 w 309"/>
              <a:gd name="T19" fmla="*/ 3 h 220"/>
              <a:gd name="T20" fmla="*/ 190 w 309"/>
              <a:gd name="T21" fmla="*/ 0 h 220"/>
              <a:gd name="T22" fmla="*/ 223 w 309"/>
              <a:gd name="T23" fmla="*/ 3 h 220"/>
              <a:gd name="T24" fmla="*/ 252 w 309"/>
              <a:gd name="T25" fmla="*/ 13 h 220"/>
              <a:gd name="T26" fmla="*/ 276 w 309"/>
              <a:gd name="T27" fmla="*/ 29 h 220"/>
              <a:gd name="T28" fmla="*/ 295 w 309"/>
              <a:gd name="T29" fmla="*/ 49 h 220"/>
              <a:gd name="T30" fmla="*/ 306 w 309"/>
              <a:gd name="T31" fmla="*/ 72 h 220"/>
              <a:gd name="T32" fmla="*/ 309 w 309"/>
              <a:gd name="T33" fmla="*/ 99 h 220"/>
              <a:gd name="T34" fmla="*/ 308 w 309"/>
              <a:gd name="T35" fmla="*/ 115 h 220"/>
              <a:gd name="T36" fmla="*/ 304 w 309"/>
              <a:gd name="T37" fmla="*/ 129 h 220"/>
              <a:gd name="T38" fmla="*/ 297 w 309"/>
              <a:gd name="T39" fmla="*/ 142 h 220"/>
              <a:gd name="T40" fmla="*/ 286 w 309"/>
              <a:gd name="T41" fmla="*/ 154 h 220"/>
              <a:gd name="T42" fmla="*/ 309 w 309"/>
              <a:gd name="T43" fmla="*/ 195 h 220"/>
              <a:gd name="T44" fmla="*/ 29 w 309"/>
              <a:gd name="T45" fmla="*/ 195 h 220"/>
              <a:gd name="T46" fmla="*/ 16 w 309"/>
              <a:gd name="T47" fmla="*/ 199 h 220"/>
              <a:gd name="T48" fmla="*/ 9 w 309"/>
              <a:gd name="T49" fmla="*/ 209 h 220"/>
              <a:gd name="T50" fmla="*/ 0 w 309"/>
              <a:gd name="T51" fmla="*/ 220 h 220"/>
              <a:gd name="T52" fmla="*/ 135 w 309"/>
              <a:gd name="T53" fmla="*/ 135 h 220"/>
              <a:gd name="T54" fmla="*/ 241 w 309"/>
              <a:gd name="T55" fmla="*/ 135 h 220"/>
              <a:gd name="T56" fmla="*/ 259 w 309"/>
              <a:gd name="T57" fmla="*/ 134 h 220"/>
              <a:gd name="T58" fmla="*/ 270 w 309"/>
              <a:gd name="T59" fmla="*/ 132 h 220"/>
              <a:gd name="T60" fmla="*/ 281 w 309"/>
              <a:gd name="T61" fmla="*/ 127 h 220"/>
              <a:gd name="T62" fmla="*/ 289 w 309"/>
              <a:gd name="T63" fmla="*/ 118 h 220"/>
              <a:gd name="T64" fmla="*/ 294 w 309"/>
              <a:gd name="T65" fmla="*/ 108 h 220"/>
              <a:gd name="T66" fmla="*/ 294 w 309"/>
              <a:gd name="T67" fmla="*/ 97 h 220"/>
              <a:gd name="T68" fmla="*/ 291 w 309"/>
              <a:gd name="T69" fmla="*/ 87 h 220"/>
              <a:gd name="T70" fmla="*/ 283 w 309"/>
              <a:gd name="T71" fmla="*/ 80 h 220"/>
              <a:gd name="T72" fmla="*/ 270 w 309"/>
              <a:gd name="T73" fmla="*/ 72 h 220"/>
              <a:gd name="T74" fmla="*/ 250 w 309"/>
              <a:gd name="T75" fmla="*/ 67 h 220"/>
              <a:gd name="T76" fmla="*/ 216 w 309"/>
              <a:gd name="T77" fmla="*/ 65 h 220"/>
              <a:gd name="T78" fmla="*/ 171 w 309"/>
              <a:gd name="T79" fmla="*/ 65 h 220"/>
              <a:gd name="T80" fmla="*/ 144 w 309"/>
              <a:gd name="T81" fmla="*/ 69 h 220"/>
              <a:gd name="T82" fmla="*/ 132 w 309"/>
              <a:gd name="T83" fmla="*/ 73 h 220"/>
              <a:gd name="T84" fmla="*/ 121 w 309"/>
              <a:gd name="T85" fmla="*/ 81 h 220"/>
              <a:gd name="T86" fmla="*/ 115 w 309"/>
              <a:gd name="T87" fmla="*/ 92 h 220"/>
              <a:gd name="T88" fmla="*/ 115 w 309"/>
              <a:gd name="T89" fmla="*/ 104 h 220"/>
              <a:gd name="T90" fmla="*/ 117 w 309"/>
              <a:gd name="T91" fmla="*/ 113 h 220"/>
              <a:gd name="T92" fmla="*/ 123 w 309"/>
              <a:gd name="T93" fmla="*/ 122 h 220"/>
              <a:gd name="T94" fmla="*/ 130 w 309"/>
              <a:gd name="T95" fmla="*/ 131 h 2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309" h="220">
                <a:moveTo>
                  <a:pt x="0" y="135"/>
                </a:moveTo>
                <a:lnTo>
                  <a:pt x="116" y="135"/>
                </a:lnTo>
                <a:lnTo>
                  <a:pt x="110" y="129"/>
                </a:lnTo>
                <a:lnTo>
                  <a:pt x="104" y="122"/>
                </a:lnTo>
                <a:lnTo>
                  <a:pt x="99" y="115"/>
                </a:lnTo>
                <a:lnTo>
                  <a:pt x="95" y="108"/>
                </a:lnTo>
                <a:lnTo>
                  <a:pt x="92" y="101"/>
                </a:lnTo>
                <a:lnTo>
                  <a:pt x="90" y="94"/>
                </a:lnTo>
                <a:lnTo>
                  <a:pt x="89" y="86"/>
                </a:lnTo>
                <a:lnTo>
                  <a:pt x="88" y="79"/>
                </a:lnTo>
                <a:lnTo>
                  <a:pt x="89" y="68"/>
                </a:lnTo>
                <a:lnTo>
                  <a:pt x="91" y="58"/>
                </a:lnTo>
                <a:lnTo>
                  <a:pt x="95" y="49"/>
                </a:lnTo>
                <a:lnTo>
                  <a:pt x="101" y="40"/>
                </a:lnTo>
                <a:lnTo>
                  <a:pt x="108" y="31"/>
                </a:lnTo>
                <a:lnTo>
                  <a:pt x="116" y="22"/>
                </a:lnTo>
                <a:lnTo>
                  <a:pt x="126" y="16"/>
                </a:lnTo>
                <a:lnTo>
                  <a:pt x="137" y="10"/>
                </a:lnTo>
                <a:lnTo>
                  <a:pt x="148" y="6"/>
                </a:lnTo>
                <a:lnTo>
                  <a:pt x="162" y="3"/>
                </a:lnTo>
                <a:lnTo>
                  <a:pt x="175" y="1"/>
                </a:lnTo>
                <a:lnTo>
                  <a:pt x="190" y="0"/>
                </a:lnTo>
                <a:lnTo>
                  <a:pt x="207" y="1"/>
                </a:lnTo>
                <a:lnTo>
                  <a:pt x="223" y="3"/>
                </a:lnTo>
                <a:lnTo>
                  <a:pt x="237" y="7"/>
                </a:lnTo>
                <a:lnTo>
                  <a:pt x="252" y="13"/>
                </a:lnTo>
                <a:lnTo>
                  <a:pt x="265" y="20"/>
                </a:lnTo>
                <a:lnTo>
                  <a:pt x="276" y="29"/>
                </a:lnTo>
                <a:lnTo>
                  <a:pt x="286" y="38"/>
                </a:lnTo>
                <a:lnTo>
                  <a:pt x="295" y="49"/>
                </a:lnTo>
                <a:lnTo>
                  <a:pt x="301" y="60"/>
                </a:lnTo>
                <a:lnTo>
                  <a:pt x="306" y="72"/>
                </a:lnTo>
                <a:lnTo>
                  <a:pt x="308" y="86"/>
                </a:lnTo>
                <a:lnTo>
                  <a:pt x="309" y="99"/>
                </a:lnTo>
                <a:lnTo>
                  <a:pt x="309" y="107"/>
                </a:lnTo>
                <a:lnTo>
                  <a:pt x="308" y="115"/>
                </a:lnTo>
                <a:lnTo>
                  <a:pt x="306" y="123"/>
                </a:lnTo>
                <a:lnTo>
                  <a:pt x="304" y="129"/>
                </a:lnTo>
                <a:lnTo>
                  <a:pt x="301" y="135"/>
                </a:lnTo>
                <a:lnTo>
                  <a:pt x="297" y="142"/>
                </a:lnTo>
                <a:lnTo>
                  <a:pt x="293" y="148"/>
                </a:lnTo>
                <a:lnTo>
                  <a:pt x="286" y="154"/>
                </a:lnTo>
                <a:lnTo>
                  <a:pt x="309" y="188"/>
                </a:lnTo>
                <a:lnTo>
                  <a:pt x="309" y="195"/>
                </a:lnTo>
                <a:lnTo>
                  <a:pt x="43" y="195"/>
                </a:lnTo>
                <a:lnTo>
                  <a:pt x="29" y="195"/>
                </a:lnTo>
                <a:lnTo>
                  <a:pt x="21" y="196"/>
                </a:lnTo>
                <a:lnTo>
                  <a:pt x="16" y="199"/>
                </a:lnTo>
                <a:lnTo>
                  <a:pt x="12" y="203"/>
                </a:lnTo>
                <a:lnTo>
                  <a:pt x="9" y="209"/>
                </a:lnTo>
                <a:lnTo>
                  <a:pt x="7" y="220"/>
                </a:lnTo>
                <a:lnTo>
                  <a:pt x="0" y="220"/>
                </a:lnTo>
                <a:lnTo>
                  <a:pt x="0" y="135"/>
                </a:lnTo>
                <a:close/>
                <a:moveTo>
                  <a:pt x="135" y="135"/>
                </a:moveTo>
                <a:lnTo>
                  <a:pt x="228" y="135"/>
                </a:lnTo>
                <a:lnTo>
                  <a:pt x="241" y="135"/>
                </a:lnTo>
                <a:lnTo>
                  <a:pt x="252" y="135"/>
                </a:lnTo>
                <a:lnTo>
                  <a:pt x="259" y="134"/>
                </a:lnTo>
                <a:lnTo>
                  <a:pt x="264" y="134"/>
                </a:lnTo>
                <a:lnTo>
                  <a:pt x="270" y="132"/>
                </a:lnTo>
                <a:lnTo>
                  <a:pt x="276" y="130"/>
                </a:lnTo>
                <a:lnTo>
                  <a:pt x="281" y="127"/>
                </a:lnTo>
                <a:lnTo>
                  <a:pt x="285" y="124"/>
                </a:lnTo>
                <a:lnTo>
                  <a:pt x="289" y="118"/>
                </a:lnTo>
                <a:lnTo>
                  <a:pt x="292" y="113"/>
                </a:lnTo>
                <a:lnTo>
                  <a:pt x="294" y="108"/>
                </a:lnTo>
                <a:lnTo>
                  <a:pt x="294" y="102"/>
                </a:lnTo>
                <a:lnTo>
                  <a:pt x="294" y="97"/>
                </a:lnTo>
                <a:lnTo>
                  <a:pt x="293" y="92"/>
                </a:lnTo>
                <a:lnTo>
                  <a:pt x="291" y="87"/>
                </a:lnTo>
                <a:lnTo>
                  <a:pt x="287" y="83"/>
                </a:lnTo>
                <a:lnTo>
                  <a:pt x="283" y="80"/>
                </a:lnTo>
                <a:lnTo>
                  <a:pt x="277" y="76"/>
                </a:lnTo>
                <a:lnTo>
                  <a:pt x="270" y="72"/>
                </a:lnTo>
                <a:lnTo>
                  <a:pt x="262" y="69"/>
                </a:lnTo>
                <a:lnTo>
                  <a:pt x="250" y="67"/>
                </a:lnTo>
                <a:lnTo>
                  <a:pt x="234" y="66"/>
                </a:lnTo>
                <a:lnTo>
                  <a:pt x="216" y="65"/>
                </a:lnTo>
                <a:lnTo>
                  <a:pt x="192" y="64"/>
                </a:lnTo>
                <a:lnTo>
                  <a:pt x="171" y="65"/>
                </a:lnTo>
                <a:lnTo>
                  <a:pt x="153" y="67"/>
                </a:lnTo>
                <a:lnTo>
                  <a:pt x="144" y="69"/>
                </a:lnTo>
                <a:lnTo>
                  <a:pt x="137" y="71"/>
                </a:lnTo>
                <a:lnTo>
                  <a:pt x="132" y="73"/>
                </a:lnTo>
                <a:lnTo>
                  <a:pt x="127" y="77"/>
                </a:lnTo>
                <a:lnTo>
                  <a:pt x="121" y="81"/>
                </a:lnTo>
                <a:lnTo>
                  <a:pt x="117" y="86"/>
                </a:lnTo>
                <a:lnTo>
                  <a:pt x="115" y="92"/>
                </a:lnTo>
                <a:lnTo>
                  <a:pt x="114" y="99"/>
                </a:lnTo>
                <a:lnTo>
                  <a:pt x="115" y="104"/>
                </a:lnTo>
                <a:lnTo>
                  <a:pt x="116" y="108"/>
                </a:lnTo>
                <a:lnTo>
                  <a:pt x="117" y="113"/>
                </a:lnTo>
                <a:lnTo>
                  <a:pt x="120" y="117"/>
                </a:lnTo>
                <a:lnTo>
                  <a:pt x="123" y="122"/>
                </a:lnTo>
                <a:lnTo>
                  <a:pt x="126" y="127"/>
                </a:lnTo>
                <a:lnTo>
                  <a:pt x="130" y="131"/>
                </a:lnTo>
                <a:lnTo>
                  <a:pt x="135" y="135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9" name="Freeform 103"/>
          <p:cNvSpPr>
            <a:spLocks noEditPoints="1"/>
          </p:cNvSpPr>
          <p:nvPr/>
        </p:nvSpPr>
        <p:spPr bwMode="auto">
          <a:xfrm>
            <a:off x="521485" y="1805294"/>
            <a:ext cx="122238" cy="44450"/>
          </a:xfrm>
          <a:custGeom>
            <a:avLst/>
            <a:gdLst>
              <a:gd name="T0" fmla="*/ 1 w 310"/>
              <a:gd name="T1" fmla="*/ 49 h 112"/>
              <a:gd name="T2" fmla="*/ 6 w 310"/>
              <a:gd name="T3" fmla="*/ 37 h 112"/>
              <a:gd name="T4" fmla="*/ 15 w 310"/>
              <a:gd name="T5" fmla="*/ 28 h 112"/>
              <a:gd name="T6" fmla="*/ 28 w 310"/>
              <a:gd name="T7" fmla="*/ 23 h 112"/>
              <a:gd name="T8" fmla="*/ 42 w 310"/>
              <a:gd name="T9" fmla="*/ 23 h 112"/>
              <a:gd name="T10" fmla="*/ 54 w 310"/>
              <a:gd name="T11" fmla="*/ 28 h 112"/>
              <a:gd name="T12" fmla="*/ 64 w 310"/>
              <a:gd name="T13" fmla="*/ 38 h 112"/>
              <a:gd name="T14" fmla="*/ 69 w 310"/>
              <a:gd name="T15" fmla="*/ 49 h 112"/>
              <a:gd name="T16" fmla="*/ 69 w 310"/>
              <a:gd name="T17" fmla="*/ 63 h 112"/>
              <a:gd name="T18" fmla="*/ 64 w 310"/>
              <a:gd name="T19" fmla="*/ 75 h 112"/>
              <a:gd name="T20" fmla="*/ 54 w 310"/>
              <a:gd name="T21" fmla="*/ 84 h 112"/>
              <a:gd name="T22" fmla="*/ 42 w 310"/>
              <a:gd name="T23" fmla="*/ 89 h 112"/>
              <a:gd name="T24" fmla="*/ 28 w 310"/>
              <a:gd name="T25" fmla="*/ 89 h 112"/>
              <a:gd name="T26" fmla="*/ 15 w 310"/>
              <a:gd name="T27" fmla="*/ 84 h 112"/>
              <a:gd name="T28" fmla="*/ 6 w 310"/>
              <a:gd name="T29" fmla="*/ 75 h 112"/>
              <a:gd name="T30" fmla="*/ 1 w 310"/>
              <a:gd name="T31" fmla="*/ 63 h 112"/>
              <a:gd name="T32" fmla="*/ 101 w 310"/>
              <a:gd name="T33" fmla="*/ 26 h 112"/>
              <a:gd name="T34" fmla="*/ 277 w 310"/>
              <a:gd name="T35" fmla="*/ 26 h 112"/>
              <a:gd name="T36" fmla="*/ 291 w 310"/>
              <a:gd name="T37" fmla="*/ 23 h 112"/>
              <a:gd name="T38" fmla="*/ 299 w 310"/>
              <a:gd name="T39" fmla="*/ 18 h 112"/>
              <a:gd name="T40" fmla="*/ 302 w 310"/>
              <a:gd name="T41" fmla="*/ 8 h 112"/>
              <a:gd name="T42" fmla="*/ 310 w 310"/>
              <a:gd name="T43" fmla="*/ 0 h 112"/>
              <a:gd name="T44" fmla="*/ 303 w 310"/>
              <a:gd name="T45" fmla="*/ 112 h 112"/>
              <a:gd name="T46" fmla="*/ 301 w 310"/>
              <a:gd name="T47" fmla="*/ 100 h 112"/>
              <a:gd name="T48" fmla="*/ 294 w 310"/>
              <a:gd name="T49" fmla="*/ 91 h 112"/>
              <a:gd name="T50" fmla="*/ 285 w 310"/>
              <a:gd name="T51" fmla="*/ 88 h 112"/>
              <a:gd name="T52" fmla="*/ 267 w 310"/>
              <a:gd name="T53" fmla="*/ 87 h 112"/>
              <a:gd name="T54" fmla="*/ 135 w 310"/>
              <a:gd name="T55" fmla="*/ 87 h 112"/>
              <a:gd name="T56" fmla="*/ 121 w 310"/>
              <a:gd name="T57" fmla="*/ 89 h 112"/>
              <a:gd name="T58" fmla="*/ 114 w 310"/>
              <a:gd name="T59" fmla="*/ 95 h 112"/>
              <a:gd name="T60" fmla="*/ 109 w 310"/>
              <a:gd name="T61" fmla="*/ 105 h 112"/>
              <a:gd name="T62" fmla="*/ 101 w 310"/>
              <a:gd name="T63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10" h="112">
                <a:moveTo>
                  <a:pt x="0" y="57"/>
                </a:moveTo>
                <a:lnTo>
                  <a:pt x="1" y="49"/>
                </a:lnTo>
                <a:lnTo>
                  <a:pt x="3" y="43"/>
                </a:lnTo>
                <a:lnTo>
                  <a:pt x="6" y="37"/>
                </a:lnTo>
                <a:lnTo>
                  <a:pt x="10" y="32"/>
                </a:lnTo>
                <a:lnTo>
                  <a:pt x="15" y="28"/>
                </a:lnTo>
                <a:lnTo>
                  <a:pt x="22" y="25"/>
                </a:lnTo>
                <a:lnTo>
                  <a:pt x="28" y="23"/>
                </a:lnTo>
                <a:lnTo>
                  <a:pt x="35" y="23"/>
                </a:lnTo>
                <a:lnTo>
                  <a:pt x="42" y="23"/>
                </a:lnTo>
                <a:lnTo>
                  <a:pt x="48" y="25"/>
                </a:lnTo>
                <a:lnTo>
                  <a:pt x="54" y="28"/>
                </a:lnTo>
                <a:lnTo>
                  <a:pt x="59" y="32"/>
                </a:lnTo>
                <a:lnTo>
                  <a:pt x="64" y="38"/>
                </a:lnTo>
                <a:lnTo>
                  <a:pt x="67" y="43"/>
                </a:lnTo>
                <a:lnTo>
                  <a:pt x="69" y="49"/>
                </a:lnTo>
                <a:lnTo>
                  <a:pt x="70" y="57"/>
                </a:lnTo>
                <a:lnTo>
                  <a:pt x="69" y="63"/>
                </a:lnTo>
                <a:lnTo>
                  <a:pt x="67" y="69"/>
                </a:lnTo>
                <a:lnTo>
                  <a:pt x="64" y="75"/>
                </a:lnTo>
                <a:lnTo>
                  <a:pt x="59" y="80"/>
                </a:lnTo>
                <a:lnTo>
                  <a:pt x="54" y="84"/>
                </a:lnTo>
                <a:lnTo>
                  <a:pt x="48" y="87"/>
                </a:lnTo>
                <a:lnTo>
                  <a:pt x="42" y="89"/>
                </a:lnTo>
                <a:lnTo>
                  <a:pt x="35" y="90"/>
                </a:lnTo>
                <a:lnTo>
                  <a:pt x="28" y="89"/>
                </a:lnTo>
                <a:lnTo>
                  <a:pt x="22" y="87"/>
                </a:lnTo>
                <a:lnTo>
                  <a:pt x="15" y="84"/>
                </a:lnTo>
                <a:lnTo>
                  <a:pt x="10" y="80"/>
                </a:lnTo>
                <a:lnTo>
                  <a:pt x="6" y="75"/>
                </a:lnTo>
                <a:lnTo>
                  <a:pt x="3" y="69"/>
                </a:lnTo>
                <a:lnTo>
                  <a:pt x="1" y="63"/>
                </a:lnTo>
                <a:lnTo>
                  <a:pt x="0" y="57"/>
                </a:lnTo>
                <a:close/>
                <a:moveTo>
                  <a:pt x="101" y="26"/>
                </a:moveTo>
                <a:lnTo>
                  <a:pt x="267" y="26"/>
                </a:lnTo>
                <a:lnTo>
                  <a:pt x="277" y="26"/>
                </a:lnTo>
                <a:lnTo>
                  <a:pt x="285" y="25"/>
                </a:lnTo>
                <a:lnTo>
                  <a:pt x="291" y="23"/>
                </a:lnTo>
                <a:lnTo>
                  <a:pt x="295" y="21"/>
                </a:lnTo>
                <a:lnTo>
                  <a:pt x="299" y="18"/>
                </a:lnTo>
                <a:lnTo>
                  <a:pt x="301" y="14"/>
                </a:lnTo>
                <a:lnTo>
                  <a:pt x="302" y="8"/>
                </a:lnTo>
                <a:lnTo>
                  <a:pt x="303" y="0"/>
                </a:lnTo>
                <a:lnTo>
                  <a:pt x="310" y="0"/>
                </a:lnTo>
                <a:lnTo>
                  <a:pt x="310" y="112"/>
                </a:lnTo>
                <a:lnTo>
                  <a:pt x="303" y="112"/>
                </a:lnTo>
                <a:lnTo>
                  <a:pt x="302" y="106"/>
                </a:lnTo>
                <a:lnTo>
                  <a:pt x="301" y="100"/>
                </a:lnTo>
                <a:lnTo>
                  <a:pt x="298" y="95"/>
                </a:lnTo>
                <a:lnTo>
                  <a:pt x="294" y="91"/>
                </a:lnTo>
                <a:lnTo>
                  <a:pt x="290" y="89"/>
                </a:lnTo>
                <a:lnTo>
                  <a:pt x="285" y="88"/>
                </a:lnTo>
                <a:lnTo>
                  <a:pt x="277" y="87"/>
                </a:lnTo>
                <a:lnTo>
                  <a:pt x="267" y="87"/>
                </a:lnTo>
                <a:lnTo>
                  <a:pt x="145" y="87"/>
                </a:lnTo>
                <a:lnTo>
                  <a:pt x="135" y="87"/>
                </a:lnTo>
                <a:lnTo>
                  <a:pt x="127" y="88"/>
                </a:lnTo>
                <a:lnTo>
                  <a:pt x="121" y="89"/>
                </a:lnTo>
                <a:lnTo>
                  <a:pt x="117" y="92"/>
                </a:lnTo>
                <a:lnTo>
                  <a:pt x="114" y="95"/>
                </a:lnTo>
                <a:lnTo>
                  <a:pt x="112" y="100"/>
                </a:lnTo>
                <a:lnTo>
                  <a:pt x="109" y="105"/>
                </a:lnTo>
                <a:lnTo>
                  <a:pt x="109" y="112"/>
                </a:lnTo>
                <a:lnTo>
                  <a:pt x="101" y="112"/>
                </a:lnTo>
                <a:lnTo>
                  <a:pt x="101" y="26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0" name="Freeform 104"/>
          <p:cNvSpPr>
            <a:spLocks/>
          </p:cNvSpPr>
          <p:nvPr/>
        </p:nvSpPr>
        <p:spPr bwMode="auto">
          <a:xfrm>
            <a:off x="524660" y="1746556"/>
            <a:ext cx="119063" cy="44450"/>
          </a:xfrm>
          <a:custGeom>
            <a:avLst/>
            <a:gdLst>
              <a:gd name="T0" fmla="*/ 0 w 303"/>
              <a:gd name="T1" fmla="*/ 25 h 112"/>
              <a:gd name="T2" fmla="*/ 260 w 303"/>
              <a:gd name="T3" fmla="*/ 25 h 112"/>
              <a:gd name="T4" fmla="*/ 270 w 303"/>
              <a:gd name="T5" fmla="*/ 25 h 112"/>
              <a:gd name="T6" fmla="*/ 278 w 303"/>
              <a:gd name="T7" fmla="*/ 24 h 112"/>
              <a:gd name="T8" fmla="*/ 284 w 303"/>
              <a:gd name="T9" fmla="*/ 23 h 112"/>
              <a:gd name="T10" fmla="*/ 288 w 303"/>
              <a:gd name="T11" fmla="*/ 20 h 112"/>
              <a:gd name="T12" fmla="*/ 292 w 303"/>
              <a:gd name="T13" fmla="*/ 17 h 112"/>
              <a:gd name="T14" fmla="*/ 294 w 303"/>
              <a:gd name="T15" fmla="*/ 13 h 112"/>
              <a:gd name="T16" fmla="*/ 295 w 303"/>
              <a:gd name="T17" fmla="*/ 7 h 112"/>
              <a:gd name="T18" fmla="*/ 296 w 303"/>
              <a:gd name="T19" fmla="*/ 0 h 112"/>
              <a:gd name="T20" fmla="*/ 303 w 303"/>
              <a:gd name="T21" fmla="*/ 0 h 112"/>
              <a:gd name="T22" fmla="*/ 303 w 303"/>
              <a:gd name="T23" fmla="*/ 112 h 112"/>
              <a:gd name="T24" fmla="*/ 296 w 303"/>
              <a:gd name="T25" fmla="*/ 112 h 112"/>
              <a:gd name="T26" fmla="*/ 295 w 303"/>
              <a:gd name="T27" fmla="*/ 105 h 112"/>
              <a:gd name="T28" fmla="*/ 294 w 303"/>
              <a:gd name="T29" fmla="*/ 99 h 112"/>
              <a:gd name="T30" fmla="*/ 291 w 303"/>
              <a:gd name="T31" fmla="*/ 94 h 112"/>
              <a:gd name="T32" fmla="*/ 287 w 303"/>
              <a:gd name="T33" fmla="*/ 91 h 112"/>
              <a:gd name="T34" fmla="*/ 283 w 303"/>
              <a:gd name="T35" fmla="*/ 89 h 112"/>
              <a:gd name="T36" fmla="*/ 278 w 303"/>
              <a:gd name="T37" fmla="*/ 87 h 112"/>
              <a:gd name="T38" fmla="*/ 270 w 303"/>
              <a:gd name="T39" fmla="*/ 86 h 112"/>
              <a:gd name="T40" fmla="*/ 260 w 303"/>
              <a:gd name="T41" fmla="*/ 86 h 112"/>
              <a:gd name="T42" fmla="*/ 43 w 303"/>
              <a:gd name="T43" fmla="*/ 86 h 112"/>
              <a:gd name="T44" fmla="*/ 33 w 303"/>
              <a:gd name="T45" fmla="*/ 86 h 112"/>
              <a:gd name="T46" fmla="*/ 26 w 303"/>
              <a:gd name="T47" fmla="*/ 87 h 112"/>
              <a:gd name="T48" fmla="*/ 20 w 303"/>
              <a:gd name="T49" fmla="*/ 89 h 112"/>
              <a:gd name="T50" fmla="*/ 16 w 303"/>
              <a:gd name="T51" fmla="*/ 91 h 112"/>
              <a:gd name="T52" fmla="*/ 13 w 303"/>
              <a:gd name="T53" fmla="*/ 94 h 112"/>
              <a:gd name="T54" fmla="*/ 11 w 303"/>
              <a:gd name="T55" fmla="*/ 99 h 112"/>
              <a:gd name="T56" fmla="*/ 8 w 303"/>
              <a:gd name="T57" fmla="*/ 105 h 112"/>
              <a:gd name="T58" fmla="*/ 7 w 303"/>
              <a:gd name="T59" fmla="*/ 112 h 112"/>
              <a:gd name="T60" fmla="*/ 0 w 303"/>
              <a:gd name="T61" fmla="*/ 112 h 112"/>
              <a:gd name="T62" fmla="*/ 0 w 303"/>
              <a:gd name="T63" fmla="*/ 25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03" h="112">
                <a:moveTo>
                  <a:pt x="0" y="25"/>
                </a:moveTo>
                <a:lnTo>
                  <a:pt x="260" y="25"/>
                </a:lnTo>
                <a:lnTo>
                  <a:pt x="270" y="25"/>
                </a:lnTo>
                <a:lnTo>
                  <a:pt x="278" y="24"/>
                </a:lnTo>
                <a:lnTo>
                  <a:pt x="284" y="23"/>
                </a:lnTo>
                <a:lnTo>
                  <a:pt x="288" y="20"/>
                </a:lnTo>
                <a:lnTo>
                  <a:pt x="292" y="17"/>
                </a:lnTo>
                <a:lnTo>
                  <a:pt x="294" y="13"/>
                </a:lnTo>
                <a:lnTo>
                  <a:pt x="295" y="7"/>
                </a:lnTo>
                <a:lnTo>
                  <a:pt x="296" y="0"/>
                </a:lnTo>
                <a:lnTo>
                  <a:pt x="303" y="0"/>
                </a:lnTo>
                <a:lnTo>
                  <a:pt x="303" y="112"/>
                </a:lnTo>
                <a:lnTo>
                  <a:pt x="296" y="112"/>
                </a:lnTo>
                <a:lnTo>
                  <a:pt x="295" y="105"/>
                </a:lnTo>
                <a:lnTo>
                  <a:pt x="294" y="99"/>
                </a:lnTo>
                <a:lnTo>
                  <a:pt x="291" y="94"/>
                </a:lnTo>
                <a:lnTo>
                  <a:pt x="287" y="91"/>
                </a:lnTo>
                <a:lnTo>
                  <a:pt x="283" y="89"/>
                </a:lnTo>
                <a:lnTo>
                  <a:pt x="278" y="87"/>
                </a:lnTo>
                <a:lnTo>
                  <a:pt x="270" y="86"/>
                </a:lnTo>
                <a:lnTo>
                  <a:pt x="260" y="86"/>
                </a:lnTo>
                <a:lnTo>
                  <a:pt x="43" y="86"/>
                </a:lnTo>
                <a:lnTo>
                  <a:pt x="33" y="86"/>
                </a:lnTo>
                <a:lnTo>
                  <a:pt x="26" y="87"/>
                </a:lnTo>
                <a:lnTo>
                  <a:pt x="20" y="89"/>
                </a:lnTo>
                <a:lnTo>
                  <a:pt x="16" y="91"/>
                </a:lnTo>
                <a:lnTo>
                  <a:pt x="13" y="94"/>
                </a:lnTo>
                <a:lnTo>
                  <a:pt x="11" y="99"/>
                </a:lnTo>
                <a:lnTo>
                  <a:pt x="8" y="105"/>
                </a:lnTo>
                <a:lnTo>
                  <a:pt x="7" y="112"/>
                </a:lnTo>
                <a:lnTo>
                  <a:pt x="0" y="112"/>
                </a:lnTo>
                <a:lnTo>
                  <a:pt x="0" y="25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1" name="Freeform 105"/>
          <p:cNvSpPr>
            <a:spLocks noEditPoints="1"/>
          </p:cNvSpPr>
          <p:nvPr/>
        </p:nvSpPr>
        <p:spPr bwMode="auto">
          <a:xfrm>
            <a:off x="521485" y="1689406"/>
            <a:ext cx="122238" cy="44450"/>
          </a:xfrm>
          <a:custGeom>
            <a:avLst/>
            <a:gdLst>
              <a:gd name="T0" fmla="*/ 1 w 310"/>
              <a:gd name="T1" fmla="*/ 49 h 112"/>
              <a:gd name="T2" fmla="*/ 6 w 310"/>
              <a:gd name="T3" fmla="*/ 37 h 112"/>
              <a:gd name="T4" fmla="*/ 15 w 310"/>
              <a:gd name="T5" fmla="*/ 28 h 112"/>
              <a:gd name="T6" fmla="*/ 28 w 310"/>
              <a:gd name="T7" fmla="*/ 23 h 112"/>
              <a:gd name="T8" fmla="*/ 42 w 310"/>
              <a:gd name="T9" fmla="*/ 23 h 112"/>
              <a:gd name="T10" fmla="*/ 54 w 310"/>
              <a:gd name="T11" fmla="*/ 28 h 112"/>
              <a:gd name="T12" fmla="*/ 64 w 310"/>
              <a:gd name="T13" fmla="*/ 38 h 112"/>
              <a:gd name="T14" fmla="*/ 69 w 310"/>
              <a:gd name="T15" fmla="*/ 49 h 112"/>
              <a:gd name="T16" fmla="*/ 69 w 310"/>
              <a:gd name="T17" fmla="*/ 62 h 112"/>
              <a:gd name="T18" fmla="*/ 64 w 310"/>
              <a:gd name="T19" fmla="*/ 75 h 112"/>
              <a:gd name="T20" fmla="*/ 54 w 310"/>
              <a:gd name="T21" fmla="*/ 84 h 112"/>
              <a:gd name="T22" fmla="*/ 42 w 310"/>
              <a:gd name="T23" fmla="*/ 89 h 112"/>
              <a:gd name="T24" fmla="*/ 28 w 310"/>
              <a:gd name="T25" fmla="*/ 89 h 112"/>
              <a:gd name="T26" fmla="*/ 15 w 310"/>
              <a:gd name="T27" fmla="*/ 84 h 112"/>
              <a:gd name="T28" fmla="*/ 6 w 310"/>
              <a:gd name="T29" fmla="*/ 75 h 112"/>
              <a:gd name="T30" fmla="*/ 1 w 310"/>
              <a:gd name="T31" fmla="*/ 62 h 112"/>
              <a:gd name="T32" fmla="*/ 101 w 310"/>
              <a:gd name="T33" fmla="*/ 26 h 112"/>
              <a:gd name="T34" fmla="*/ 277 w 310"/>
              <a:gd name="T35" fmla="*/ 25 h 112"/>
              <a:gd name="T36" fmla="*/ 291 w 310"/>
              <a:gd name="T37" fmla="*/ 23 h 112"/>
              <a:gd name="T38" fmla="*/ 299 w 310"/>
              <a:gd name="T39" fmla="*/ 17 h 112"/>
              <a:gd name="T40" fmla="*/ 302 w 310"/>
              <a:gd name="T41" fmla="*/ 7 h 112"/>
              <a:gd name="T42" fmla="*/ 310 w 310"/>
              <a:gd name="T43" fmla="*/ 0 h 112"/>
              <a:gd name="T44" fmla="*/ 303 w 310"/>
              <a:gd name="T45" fmla="*/ 112 h 112"/>
              <a:gd name="T46" fmla="*/ 301 w 310"/>
              <a:gd name="T47" fmla="*/ 99 h 112"/>
              <a:gd name="T48" fmla="*/ 294 w 310"/>
              <a:gd name="T49" fmla="*/ 91 h 112"/>
              <a:gd name="T50" fmla="*/ 285 w 310"/>
              <a:gd name="T51" fmla="*/ 88 h 112"/>
              <a:gd name="T52" fmla="*/ 267 w 310"/>
              <a:gd name="T53" fmla="*/ 87 h 112"/>
              <a:gd name="T54" fmla="*/ 135 w 310"/>
              <a:gd name="T55" fmla="*/ 87 h 112"/>
              <a:gd name="T56" fmla="*/ 121 w 310"/>
              <a:gd name="T57" fmla="*/ 89 h 112"/>
              <a:gd name="T58" fmla="*/ 114 w 310"/>
              <a:gd name="T59" fmla="*/ 95 h 112"/>
              <a:gd name="T60" fmla="*/ 109 w 310"/>
              <a:gd name="T61" fmla="*/ 104 h 112"/>
              <a:gd name="T62" fmla="*/ 101 w 310"/>
              <a:gd name="T63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10" h="112">
                <a:moveTo>
                  <a:pt x="0" y="56"/>
                </a:moveTo>
                <a:lnTo>
                  <a:pt x="1" y="49"/>
                </a:lnTo>
                <a:lnTo>
                  <a:pt x="3" y="43"/>
                </a:lnTo>
                <a:lnTo>
                  <a:pt x="6" y="37"/>
                </a:lnTo>
                <a:lnTo>
                  <a:pt x="10" y="32"/>
                </a:lnTo>
                <a:lnTo>
                  <a:pt x="15" y="28"/>
                </a:lnTo>
                <a:lnTo>
                  <a:pt x="22" y="25"/>
                </a:lnTo>
                <a:lnTo>
                  <a:pt x="28" y="23"/>
                </a:lnTo>
                <a:lnTo>
                  <a:pt x="35" y="23"/>
                </a:lnTo>
                <a:lnTo>
                  <a:pt x="42" y="23"/>
                </a:lnTo>
                <a:lnTo>
                  <a:pt x="48" y="25"/>
                </a:lnTo>
                <a:lnTo>
                  <a:pt x="54" y="28"/>
                </a:lnTo>
                <a:lnTo>
                  <a:pt x="59" y="32"/>
                </a:lnTo>
                <a:lnTo>
                  <a:pt x="64" y="38"/>
                </a:lnTo>
                <a:lnTo>
                  <a:pt x="67" y="43"/>
                </a:lnTo>
                <a:lnTo>
                  <a:pt x="69" y="49"/>
                </a:lnTo>
                <a:lnTo>
                  <a:pt x="70" y="56"/>
                </a:lnTo>
                <a:lnTo>
                  <a:pt x="69" y="62"/>
                </a:lnTo>
                <a:lnTo>
                  <a:pt x="67" y="69"/>
                </a:lnTo>
                <a:lnTo>
                  <a:pt x="64" y="75"/>
                </a:lnTo>
                <a:lnTo>
                  <a:pt x="59" y="80"/>
                </a:lnTo>
                <a:lnTo>
                  <a:pt x="54" y="84"/>
                </a:lnTo>
                <a:lnTo>
                  <a:pt x="48" y="87"/>
                </a:lnTo>
                <a:lnTo>
                  <a:pt x="42" y="89"/>
                </a:lnTo>
                <a:lnTo>
                  <a:pt x="35" y="90"/>
                </a:lnTo>
                <a:lnTo>
                  <a:pt x="28" y="89"/>
                </a:lnTo>
                <a:lnTo>
                  <a:pt x="22" y="87"/>
                </a:lnTo>
                <a:lnTo>
                  <a:pt x="15" y="84"/>
                </a:lnTo>
                <a:lnTo>
                  <a:pt x="10" y="80"/>
                </a:lnTo>
                <a:lnTo>
                  <a:pt x="6" y="75"/>
                </a:lnTo>
                <a:lnTo>
                  <a:pt x="3" y="69"/>
                </a:lnTo>
                <a:lnTo>
                  <a:pt x="1" y="62"/>
                </a:lnTo>
                <a:lnTo>
                  <a:pt x="0" y="56"/>
                </a:lnTo>
                <a:close/>
                <a:moveTo>
                  <a:pt x="101" y="26"/>
                </a:moveTo>
                <a:lnTo>
                  <a:pt x="267" y="26"/>
                </a:lnTo>
                <a:lnTo>
                  <a:pt x="277" y="25"/>
                </a:lnTo>
                <a:lnTo>
                  <a:pt x="285" y="25"/>
                </a:lnTo>
                <a:lnTo>
                  <a:pt x="291" y="23"/>
                </a:lnTo>
                <a:lnTo>
                  <a:pt x="295" y="21"/>
                </a:lnTo>
                <a:lnTo>
                  <a:pt x="299" y="17"/>
                </a:lnTo>
                <a:lnTo>
                  <a:pt x="301" y="12"/>
                </a:lnTo>
                <a:lnTo>
                  <a:pt x="302" y="7"/>
                </a:lnTo>
                <a:lnTo>
                  <a:pt x="303" y="0"/>
                </a:lnTo>
                <a:lnTo>
                  <a:pt x="310" y="0"/>
                </a:lnTo>
                <a:lnTo>
                  <a:pt x="310" y="112"/>
                </a:lnTo>
                <a:lnTo>
                  <a:pt x="303" y="112"/>
                </a:lnTo>
                <a:lnTo>
                  <a:pt x="302" y="105"/>
                </a:lnTo>
                <a:lnTo>
                  <a:pt x="301" y="99"/>
                </a:lnTo>
                <a:lnTo>
                  <a:pt x="298" y="95"/>
                </a:lnTo>
                <a:lnTo>
                  <a:pt x="294" y="91"/>
                </a:lnTo>
                <a:lnTo>
                  <a:pt x="290" y="89"/>
                </a:lnTo>
                <a:lnTo>
                  <a:pt x="285" y="88"/>
                </a:lnTo>
                <a:lnTo>
                  <a:pt x="277" y="87"/>
                </a:lnTo>
                <a:lnTo>
                  <a:pt x="267" y="87"/>
                </a:lnTo>
                <a:lnTo>
                  <a:pt x="145" y="87"/>
                </a:lnTo>
                <a:lnTo>
                  <a:pt x="135" y="87"/>
                </a:lnTo>
                <a:lnTo>
                  <a:pt x="127" y="88"/>
                </a:lnTo>
                <a:lnTo>
                  <a:pt x="121" y="89"/>
                </a:lnTo>
                <a:lnTo>
                  <a:pt x="117" y="92"/>
                </a:lnTo>
                <a:lnTo>
                  <a:pt x="114" y="95"/>
                </a:lnTo>
                <a:lnTo>
                  <a:pt x="112" y="99"/>
                </a:lnTo>
                <a:lnTo>
                  <a:pt x="109" y="104"/>
                </a:lnTo>
                <a:lnTo>
                  <a:pt x="109" y="112"/>
                </a:lnTo>
                <a:lnTo>
                  <a:pt x="101" y="112"/>
                </a:lnTo>
                <a:lnTo>
                  <a:pt x="101" y="26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2" name="Freeform 106"/>
          <p:cNvSpPr>
            <a:spLocks/>
          </p:cNvSpPr>
          <p:nvPr/>
        </p:nvSpPr>
        <p:spPr bwMode="auto">
          <a:xfrm>
            <a:off x="531010" y="1621144"/>
            <a:ext cx="114300" cy="53975"/>
          </a:xfrm>
          <a:custGeom>
            <a:avLst/>
            <a:gdLst>
              <a:gd name="T0" fmla="*/ 0 w 288"/>
              <a:gd name="T1" fmla="*/ 48 h 136"/>
              <a:gd name="T2" fmla="*/ 76 w 288"/>
              <a:gd name="T3" fmla="*/ 48 h 136"/>
              <a:gd name="T4" fmla="*/ 76 w 288"/>
              <a:gd name="T5" fmla="*/ 0 h 136"/>
              <a:gd name="T6" fmla="*/ 99 w 288"/>
              <a:gd name="T7" fmla="*/ 0 h 136"/>
              <a:gd name="T8" fmla="*/ 99 w 288"/>
              <a:gd name="T9" fmla="*/ 48 h 136"/>
              <a:gd name="T10" fmla="*/ 228 w 288"/>
              <a:gd name="T11" fmla="*/ 48 h 136"/>
              <a:gd name="T12" fmla="*/ 242 w 288"/>
              <a:gd name="T13" fmla="*/ 48 h 136"/>
              <a:gd name="T14" fmla="*/ 251 w 288"/>
              <a:gd name="T15" fmla="*/ 47 h 136"/>
              <a:gd name="T16" fmla="*/ 255 w 288"/>
              <a:gd name="T17" fmla="*/ 45 h 136"/>
              <a:gd name="T18" fmla="*/ 259 w 288"/>
              <a:gd name="T19" fmla="*/ 41 h 136"/>
              <a:gd name="T20" fmla="*/ 261 w 288"/>
              <a:gd name="T21" fmla="*/ 37 h 136"/>
              <a:gd name="T22" fmla="*/ 262 w 288"/>
              <a:gd name="T23" fmla="*/ 34 h 136"/>
              <a:gd name="T24" fmla="*/ 262 w 288"/>
              <a:gd name="T25" fmla="*/ 30 h 136"/>
              <a:gd name="T26" fmla="*/ 261 w 288"/>
              <a:gd name="T27" fmla="*/ 27 h 136"/>
              <a:gd name="T28" fmla="*/ 259 w 288"/>
              <a:gd name="T29" fmla="*/ 24 h 136"/>
              <a:gd name="T30" fmla="*/ 257 w 288"/>
              <a:gd name="T31" fmla="*/ 20 h 136"/>
              <a:gd name="T32" fmla="*/ 250 w 288"/>
              <a:gd name="T33" fmla="*/ 14 h 136"/>
              <a:gd name="T34" fmla="*/ 241 w 288"/>
              <a:gd name="T35" fmla="*/ 8 h 136"/>
              <a:gd name="T36" fmla="*/ 245 w 288"/>
              <a:gd name="T37" fmla="*/ 0 h 136"/>
              <a:gd name="T38" fmla="*/ 255 w 288"/>
              <a:gd name="T39" fmla="*/ 6 h 136"/>
              <a:gd name="T40" fmla="*/ 264 w 288"/>
              <a:gd name="T41" fmla="*/ 11 h 136"/>
              <a:gd name="T42" fmla="*/ 271 w 288"/>
              <a:gd name="T43" fmla="*/ 17 h 136"/>
              <a:gd name="T44" fmla="*/ 278 w 288"/>
              <a:gd name="T45" fmla="*/ 24 h 136"/>
              <a:gd name="T46" fmla="*/ 282 w 288"/>
              <a:gd name="T47" fmla="*/ 31 h 136"/>
              <a:gd name="T48" fmla="*/ 286 w 288"/>
              <a:gd name="T49" fmla="*/ 39 h 136"/>
              <a:gd name="T50" fmla="*/ 288 w 288"/>
              <a:gd name="T51" fmla="*/ 48 h 136"/>
              <a:gd name="T52" fmla="*/ 288 w 288"/>
              <a:gd name="T53" fmla="*/ 58 h 136"/>
              <a:gd name="T54" fmla="*/ 287 w 288"/>
              <a:gd name="T55" fmla="*/ 67 h 136"/>
              <a:gd name="T56" fmla="*/ 285 w 288"/>
              <a:gd name="T57" fmla="*/ 76 h 136"/>
              <a:gd name="T58" fmla="*/ 282 w 288"/>
              <a:gd name="T59" fmla="*/ 84 h 136"/>
              <a:gd name="T60" fmla="*/ 277 w 288"/>
              <a:gd name="T61" fmla="*/ 90 h 136"/>
              <a:gd name="T62" fmla="*/ 271 w 288"/>
              <a:gd name="T63" fmla="*/ 97 h 136"/>
              <a:gd name="T64" fmla="*/ 265 w 288"/>
              <a:gd name="T65" fmla="*/ 102 h 136"/>
              <a:gd name="T66" fmla="*/ 259 w 288"/>
              <a:gd name="T67" fmla="*/ 106 h 136"/>
              <a:gd name="T68" fmla="*/ 252 w 288"/>
              <a:gd name="T69" fmla="*/ 108 h 136"/>
              <a:gd name="T70" fmla="*/ 247 w 288"/>
              <a:gd name="T71" fmla="*/ 109 h 136"/>
              <a:gd name="T72" fmla="*/ 238 w 288"/>
              <a:gd name="T73" fmla="*/ 110 h 136"/>
              <a:gd name="T74" fmla="*/ 227 w 288"/>
              <a:gd name="T75" fmla="*/ 110 h 136"/>
              <a:gd name="T76" fmla="*/ 211 w 288"/>
              <a:gd name="T77" fmla="*/ 110 h 136"/>
              <a:gd name="T78" fmla="*/ 99 w 288"/>
              <a:gd name="T79" fmla="*/ 110 h 136"/>
              <a:gd name="T80" fmla="*/ 99 w 288"/>
              <a:gd name="T81" fmla="*/ 136 h 136"/>
              <a:gd name="T82" fmla="*/ 91 w 288"/>
              <a:gd name="T83" fmla="*/ 136 h 136"/>
              <a:gd name="T84" fmla="*/ 80 w 288"/>
              <a:gd name="T85" fmla="*/ 123 h 136"/>
              <a:gd name="T86" fmla="*/ 70 w 288"/>
              <a:gd name="T87" fmla="*/ 111 h 136"/>
              <a:gd name="T88" fmla="*/ 60 w 288"/>
              <a:gd name="T89" fmla="*/ 101 h 136"/>
              <a:gd name="T90" fmla="*/ 49 w 288"/>
              <a:gd name="T91" fmla="*/ 90 h 136"/>
              <a:gd name="T92" fmla="*/ 37 w 288"/>
              <a:gd name="T93" fmla="*/ 80 h 136"/>
              <a:gd name="T94" fmla="*/ 25 w 288"/>
              <a:gd name="T95" fmla="*/ 72 h 136"/>
              <a:gd name="T96" fmla="*/ 13 w 288"/>
              <a:gd name="T97" fmla="*/ 64 h 136"/>
              <a:gd name="T98" fmla="*/ 0 w 288"/>
              <a:gd name="T99" fmla="*/ 57 h 136"/>
              <a:gd name="T100" fmla="*/ 0 w 288"/>
              <a:gd name="T101" fmla="*/ 48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288" h="136">
                <a:moveTo>
                  <a:pt x="0" y="48"/>
                </a:moveTo>
                <a:lnTo>
                  <a:pt x="76" y="48"/>
                </a:lnTo>
                <a:lnTo>
                  <a:pt x="76" y="0"/>
                </a:lnTo>
                <a:lnTo>
                  <a:pt x="99" y="0"/>
                </a:lnTo>
                <a:lnTo>
                  <a:pt x="99" y="48"/>
                </a:lnTo>
                <a:lnTo>
                  <a:pt x="228" y="48"/>
                </a:lnTo>
                <a:lnTo>
                  <a:pt x="242" y="48"/>
                </a:lnTo>
                <a:lnTo>
                  <a:pt x="251" y="47"/>
                </a:lnTo>
                <a:lnTo>
                  <a:pt x="255" y="45"/>
                </a:lnTo>
                <a:lnTo>
                  <a:pt x="259" y="41"/>
                </a:lnTo>
                <a:lnTo>
                  <a:pt x="261" y="37"/>
                </a:lnTo>
                <a:lnTo>
                  <a:pt x="262" y="34"/>
                </a:lnTo>
                <a:lnTo>
                  <a:pt x="262" y="30"/>
                </a:lnTo>
                <a:lnTo>
                  <a:pt x="261" y="27"/>
                </a:lnTo>
                <a:lnTo>
                  <a:pt x="259" y="24"/>
                </a:lnTo>
                <a:lnTo>
                  <a:pt x="257" y="20"/>
                </a:lnTo>
                <a:lnTo>
                  <a:pt x="250" y="14"/>
                </a:lnTo>
                <a:lnTo>
                  <a:pt x="241" y="8"/>
                </a:lnTo>
                <a:lnTo>
                  <a:pt x="245" y="0"/>
                </a:lnTo>
                <a:lnTo>
                  <a:pt x="255" y="6"/>
                </a:lnTo>
                <a:lnTo>
                  <a:pt x="264" y="11"/>
                </a:lnTo>
                <a:lnTo>
                  <a:pt x="271" y="17"/>
                </a:lnTo>
                <a:lnTo>
                  <a:pt x="278" y="24"/>
                </a:lnTo>
                <a:lnTo>
                  <a:pt x="282" y="31"/>
                </a:lnTo>
                <a:lnTo>
                  <a:pt x="286" y="39"/>
                </a:lnTo>
                <a:lnTo>
                  <a:pt x="288" y="48"/>
                </a:lnTo>
                <a:lnTo>
                  <a:pt x="288" y="58"/>
                </a:lnTo>
                <a:lnTo>
                  <a:pt x="287" y="67"/>
                </a:lnTo>
                <a:lnTo>
                  <a:pt x="285" y="76"/>
                </a:lnTo>
                <a:lnTo>
                  <a:pt x="282" y="84"/>
                </a:lnTo>
                <a:lnTo>
                  <a:pt x="277" y="90"/>
                </a:lnTo>
                <a:lnTo>
                  <a:pt x="271" y="97"/>
                </a:lnTo>
                <a:lnTo>
                  <a:pt x="265" y="102"/>
                </a:lnTo>
                <a:lnTo>
                  <a:pt x="259" y="106"/>
                </a:lnTo>
                <a:lnTo>
                  <a:pt x="252" y="108"/>
                </a:lnTo>
                <a:lnTo>
                  <a:pt x="247" y="109"/>
                </a:lnTo>
                <a:lnTo>
                  <a:pt x="238" y="110"/>
                </a:lnTo>
                <a:lnTo>
                  <a:pt x="227" y="110"/>
                </a:lnTo>
                <a:lnTo>
                  <a:pt x="211" y="110"/>
                </a:lnTo>
                <a:lnTo>
                  <a:pt x="99" y="110"/>
                </a:lnTo>
                <a:lnTo>
                  <a:pt x="99" y="136"/>
                </a:lnTo>
                <a:lnTo>
                  <a:pt x="91" y="136"/>
                </a:lnTo>
                <a:lnTo>
                  <a:pt x="80" y="123"/>
                </a:lnTo>
                <a:lnTo>
                  <a:pt x="70" y="111"/>
                </a:lnTo>
                <a:lnTo>
                  <a:pt x="60" y="101"/>
                </a:lnTo>
                <a:lnTo>
                  <a:pt x="49" y="90"/>
                </a:lnTo>
                <a:lnTo>
                  <a:pt x="37" y="80"/>
                </a:lnTo>
                <a:lnTo>
                  <a:pt x="25" y="72"/>
                </a:lnTo>
                <a:lnTo>
                  <a:pt x="13" y="64"/>
                </a:lnTo>
                <a:lnTo>
                  <a:pt x="0" y="57"/>
                </a:lnTo>
                <a:lnTo>
                  <a:pt x="0" y="48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3" name="Freeform 107"/>
          <p:cNvSpPr>
            <a:spLocks/>
          </p:cNvSpPr>
          <p:nvPr/>
        </p:nvSpPr>
        <p:spPr bwMode="auto">
          <a:xfrm>
            <a:off x="561173" y="1524306"/>
            <a:ext cx="122238" cy="84138"/>
          </a:xfrm>
          <a:custGeom>
            <a:avLst/>
            <a:gdLst>
              <a:gd name="T0" fmla="*/ 63 w 308"/>
              <a:gd name="T1" fmla="*/ 176 h 215"/>
              <a:gd name="T2" fmla="*/ 34 w 308"/>
              <a:gd name="T3" fmla="*/ 189 h 215"/>
              <a:gd name="T4" fmla="*/ 20 w 308"/>
              <a:gd name="T5" fmla="*/ 198 h 215"/>
              <a:gd name="T6" fmla="*/ 13 w 308"/>
              <a:gd name="T7" fmla="*/ 206 h 215"/>
              <a:gd name="T8" fmla="*/ 8 w 308"/>
              <a:gd name="T9" fmla="*/ 215 h 215"/>
              <a:gd name="T10" fmla="*/ 0 w 308"/>
              <a:gd name="T11" fmla="*/ 106 h 215"/>
              <a:gd name="T12" fmla="*/ 8 w 308"/>
              <a:gd name="T13" fmla="*/ 112 h 215"/>
              <a:gd name="T14" fmla="*/ 11 w 308"/>
              <a:gd name="T15" fmla="*/ 120 h 215"/>
              <a:gd name="T16" fmla="*/ 15 w 308"/>
              <a:gd name="T17" fmla="*/ 124 h 215"/>
              <a:gd name="T18" fmla="*/ 19 w 308"/>
              <a:gd name="T19" fmla="*/ 126 h 215"/>
              <a:gd name="T20" fmla="*/ 27 w 308"/>
              <a:gd name="T21" fmla="*/ 126 h 215"/>
              <a:gd name="T22" fmla="*/ 44 w 308"/>
              <a:gd name="T23" fmla="*/ 120 h 215"/>
              <a:gd name="T24" fmla="*/ 138 w 308"/>
              <a:gd name="T25" fmla="*/ 81 h 215"/>
              <a:gd name="T26" fmla="*/ 59 w 308"/>
              <a:gd name="T27" fmla="*/ 51 h 215"/>
              <a:gd name="T28" fmla="*/ 35 w 308"/>
              <a:gd name="T29" fmla="*/ 45 h 215"/>
              <a:gd name="T30" fmla="*/ 23 w 308"/>
              <a:gd name="T31" fmla="*/ 44 h 215"/>
              <a:gd name="T32" fmla="*/ 17 w 308"/>
              <a:gd name="T33" fmla="*/ 47 h 215"/>
              <a:gd name="T34" fmla="*/ 12 w 308"/>
              <a:gd name="T35" fmla="*/ 52 h 215"/>
              <a:gd name="T36" fmla="*/ 8 w 308"/>
              <a:gd name="T37" fmla="*/ 61 h 215"/>
              <a:gd name="T38" fmla="*/ 0 w 308"/>
              <a:gd name="T39" fmla="*/ 68 h 215"/>
              <a:gd name="T40" fmla="*/ 8 w 308"/>
              <a:gd name="T41" fmla="*/ 0 h 215"/>
              <a:gd name="T42" fmla="*/ 11 w 308"/>
              <a:gd name="T43" fmla="*/ 9 h 215"/>
              <a:gd name="T44" fmla="*/ 16 w 308"/>
              <a:gd name="T45" fmla="*/ 17 h 215"/>
              <a:gd name="T46" fmla="*/ 31 w 308"/>
              <a:gd name="T47" fmla="*/ 25 h 215"/>
              <a:gd name="T48" fmla="*/ 63 w 308"/>
              <a:gd name="T49" fmla="*/ 38 h 215"/>
              <a:gd name="T50" fmla="*/ 245 w 308"/>
              <a:gd name="T51" fmla="*/ 106 h 215"/>
              <a:gd name="T52" fmla="*/ 279 w 308"/>
              <a:gd name="T53" fmla="*/ 123 h 215"/>
              <a:gd name="T54" fmla="*/ 294 w 308"/>
              <a:gd name="T55" fmla="*/ 132 h 215"/>
              <a:gd name="T56" fmla="*/ 301 w 308"/>
              <a:gd name="T57" fmla="*/ 141 h 215"/>
              <a:gd name="T58" fmla="*/ 306 w 308"/>
              <a:gd name="T59" fmla="*/ 150 h 215"/>
              <a:gd name="T60" fmla="*/ 308 w 308"/>
              <a:gd name="T61" fmla="*/ 161 h 215"/>
              <a:gd name="T62" fmla="*/ 307 w 308"/>
              <a:gd name="T63" fmla="*/ 175 h 215"/>
              <a:gd name="T64" fmla="*/ 302 w 308"/>
              <a:gd name="T65" fmla="*/ 189 h 215"/>
              <a:gd name="T66" fmla="*/ 292 w 308"/>
              <a:gd name="T67" fmla="*/ 200 h 215"/>
              <a:gd name="T68" fmla="*/ 279 w 308"/>
              <a:gd name="T69" fmla="*/ 206 h 215"/>
              <a:gd name="T70" fmla="*/ 266 w 308"/>
              <a:gd name="T71" fmla="*/ 206 h 215"/>
              <a:gd name="T72" fmla="*/ 255 w 308"/>
              <a:gd name="T73" fmla="*/ 203 h 215"/>
              <a:gd name="T74" fmla="*/ 247 w 308"/>
              <a:gd name="T75" fmla="*/ 194 h 215"/>
              <a:gd name="T76" fmla="*/ 243 w 308"/>
              <a:gd name="T77" fmla="*/ 185 h 215"/>
              <a:gd name="T78" fmla="*/ 243 w 308"/>
              <a:gd name="T79" fmla="*/ 175 h 215"/>
              <a:gd name="T80" fmla="*/ 246 w 308"/>
              <a:gd name="T81" fmla="*/ 166 h 215"/>
              <a:gd name="T82" fmla="*/ 253 w 308"/>
              <a:gd name="T83" fmla="*/ 160 h 215"/>
              <a:gd name="T84" fmla="*/ 264 w 308"/>
              <a:gd name="T85" fmla="*/ 156 h 215"/>
              <a:gd name="T86" fmla="*/ 278 w 308"/>
              <a:gd name="T87" fmla="*/ 154 h 215"/>
              <a:gd name="T88" fmla="*/ 284 w 308"/>
              <a:gd name="T89" fmla="*/ 151 h 215"/>
              <a:gd name="T90" fmla="*/ 284 w 308"/>
              <a:gd name="T91" fmla="*/ 145 h 215"/>
              <a:gd name="T92" fmla="*/ 281 w 308"/>
              <a:gd name="T93" fmla="*/ 140 h 215"/>
              <a:gd name="T94" fmla="*/ 272 w 308"/>
              <a:gd name="T95" fmla="*/ 133 h 215"/>
              <a:gd name="T96" fmla="*/ 251 w 308"/>
              <a:gd name="T97" fmla="*/ 123 h 215"/>
              <a:gd name="T98" fmla="*/ 218 w 308"/>
              <a:gd name="T99" fmla="*/ 111 h 2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308" h="215">
                <a:moveTo>
                  <a:pt x="218" y="111"/>
                </a:moveTo>
                <a:lnTo>
                  <a:pt x="63" y="176"/>
                </a:lnTo>
                <a:lnTo>
                  <a:pt x="47" y="183"/>
                </a:lnTo>
                <a:lnTo>
                  <a:pt x="34" y="189"/>
                </a:lnTo>
                <a:lnTo>
                  <a:pt x="25" y="194"/>
                </a:lnTo>
                <a:lnTo>
                  <a:pt x="20" y="198"/>
                </a:lnTo>
                <a:lnTo>
                  <a:pt x="16" y="202"/>
                </a:lnTo>
                <a:lnTo>
                  <a:pt x="13" y="206"/>
                </a:lnTo>
                <a:lnTo>
                  <a:pt x="11" y="211"/>
                </a:lnTo>
                <a:lnTo>
                  <a:pt x="8" y="215"/>
                </a:lnTo>
                <a:lnTo>
                  <a:pt x="0" y="215"/>
                </a:lnTo>
                <a:lnTo>
                  <a:pt x="0" y="106"/>
                </a:lnTo>
                <a:lnTo>
                  <a:pt x="8" y="106"/>
                </a:lnTo>
                <a:lnTo>
                  <a:pt x="8" y="112"/>
                </a:lnTo>
                <a:lnTo>
                  <a:pt x="10" y="116"/>
                </a:lnTo>
                <a:lnTo>
                  <a:pt x="11" y="120"/>
                </a:lnTo>
                <a:lnTo>
                  <a:pt x="13" y="122"/>
                </a:lnTo>
                <a:lnTo>
                  <a:pt x="15" y="124"/>
                </a:lnTo>
                <a:lnTo>
                  <a:pt x="17" y="125"/>
                </a:lnTo>
                <a:lnTo>
                  <a:pt x="19" y="126"/>
                </a:lnTo>
                <a:lnTo>
                  <a:pt x="22" y="126"/>
                </a:lnTo>
                <a:lnTo>
                  <a:pt x="27" y="126"/>
                </a:lnTo>
                <a:lnTo>
                  <a:pt x="34" y="124"/>
                </a:lnTo>
                <a:lnTo>
                  <a:pt x="44" y="120"/>
                </a:lnTo>
                <a:lnTo>
                  <a:pt x="55" y="116"/>
                </a:lnTo>
                <a:lnTo>
                  <a:pt x="138" y="81"/>
                </a:lnTo>
                <a:lnTo>
                  <a:pt x="74" y="56"/>
                </a:lnTo>
                <a:lnTo>
                  <a:pt x="59" y="51"/>
                </a:lnTo>
                <a:lnTo>
                  <a:pt x="45" y="47"/>
                </a:lnTo>
                <a:lnTo>
                  <a:pt x="35" y="45"/>
                </a:lnTo>
                <a:lnTo>
                  <a:pt x="27" y="44"/>
                </a:lnTo>
                <a:lnTo>
                  <a:pt x="23" y="44"/>
                </a:lnTo>
                <a:lnTo>
                  <a:pt x="20" y="45"/>
                </a:lnTo>
                <a:lnTo>
                  <a:pt x="17" y="47"/>
                </a:lnTo>
                <a:lnTo>
                  <a:pt x="14" y="49"/>
                </a:lnTo>
                <a:lnTo>
                  <a:pt x="12" y="52"/>
                </a:lnTo>
                <a:lnTo>
                  <a:pt x="10" y="56"/>
                </a:lnTo>
                <a:lnTo>
                  <a:pt x="8" y="61"/>
                </a:lnTo>
                <a:lnTo>
                  <a:pt x="8" y="68"/>
                </a:lnTo>
                <a:lnTo>
                  <a:pt x="0" y="68"/>
                </a:lnTo>
                <a:lnTo>
                  <a:pt x="0" y="0"/>
                </a:lnTo>
                <a:lnTo>
                  <a:pt x="8" y="0"/>
                </a:lnTo>
                <a:lnTo>
                  <a:pt x="10" y="5"/>
                </a:lnTo>
                <a:lnTo>
                  <a:pt x="11" y="9"/>
                </a:lnTo>
                <a:lnTo>
                  <a:pt x="13" y="13"/>
                </a:lnTo>
                <a:lnTo>
                  <a:pt x="16" y="17"/>
                </a:lnTo>
                <a:lnTo>
                  <a:pt x="22" y="21"/>
                </a:lnTo>
                <a:lnTo>
                  <a:pt x="31" y="25"/>
                </a:lnTo>
                <a:lnTo>
                  <a:pt x="45" y="31"/>
                </a:lnTo>
                <a:lnTo>
                  <a:pt x="63" y="38"/>
                </a:lnTo>
                <a:lnTo>
                  <a:pt x="218" y="96"/>
                </a:lnTo>
                <a:lnTo>
                  <a:pt x="245" y="106"/>
                </a:lnTo>
                <a:lnTo>
                  <a:pt x="265" y="115"/>
                </a:lnTo>
                <a:lnTo>
                  <a:pt x="279" y="123"/>
                </a:lnTo>
                <a:lnTo>
                  <a:pt x="290" y="128"/>
                </a:lnTo>
                <a:lnTo>
                  <a:pt x="294" y="132"/>
                </a:lnTo>
                <a:lnTo>
                  <a:pt x="298" y="136"/>
                </a:lnTo>
                <a:lnTo>
                  <a:pt x="301" y="141"/>
                </a:lnTo>
                <a:lnTo>
                  <a:pt x="304" y="145"/>
                </a:lnTo>
                <a:lnTo>
                  <a:pt x="306" y="150"/>
                </a:lnTo>
                <a:lnTo>
                  <a:pt x="307" y="156"/>
                </a:lnTo>
                <a:lnTo>
                  <a:pt x="308" y="161"/>
                </a:lnTo>
                <a:lnTo>
                  <a:pt x="308" y="166"/>
                </a:lnTo>
                <a:lnTo>
                  <a:pt x="307" y="175"/>
                </a:lnTo>
                <a:lnTo>
                  <a:pt x="305" y="182"/>
                </a:lnTo>
                <a:lnTo>
                  <a:pt x="302" y="189"/>
                </a:lnTo>
                <a:lnTo>
                  <a:pt x="298" y="195"/>
                </a:lnTo>
                <a:lnTo>
                  <a:pt x="292" y="200"/>
                </a:lnTo>
                <a:lnTo>
                  <a:pt x="285" y="204"/>
                </a:lnTo>
                <a:lnTo>
                  <a:pt x="279" y="206"/>
                </a:lnTo>
                <a:lnTo>
                  <a:pt x="272" y="207"/>
                </a:lnTo>
                <a:lnTo>
                  <a:pt x="266" y="206"/>
                </a:lnTo>
                <a:lnTo>
                  <a:pt x="260" y="205"/>
                </a:lnTo>
                <a:lnTo>
                  <a:pt x="255" y="203"/>
                </a:lnTo>
                <a:lnTo>
                  <a:pt x="251" y="198"/>
                </a:lnTo>
                <a:lnTo>
                  <a:pt x="247" y="194"/>
                </a:lnTo>
                <a:lnTo>
                  <a:pt x="244" y="190"/>
                </a:lnTo>
                <a:lnTo>
                  <a:pt x="243" y="185"/>
                </a:lnTo>
                <a:lnTo>
                  <a:pt x="241" y="180"/>
                </a:lnTo>
                <a:lnTo>
                  <a:pt x="243" y="175"/>
                </a:lnTo>
                <a:lnTo>
                  <a:pt x="244" y="170"/>
                </a:lnTo>
                <a:lnTo>
                  <a:pt x="246" y="166"/>
                </a:lnTo>
                <a:lnTo>
                  <a:pt x="249" y="162"/>
                </a:lnTo>
                <a:lnTo>
                  <a:pt x="253" y="160"/>
                </a:lnTo>
                <a:lnTo>
                  <a:pt x="258" y="158"/>
                </a:lnTo>
                <a:lnTo>
                  <a:pt x="264" y="156"/>
                </a:lnTo>
                <a:lnTo>
                  <a:pt x="271" y="156"/>
                </a:lnTo>
                <a:lnTo>
                  <a:pt x="278" y="154"/>
                </a:lnTo>
                <a:lnTo>
                  <a:pt x="282" y="153"/>
                </a:lnTo>
                <a:lnTo>
                  <a:pt x="284" y="151"/>
                </a:lnTo>
                <a:lnTo>
                  <a:pt x="284" y="148"/>
                </a:lnTo>
                <a:lnTo>
                  <a:pt x="284" y="145"/>
                </a:lnTo>
                <a:lnTo>
                  <a:pt x="283" y="143"/>
                </a:lnTo>
                <a:lnTo>
                  <a:pt x="281" y="140"/>
                </a:lnTo>
                <a:lnTo>
                  <a:pt x="278" y="137"/>
                </a:lnTo>
                <a:lnTo>
                  <a:pt x="272" y="133"/>
                </a:lnTo>
                <a:lnTo>
                  <a:pt x="263" y="128"/>
                </a:lnTo>
                <a:lnTo>
                  <a:pt x="251" y="123"/>
                </a:lnTo>
                <a:lnTo>
                  <a:pt x="235" y="117"/>
                </a:lnTo>
                <a:lnTo>
                  <a:pt x="218" y="111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4" name="Freeform 108"/>
          <p:cNvSpPr>
            <a:spLocks/>
          </p:cNvSpPr>
          <p:nvPr/>
        </p:nvSpPr>
        <p:spPr bwMode="auto">
          <a:xfrm>
            <a:off x="521485" y="1421119"/>
            <a:ext cx="158750" cy="50800"/>
          </a:xfrm>
          <a:custGeom>
            <a:avLst/>
            <a:gdLst>
              <a:gd name="T0" fmla="*/ 0 w 402"/>
              <a:gd name="T1" fmla="*/ 0 h 125"/>
              <a:gd name="T2" fmla="*/ 10 w 402"/>
              <a:gd name="T3" fmla="*/ 0 h 125"/>
              <a:gd name="T4" fmla="*/ 18 w 402"/>
              <a:gd name="T5" fmla="*/ 10 h 125"/>
              <a:gd name="T6" fmla="*/ 26 w 402"/>
              <a:gd name="T7" fmla="*/ 19 h 125"/>
              <a:gd name="T8" fmla="*/ 33 w 402"/>
              <a:gd name="T9" fmla="*/ 26 h 125"/>
              <a:gd name="T10" fmla="*/ 40 w 402"/>
              <a:gd name="T11" fmla="*/ 32 h 125"/>
              <a:gd name="T12" fmla="*/ 51 w 402"/>
              <a:gd name="T13" fmla="*/ 39 h 125"/>
              <a:gd name="T14" fmla="*/ 64 w 402"/>
              <a:gd name="T15" fmla="*/ 46 h 125"/>
              <a:gd name="T16" fmla="*/ 77 w 402"/>
              <a:gd name="T17" fmla="*/ 52 h 125"/>
              <a:gd name="T18" fmla="*/ 92 w 402"/>
              <a:gd name="T19" fmla="*/ 56 h 125"/>
              <a:gd name="T20" fmla="*/ 114 w 402"/>
              <a:gd name="T21" fmla="*/ 61 h 125"/>
              <a:gd name="T22" fmla="*/ 139 w 402"/>
              <a:gd name="T23" fmla="*/ 64 h 125"/>
              <a:gd name="T24" fmla="*/ 168 w 402"/>
              <a:gd name="T25" fmla="*/ 66 h 125"/>
              <a:gd name="T26" fmla="*/ 201 w 402"/>
              <a:gd name="T27" fmla="*/ 66 h 125"/>
              <a:gd name="T28" fmla="*/ 232 w 402"/>
              <a:gd name="T29" fmla="*/ 66 h 125"/>
              <a:gd name="T30" fmla="*/ 260 w 402"/>
              <a:gd name="T31" fmla="*/ 64 h 125"/>
              <a:gd name="T32" fmla="*/ 284 w 402"/>
              <a:gd name="T33" fmla="*/ 61 h 125"/>
              <a:gd name="T34" fmla="*/ 304 w 402"/>
              <a:gd name="T35" fmla="*/ 57 h 125"/>
              <a:gd name="T36" fmla="*/ 321 w 402"/>
              <a:gd name="T37" fmla="*/ 52 h 125"/>
              <a:gd name="T38" fmla="*/ 337 w 402"/>
              <a:gd name="T39" fmla="*/ 46 h 125"/>
              <a:gd name="T40" fmla="*/ 351 w 402"/>
              <a:gd name="T41" fmla="*/ 38 h 125"/>
              <a:gd name="T42" fmla="*/ 363 w 402"/>
              <a:gd name="T43" fmla="*/ 31 h 125"/>
              <a:gd name="T44" fmla="*/ 371 w 402"/>
              <a:gd name="T45" fmla="*/ 25 h 125"/>
              <a:gd name="T46" fmla="*/ 378 w 402"/>
              <a:gd name="T47" fmla="*/ 17 h 125"/>
              <a:gd name="T48" fmla="*/ 384 w 402"/>
              <a:gd name="T49" fmla="*/ 9 h 125"/>
              <a:gd name="T50" fmla="*/ 391 w 402"/>
              <a:gd name="T51" fmla="*/ 0 h 125"/>
              <a:gd name="T52" fmla="*/ 402 w 402"/>
              <a:gd name="T53" fmla="*/ 0 h 125"/>
              <a:gd name="T54" fmla="*/ 397 w 402"/>
              <a:gd name="T55" fmla="*/ 12 h 125"/>
              <a:gd name="T56" fmla="*/ 391 w 402"/>
              <a:gd name="T57" fmla="*/ 24 h 125"/>
              <a:gd name="T58" fmla="*/ 383 w 402"/>
              <a:gd name="T59" fmla="*/ 36 h 125"/>
              <a:gd name="T60" fmla="*/ 374 w 402"/>
              <a:gd name="T61" fmla="*/ 48 h 125"/>
              <a:gd name="T62" fmla="*/ 364 w 402"/>
              <a:gd name="T63" fmla="*/ 59 h 125"/>
              <a:gd name="T64" fmla="*/ 354 w 402"/>
              <a:gd name="T65" fmla="*/ 69 h 125"/>
              <a:gd name="T66" fmla="*/ 341 w 402"/>
              <a:gd name="T67" fmla="*/ 79 h 125"/>
              <a:gd name="T68" fmla="*/ 328 w 402"/>
              <a:gd name="T69" fmla="*/ 89 h 125"/>
              <a:gd name="T70" fmla="*/ 314 w 402"/>
              <a:gd name="T71" fmla="*/ 97 h 125"/>
              <a:gd name="T72" fmla="*/ 299 w 402"/>
              <a:gd name="T73" fmla="*/ 104 h 125"/>
              <a:gd name="T74" fmla="*/ 283 w 402"/>
              <a:gd name="T75" fmla="*/ 111 h 125"/>
              <a:gd name="T76" fmla="*/ 268 w 402"/>
              <a:gd name="T77" fmla="*/ 116 h 125"/>
              <a:gd name="T78" fmla="*/ 252 w 402"/>
              <a:gd name="T79" fmla="*/ 120 h 125"/>
              <a:gd name="T80" fmla="*/ 235 w 402"/>
              <a:gd name="T81" fmla="*/ 122 h 125"/>
              <a:gd name="T82" fmla="*/ 218 w 402"/>
              <a:gd name="T83" fmla="*/ 124 h 125"/>
              <a:gd name="T84" fmla="*/ 199 w 402"/>
              <a:gd name="T85" fmla="*/ 125 h 125"/>
              <a:gd name="T86" fmla="*/ 182 w 402"/>
              <a:gd name="T87" fmla="*/ 124 h 125"/>
              <a:gd name="T88" fmla="*/ 165 w 402"/>
              <a:gd name="T89" fmla="*/ 122 h 125"/>
              <a:gd name="T90" fmla="*/ 148 w 402"/>
              <a:gd name="T91" fmla="*/ 120 h 125"/>
              <a:gd name="T92" fmla="*/ 132 w 402"/>
              <a:gd name="T93" fmla="*/ 116 h 125"/>
              <a:gd name="T94" fmla="*/ 117 w 402"/>
              <a:gd name="T95" fmla="*/ 111 h 125"/>
              <a:gd name="T96" fmla="*/ 101 w 402"/>
              <a:gd name="T97" fmla="*/ 104 h 125"/>
              <a:gd name="T98" fmla="*/ 87 w 402"/>
              <a:gd name="T99" fmla="*/ 97 h 125"/>
              <a:gd name="T100" fmla="*/ 74 w 402"/>
              <a:gd name="T101" fmla="*/ 89 h 125"/>
              <a:gd name="T102" fmla="*/ 60 w 402"/>
              <a:gd name="T103" fmla="*/ 79 h 125"/>
              <a:gd name="T104" fmla="*/ 48 w 402"/>
              <a:gd name="T105" fmla="*/ 69 h 125"/>
              <a:gd name="T106" fmla="*/ 37 w 402"/>
              <a:gd name="T107" fmla="*/ 59 h 125"/>
              <a:gd name="T108" fmla="*/ 28 w 402"/>
              <a:gd name="T109" fmla="*/ 48 h 125"/>
              <a:gd name="T110" fmla="*/ 19 w 402"/>
              <a:gd name="T111" fmla="*/ 36 h 125"/>
              <a:gd name="T112" fmla="*/ 11 w 402"/>
              <a:gd name="T113" fmla="*/ 24 h 125"/>
              <a:gd name="T114" fmla="*/ 5 w 402"/>
              <a:gd name="T115" fmla="*/ 12 h 125"/>
              <a:gd name="T116" fmla="*/ 0 w 402"/>
              <a:gd name="T117" fmla="*/ 0 h 1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02" h="125">
                <a:moveTo>
                  <a:pt x="0" y="0"/>
                </a:moveTo>
                <a:lnTo>
                  <a:pt x="10" y="0"/>
                </a:lnTo>
                <a:lnTo>
                  <a:pt x="18" y="10"/>
                </a:lnTo>
                <a:lnTo>
                  <a:pt x="26" y="19"/>
                </a:lnTo>
                <a:lnTo>
                  <a:pt x="33" y="26"/>
                </a:lnTo>
                <a:lnTo>
                  <a:pt x="40" y="32"/>
                </a:lnTo>
                <a:lnTo>
                  <a:pt x="51" y="39"/>
                </a:lnTo>
                <a:lnTo>
                  <a:pt x="64" y="46"/>
                </a:lnTo>
                <a:lnTo>
                  <a:pt x="77" y="52"/>
                </a:lnTo>
                <a:lnTo>
                  <a:pt x="92" y="56"/>
                </a:lnTo>
                <a:lnTo>
                  <a:pt x="114" y="61"/>
                </a:lnTo>
                <a:lnTo>
                  <a:pt x="139" y="64"/>
                </a:lnTo>
                <a:lnTo>
                  <a:pt x="168" y="66"/>
                </a:lnTo>
                <a:lnTo>
                  <a:pt x="201" y="66"/>
                </a:lnTo>
                <a:lnTo>
                  <a:pt x="232" y="66"/>
                </a:lnTo>
                <a:lnTo>
                  <a:pt x="260" y="64"/>
                </a:lnTo>
                <a:lnTo>
                  <a:pt x="284" y="61"/>
                </a:lnTo>
                <a:lnTo>
                  <a:pt x="304" y="57"/>
                </a:lnTo>
                <a:lnTo>
                  <a:pt x="321" y="52"/>
                </a:lnTo>
                <a:lnTo>
                  <a:pt x="337" y="46"/>
                </a:lnTo>
                <a:lnTo>
                  <a:pt x="351" y="38"/>
                </a:lnTo>
                <a:lnTo>
                  <a:pt x="363" y="31"/>
                </a:lnTo>
                <a:lnTo>
                  <a:pt x="371" y="25"/>
                </a:lnTo>
                <a:lnTo>
                  <a:pt x="378" y="17"/>
                </a:lnTo>
                <a:lnTo>
                  <a:pt x="384" y="9"/>
                </a:lnTo>
                <a:lnTo>
                  <a:pt x="391" y="0"/>
                </a:lnTo>
                <a:lnTo>
                  <a:pt x="402" y="0"/>
                </a:lnTo>
                <a:lnTo>
                  <a:pt x="397" y="12"/>
                </a:lnTo>
                <a:lnTo>
                  <a:pt x="391" y="24"/>
                </a:lnTo>
                <a:lnTo>
                  <a:pt x="383" y="36"/>
                </a:lnTo>
                <a:lnTo>
                  <a:pt x="374" y="48"/>
                </a:lnTo>
                <a:lnTo>
                  <a:pt x="364" y="59"/>
                </a:lnTo>
                <a:lnTo>
                  <a:pt x="354" y="69"/>
                </a:lnTo>
                <a:lnTo>
                  <a:pt x="341" y="79"/>
                </a:lnTo>
                <a:lnTo>
                  <a:pt x="328" y="89"/>
                </a:lnTo>
                <a:lnTo>
                  <a:pt x="314" y="97"/>
                </a:lnTo>
                <a:lnTo>
                  <a:pt x="299" y="104"/>
                </a:lnTo>
                <a:lnTo>
                  <a:pt x="283" y="111"/>
                </a:lnTo>
                <a:lnTo>
                  <a:pt x="268" y="116"/>
                </a:lnTo>
                <a:lnTo>
                  <a:pt x="252" y="120"/>
                </a:lnTo>
                <a:lnTo>
                  <a:pt x="235" y="122"/>
                </a:lnTo>
                <a:lnTo>
                  <a:pt x="218" y="124"/>
                </a:lnTo>
                <a:lnTo>
                  <a:pt x="199" y="125"/>
                </a:lnTo>
                <a:lnTo>
                  <a:pt x="182" y="124"/>
                </a:lnTo>
                <a:lnTo>
                  <a:pt x="165" y="122"/>
                </a:lnTo>
                <a:lnTo>
                  <a:pt x="148" y="120"/>
                </a:lnTo>
                <a:lnTo>
                  <a:pt x="132" y="116"/>
                </a:lnTo>
                <a:lnTo>
                  <a:pt x="117" y="111"/>
                </a:lnTo>
                <a:lnTo>
                  <a:pt x="101" y="104"/>
                </a:lnTo>
                <a:lnTo>
                  <a:pt x="87" y="97"/>
                </a:lnTo>
                <a:lnTo>
                  <a:pt x="74" y="89"/>
                </a:lnTo>
                <a:lnTo>
                  <a:pt x="60" y="79"/>
                </a:lnTo>
                <a:lnTo>
                  <a:pt x="48" y="69"/>
                </a:lnTo>
                <a:lnTo>
                  <a:pt x="37" y="59"/>
                </a:lnTo>
                <a:lnTo>
                  <a:pt x="28" y="48"/>
                </a:lnTo>
                <a:lnTo>
                  <a:pt x="19" y="36"/>
                </a:lnTo>
                <a:lnTo>
                  <a:pt x="11" y="24"/>
                </a:lnTo>
                <a:lnTo>
                  <a:pt x="5" y="12"/>
                </a:lnTo>
                <a:lnTo>
                  <a:pt x="0" y="0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5" name="Freeform 109"/>
          <p:cNvSpPr>
            <a:spLocks noEditPoints="1"/>
          </p:cNvSpPr>
          <p:nvPr/>
        </p:nvSpPr>
        <p:spPr bwMode="auto">
          <a:xfrm>
            <a:off x="521485" y="1246494"/>
            <a:ext cx="128588" cy="152400"/>
          </a:xfrm>
          <a:custGeom>
            <a:avLst/>
            <a:gdLst>
              <a:gd name="T0" fmla="*/ 0 w 322"/>
              <a:gd name="T1" fmla="*/ 102 h 384"/>
              <a:gd name="T2" fmla="*/ 1 w 322"/>
              <a:gd name="T3" fmla="*/ 296 h 384"/>
              <a:gd name="T4" fmla="*/ 12 w 322"/>
              <a:gd name="T5" fmla="*/ 270 h 384"/>
              <a:gd name="T6" fmla="*/ 35 w 322"/>
              <a:gd name="T7" fmla="*/ 249 h 384"/>
              <a:gd name="T8" fmla="*/ 64 w 322"/>
              <a:gd name="T9" fmla="*/ 239 h 384"/>
              <a:gd name="T10" fmla="*/ 98 w 322"/>
              <a:gd name="T11" fmla="*/ 239 h 384"/>
              <a:gd name="T12" fmla="*/ 127 w 322"/>
              <a:gd name="T13" fmla="*/ 249 h 384"/>
              <a:gd name="T14" fmla="*/ 149 w 322"/>
              <a:gd name="T15" fmla="*/ 270 h 384"/>
              <a:gd name="T16" fmla="*/ 161 w 322"/>
              <a:gd name="T17" fmla="*/ 296 h 384"/>
              <a:gd name="T18" fmla="*/ 161 w 322"/>
              <a:gd name="T19" fmla="*/ 327 h 384"/>
              <a:gd name="T20" fmla="*/ 149 w 322"/>
              <a:gd name="T21" fmla="*/ 353 h 384"/>
              <a:gd name="T22" fmla="*/ 129 w 322"/>
              <a:gd name="T23" fmla="*/ 372 h 384"/>
              <a:gd name="T24" fmla="*/ 99 w 322"/>
              <a:gd name="T25" fmla="*/ 383 h 384"/>
              <a:gd name="T26" fmla="*/ 66 w 322"/>
              <a:gd name="T27" fmla="*/ 383 h 384"/>
              <a:gd name="T28" fmla="*/ 35 w 322"/>
              <a:gd name="T29" fmla="*/ 372 h 384"/>
              <a:gd name="T30" fmla="*/ 13 w 322"/>
              <a:gd name="T31" fmla="*/ 352 h 384"/>
              <a:gd name="T32" fmla="*/ 1 w 322"/>
              <a:gd name="T33" fmla="*/ 326 h 384"/>
              <a:gd name="T34" fmla="*/ 12 w 322"/>
              <a:gd name="T35" fmla="*/ 315 h 384"/>
              <a:gd name="T36" fmla="*/ 27 w 322"/>
              <a:gd name="T37" fmla="*/ 325 h 384"/>
              <a:gd name="T38" fmla="*/ 67 w 322"/>
              <a:gd name="T39" fmla="*/ 329 h 384"/>
              <a:gd name="T40" fmla="*/ 124 w 322"/>
              <a:gd name="T41" fmla="*/ 328 h 384"/>
              <a:gd name="T42" fmla="*/ 145 w 322"/>
              <a:gd name="T43" fmla="*/ 321 h 384"/>
              <a:gd name="T44" fmla="*/ 150 w 322"/>
              <a:gd name="T45" fmla="*/ 307 h 384"/>
              <a:gd name="T46" fmla="*/ 138 w 322"/>
              <a:gd name="T47" fmla="*/ 297 h 384"/>
              <a:gd name="T48" fmla="*/ 100 w 322"/>
              <a:gd name="T49" fmla="*/ 292 h 384"/>
              <a:gd name="T50" fmla="*/ 41 w 322"/>
              <a:gd name="T51" fmla="*/ 293 h 384"/>
              <a:gd name="T52" fmla="*/ 18 w 322"/>
              <a:gd name="T53" fmla="*/ 301 h 384"/>
              <a:gd name="T54" fmla="*/ 160 w 322"/>
              <a:gd name="T55" fmla="*/ 75 h 384"/>
              <a:gd name="T56" fmla="*/ 166 w 322"/>
              <a:gd name="T57" fmla="*/ 45 h 384"/>
              <a:gd name="T58" fmla="*/ 182 w 322"/>
              <a:gd name="T59" fmla="*/ 22 h 384"/>
              <a:gd name="T60" fmla="*/ 208 w 322"/>
              <a:gd name="T61" fmla="*/ 5 h 384"/>
              <a:gd name="T62" fmla="*/ 240 w 322"/>
              <a:gd name="T63" fmla="*/ 0 h 384"/>
              <a:gd name="T64" fmla="*/ 273 w 322"/>
              <a:gd name="T65" fmla="*/ 5 h 384"/>
              <a:gd name="T66" fmla="*/ 299 w 322"/>
              <a:gd name="T67" fmla="*/ 22 h 384"/>
              <a:gd name="T68" fmla="*/ 316 w 322"/>
              <a:gd name="T69" fmla="*/ 46 h 384"/>
              <a:gd name="T70" fmla="*/ 322 w 322"/>
              <a:gd name="T71" fmla="*/ 74 h 384"/>
              <a:gd name="T72" fmla="*/ 316 w 322"/>
              <a:gd name="T73" fmla="*/ 102 h 384"/>
              <a:gd name="T74" fmla="*/ 299 w 322"/>
              <a:gd name="T75" fmla="*/ 126 h 384"/>
              <a:gd name="T76" fmla="*/ 273 w 322"/>
              <a:gd name="T77" fmla="*/ 141 h 384"/>
              <a:gd name="T78" fmla="*/ 240 w 322"/>
              <a:gd name="T79" fmla="*/ 146 h 384"/>
              <a:gd name="T80" fmla="*/ 208 w 322"/>
              <a:gd name="T81" fmla="*/ 141 h 384"/>
              <a:gd name="T82" fmla="*/ 182 w 322"/>
              <a:gd name="T83" fmla="*/ 126 h 384"/>
              <a:gd name="T84" fmla="*/ 166 w 322"/>
              <a:gd name="T85" fmla="*/ 102 h 384"/>
              <a:gd name="T86" fmla="*/ 160 w 322"/>
              <a:gd name="T87" fmla="*/ 75 h 384"/>
              <a:gd name="T88" fmla="*/ 177 w 322"/>
              <a:gd name="T89" fmla="*/ 84 h 384"/>
              <a:gd name="T90" fmla="*/ 198 w 322"/>
              <a:gd name="T91" fmla="*/ 90 h 384"/>
              <a:gd name="T92" fmla="*/ 255 w 322"/>
              <a:gd name="T93" fmla="*/ 92 h 384"/>
              <a:gd name="T94" fmla="*/ 295 w 322"/>
              <a:gd name="T95" fmla="*/ 87 h 384"/>
              <a:gd name="T96" fmla="*/ 309 w 322"/>
              <a:gd name="T97" fmla="*/ 78 h 384"/>
              <a:gd name="T98" fmla="*/ 304 w 322"/>
              <a:gd name="T99" fmla="*/ 63 h 384"/>
              <a:gd name="T100" fmla="*/ 281 w 322"/>
              <a:gd name="T101" fmla="*/ 56 h 384"/>
              <a:gd name="T102" fmla="*/ 225 w 322"/>
              <a:gd name="T103" fmla="*/ 55 h 384"/>
              <a:gd name="T104" fmla="*/ 184 w 322"/>
              <a:gd name="T105" fmla="*/ 59 h 384"/>
              <a:gd name="T106" fmla="*/ 172 w 322"/>
              <a:gd name="T107" fmla="*/ 70 h 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322" h="384">
                <a:moveTo>
                  <a:pt x="0" y="73"/>
                </a:moveTo>
                <a:lnTo>
                  <a:pt x="322" y="282"/>
                </a:lnTo>
                <a:lnTo>
                  <a:pt x="322" y="312"/>
                </a:lnTo>
                <a:lnTo>
                  <a:pt x="0" y="102"/>
                </a:lnTo>
                <a:lnTo>
                  <a:pt x="0" y="73"/>
                </a:lnTo>
                <a:close/>
                <a:moveTo>
                  <a:pt x="0" y="311"/>
                </a:moveTo>
                <a:lnTo>
                  <a:pt x="0" y="304"/>
                </a:lnTo>
                <a:lnTo>
                  <a:pt x="1" y="296"/>
                </a:lnTo>
                <a:lnTo>
                  <a:pt x="3" y="289"/>
                </a:lnTo>
                <a:lnTo>
                  <a:pt x="6" y="282"/>
                </a:lnTo>
                <a:lnTo>
                  <a:pt x="9" y="276"/>
                </a:lnTo>
                <a:lnTo>
                  <a:pt x="12" y="270"/>
                </a:lnTo>
                <a:lnTo>
                  <a:pt x="18" y="264"/>
                </a:lnTo>
                <a:lnTo>
                  <a:pt x="23" y="259"/>
                </a:lnTo>
                <a:lnTo>
                  <a:pt x="29" y="254"/>
                </a:lnTo>
                <a:lnTo>
                  <a:pt x="35" y="249"/>
                </a:lnTo>
                <a:lnTo>
                  <a:pt x="41" y="245"/>
                </a:lnTo>
                <a:lnTo>
                  <a:pt x="48" y="242"/>
                </a:lnTo>
                <a:lnTo>
                  <a:pt x="55" y="240"/>
                </a:lnTo>
                <a:lnTo>
                  <a:pt x="64" y="239"/>
                </a:lnTo>
                <a:lnTo>
                  <a:pt x="72" y="238"/>
                </a:lnTo>
                <a:lnTo>
                  <a:pt x="81" y="237"/>
                </a:lnTo>
                <a:lnTo>
                  <a:pt x="89" y="238"/>
                </a:lnTo>
                <a:lnTo>
                  <a:pt x="98" y="239"/>
                </a:lnTo>
                <a:lnTo>
                  <a:pt x="105" y="240"/>
                </a:lnTo>
                <a:lnTo>
                  <a:pt x="114" y="242"/>
                </a:lnTo>
                <a:lnTo>
                  <a:pt x="121" y="245"/>
                </a:lnTo>
                <a:lnTo>
                  <a:pt x="127" y="249"/>
                </a:lnTo>
                <a:lnTo>
                  <a:pt x="134" y="254"/>
                </a:lnTo>
                <a:lnTo>
                  <a:pt x="139" y="259"/>
                </a:lnTo>
                <a:lnTo>
                  <a:pt x="144" y="265"/>
                </a:lnTo>
                <a:lnTo>
                  <a:pt x="149" y="270"/>
                </a:lnTo>
                <a:lnTo>
                  <a:pt x="153" y="276"/>
                </a:lnTo>
                <a:lnTo>
                  <a:pt x="157" y="283"/>
                </a:lnTo>
                <a:lnTo>
                  <a:pt x="159" y="289"/>
                </a:lnTo>
                <a:lnTo>
                  <a:pt x="161" y="296"/>
                </a:lnTo>
                <a:lnTo>
                  <a:pt x="162" y="304"/>
                </a:lnTo>
                <a:lnTo>
                  <a:pt x="162" y="312"/>
                </a:lnTo>
                <a:lnTo>
                  <a:pt x="162" y="319"/>
                </a:lnTo>
                <a:lnTo>
                  <a:pt x="161" y="327"/>
                </a:lnTo>
                <a:lnTo>
                  <a:pt x="159" y="333"/>
                </a:lnTo>
                <a:lnTo>
                  <a:pt x="157" y="340"/>
                </a:lnTo>
                <a:lnTo>
                  <a:pt x="153" y="347"/>
                </a:lnTo>
                <a:lnTo>
                  <a:pt x="149" y="353"/>
                </a:lnTo>
                <a:lnTo>
                  <a:pt x="145" y="358"/>
                </a:lnTo>
                <a:lnTo>
                  <a:pt x="140" y="364"/>
                </a:lnTo>
                <a:lnTo>
                  <a:pt x="134" y="368"/>
                </a:lnTo>
                <a:lnTo>
                  <a:pt x="129" y="372"/>
                </a:lnTo>
                <a:lnTo>
                  <a:pt x="122" y="376"/>
                </a:lnTo>
                <a:lnTo>
                  <a:pt x="115" y="379"/>
                </a:lnTo>
                <a:lnTo>
                  <a:pt x="107" y="381"/>
                </a:lnTo>
                <a:lnTo>
                  <a:pt x="99" y="383"/>
                </a:lnTo>
                <a:lnTo>
                  <a:pt x="91" y="384"/>
                </a:lnTo>
                <a:lnTo>
                  <a:pt x="83" y="384"/>
                </a:lnTo>
                <a:lnTo>
                  <a:pt x="74" y="384"/>
                </a:lnTo>
                <a:lnTo>
                  <a:pt x="66" y="383"/>
                </a:lnTo>
                <a:lnTo>
                  <a:pt x="57" y="381"/>
                </a:lnTo>
                <a:lnTo>
                  <a:pt x="49" y="379"/>
                </a:lnTo>
                <a:lnTo>
                  <a:pt x="42" y="376"/>
                </a:lnTo>
                <a:lnTo>
                  <a:pt x="35" y="372"/>
                </a:lnTo>
                <a:lnTo>
                  <a:pt x="29" y="368"/>
                </a:lnTo>
                <a:lnTo>
                  <a:pt x="23" y="363"/>
                </a:lnTo>
                <a:lnTo>
                  <a:pt x="18" y="358"/>
                </a:lnTo>
                <a:lnTo>
                  <a:pt x="13" y="352"/>
                </a:lnTo>
                <a:lnTo>
                  <a:pt x="9" y="346"/>
                </a:lnTo>
                <a:lnTo>
                  <a:pt x="6" y="339"/>
                </a:lnTo>
                <a:lnTo>
                  <a:pt x="3" y="333"/>
                </a:lnTo>
                <a:lnTo>
                  <a:pt x="1" y="326"/>
                </a:lnTo>
                <a:lnTo>
                  <a:pt x="0" y="319"/>
                </a:lnTo>
                <a:lnTo>
                  <a:pt x="0" y="311"/>
                </a:lnTo>
                <a:close/>
                <a:moveTo>
                  <a:pt x="12" y="311"/>
                </a:moveTo>
                <a:lnTo>
                  <a:pt x="12" y="315"/>
                </a:lnTo>
                <a:lnTo>
                  <a:pt x="15" y="319"/>
                </a:lnTo>
                <a:lnTo>
                  <a:pt x="19" y="321"/>
                </a:lnTo>
                <a:lnTo>
                  <a:pt x="22" y="324"/>
                </a:lnTo>
                <a:lnTo>
                  <a:pt x="27" y="325"/>
                </a:lnTo>
                <a:lnTo>
                  <a:pt x="33" y="327"/>
                </a:lnTo>
                <a:lnTo>
                  <a:pt x="41" y="328"/>
                </a:lnTo>
                <a:lnTo>
                  <a:pt x="52" y="329"/>
                </a:lnTo>
                <a:lnTo>
                  <a:pt x="67" y="329"/>
                </a:lnTo>
                <a:lnTo>
                  <a:pt x="85" y="330"/>
                </a:lnTo>
                <a:lnTo>
                  <a:pt x="99" y="329"/>
                </a:lnTo>
                <a:lnTo>
                  <a:pt x="113" y="329"/>
                </a:lnTo>
                <a:lnTo>
                  <a:pt x="124" y="328"/>
                </a:lnTo>
                <a:lnTo>
                  <a:pt x="133" y="326"/>
                </a:lnTo>
                <a:lnTo>
                  <a:pt x="138" y="325"/>
                </a:lnTo>
                <a:lnTo>
                  <a:pt x="142" y="323"/>
                </a:lnTo>
                <a:lnTo>
                  <a:pt x="145" y="321"/>
                </a:lnTo>
                <a:lnTo>
                  <a:pt x="148" y="319"/>
                </a:lnTo>
                <a:lnTo>
                  <a:pt x="150" y="315"/>
                </a:lnTo>
                <a:lnTo>
                  <a:pt x="151" y="311"/>
                </a:lnTo>
                <a:lnTo>
                  <a:pt x="150" y="307"/>
                </a:lnTo>
                <a:lnTo>
                  <a:pt x="148" y="303"/>
                </a:lnTo>
                <a:lnTo>
                  <a:pt x="145" y="301"/>
                </a:lnTo>
                <a:lnTo>
                  <a:pt x="142" y="299"/>
                </a:lnTo>
                <a:lnTo>
                  <a:pt x="138" y="297"/>
                </a:lnTo>
                <a:lnTo>
                  <a:pt x="133" y="295"/>
                </a:lnTo>
                <a:lnTo>
                  <a:pt x="124" y="294"/>
                </a:lnTo>
                <a:lnTo>
                  <a:pt x="113" y="292"/>
                </a:lnTo>
                <a:lnTo>
                  <a:pt x="100" y="292"/>
                </a:lnTo>
                <a:lnTo>
                  <a:pt x="86" y="292"/>
                </a:lnTo>
                <a:lnTo>
                  <a:pt x="69" y="292"/>
                </a:lnTo>
                <a:lnTo>
                  <a:pt x="53" y="292"/>
                </a:lnTo>
                <a:lnTo>
                  <a:pt x="41" y="293"/>
                </a:lnTo>
                <a:lnTo>
                  <a:pt x="32" y="295"/>
                </a:lnTo>
                <a:lnTo>
                  <a:pt x="26" y="296"/>
                </a:lnTo>
                <a:lnTo>
                  <a:pt x="22" y="299"/>
                </a:lnTo>
                <a:lnTo>
                  <a:pt x="18" y="301"/>
                </a:lnTo>
                <a:lnTo>
                  <a:pt x="14" y="304"/>
                </a:lnTo>
                <a:lnTo>
                  <a:pt x="12" y="307"/>
                </a:lnTo>
                <a:lnTo>
                  <a:pt x="12" y="311"/>
                </a:lnTo>
                <a:close/>
                <a:moveTo>
                  <a:pt x="160" y="75"/>
                </a:moveTo>
                <a:lnTo>
                  <a:pt x="161" y="67"/>
                </a:lnTo>
                <a:lnTo>
                  <a:pt x="162" y="59"/>
                </a:lnTo>
                <a:lnTo>
                  <a:pt x="163" y="52"/>
                </a:lnTo>
                <a:lnTo>
                  <a:pt x="166" y="45"/>
                </a:lnTo>
                <a:lnTo>
                  <a:pt x="169" y="39"/>
                </a:lnTo>
                <a:lnTo>
                  <a:pt x="172" y="33"/>
                </a:lnTo>
                <a:lnTo>
                  <a:pt x="177" y="27"/>
                </a:lnTo>
                <a:lnTo>
                  <a:pt x="182" y="22"/>
                </a:lnTo>
                <a:lnTo>
                  <a:pt x="188" y="16"/>
                </a:lnTo>
                <a:lnTo>
                  <a:pt x="194" y="12"/>
                </a:lnTo>
                <a:lnTo>
                  <a:pt x="200" y="8"/>
                </a:lnTo>
                <a:lnTo>
                  <a:pt x="208" y="5"/>
                </a:lnTo>
                <a:lnTo>
                  <a:pt x="215" y="3"/>
                </a:lnTo>
                <a:lnTo>
                  <a:pt x="223" y="2"/>
                </a:lnTo>
                <a:lnTo>
                  <a:pt x="231" y="1"/>
                </a:lnTo>
                <a:lnTo>
                  <a:pt x="240" y="0"/>
                </a:lnTo>
                <a:lnTo>
                  <a:pt x="248" y="1"/>
                </a:lnTo>
                <a:lnTo>
                  <a:pt x="258" y="2"/>
                </a:lnTo>
                <a:lnTo>
                  <a:pt x="265" y="3"/>
                </a:lnTo>
                <a:lnTo>
                  <a:pt x="273" y="5"/>
                </a:lnTo>
                <a:lnTo>
                  <a:pt x="280" y="8"/>
                </a:lnTo>
                <a:lnTo>
                  <a:pt x="286" y="12"/>
                </a:lnTo>
                <a:lnTo>
                  <a:pt x="293" y="16"/>
                </a:lnTo>
                <a:lnTo>
                  <a:pt x="299" y="22"/>
                </a:lnTo>
                <a:lnTo>
                  <a:pt x="305" y="28"/>
                </a:lnTo>
                <a:lnTo>
                  <a:pt x="309" y="33"/>
                </a:lnTo>
                <a:lnTo>
                  <a:pt x="313" y="39"/>
                </a:lnTo>
                <a:lnTo>
                  <a:pt x="316" y="46"/>
                </a:lnTo>
                <a:lnTo>
                  <a:pt x="318" y="52"/>
                </a:lnTo>
                <a:lnTo>
                  <a:pt x="320" y="59"/>
                </a:lnTo>
                <a:lnTo>
                  <a:pt x="321" y="67"/>
                </a:lnTo>
                <a:lnTo>
                  <a:pt x="322" y="74"/>
                </a:lnTo>
                <a:lnTo>
                  <a:pt x="321" y="81"/>
                </a:lnTo>
                <a:lnTo>
                  <a:pt x="320" y="88"/>
                </a:lnTo>
                <a:lnTo>
                  <a:pt x="318" y="95"/>
                </a:lnTo>
                <a:lnTo>
                  <a:pt x="316" y="102"/>
                </a:lnTo>
                <a:lnTo>
                  <a:pt x="313" y="108"/>
                </a:lnTo>
                <a:lnTo>
                  <a:pt x="309" y="115"/>
                </a:lnTo>
                <a:lnTo>
                  <a:pt x="305" y="120"/>
                </a:lnTo>
                <a:lnTo>
                  <a:pt x="299" y="126"/>
                </a:lnTo>
                <a:lnTo>
                  <a:pt x="293" y="130"/>
                </a:lnTo>
                <a:lnTo>
                  <a:pt x="286" y="135"/>
                </a:lnTo>
                <a:lnTo>
                  <a:pt x="280" y="138"/>
                </a:lnTo>
                <a:lnTo>
                  <a:pt x="273" y="141"/>
                </a:lnTo>
                <a:lnTo>
                  <a:pt x="266" y="143"/>
                </a:lnTo>
                <a:lnTo>
                  <a:pt x="258" y="145"/>
                </a:lnTo>
                <a:lnTo>
                  <a:pt x="250" y="146"/>
                </a:lnTo>
                <a:lnTo>
                  <a:pt x="240" y="146"/>
                </a:lnTo>
                <a:lnTo>
                  <a:pt x="232" y="146"/>
                </a:lnTo>
                <a:lnTo>
                  <a:pt x="224" y="145"/>
                </a:lnTo>
                <a:lnTo>
                  <a:pt x="216" y="143"/>
                </a:lnTo>
                <a:lnTo>
                  <a:pt x="208" y="141"/>
                </a:lnTo>
                <a:lnTo>
                  <a:pt x="201" y="138"/>
                </a:lnTo>
                <a:lnTo>
                  <a:pt x="194" y="135"/>
                </a:lnTo>
                <a:lnTo>
                  <a:pt x="188" y="131"/>
                </a:lnTo>
                <a:lnTo>
                  <a:pt x="182" y="126"/>
                </a:lnTo>
                <a:lnTo>
                  <a:pt x="177" y="121"/>
                </a:lnTo>
                <a:lnTo>
                  <a:pt x="173" y="115"/>
                </a:lnTo>
                <a:lnTo>
                  <a:pt x="169" y="108"/>
                </a:lnTo>
                <a:lnTo>
                  <a:pt x="166" y="102"/>
                </a:lnTo>
                <a:lnTo>
                  <a:pt x="163" y="96"/>
                </a:lnTo>
                <a:lnTo>
                  <a:pt x="162" y="89"/>
                </a:lnTo>
                <a:lnTo>
                  <a:pt x="161" y="82"/>
                </a:lnTo>
                <a:lnTo>
                  <a:pt x="160" y="75"/>
                </a:lnTo>
                <a:close/>
                <a:moveTo>
                  <a:pt x="171" y="74"/>
                </a:moveTo>
                <a:lnTo>
                  <a:pt x="172" y="78"/>
                </a:lnTo>
                <a:lnTo>
                  <a:pt x="174" y="81"/>
                </a:lnTo>
                <a:lnTo>
                  <a:pt x="177" y="84"/>
                </a:lnTo>
                <a:lnTo>
                  <a:pt x="181" y="86"/>
                </a:lnTo>
                <a:lnTo>
                  <a:pt x="185" y="88"/>
                </a:lnTo>
                <a:lnTo>
                  <a:pt x="191" y="89"/>
                </a:lnTo>
                <a:lnTo>
                  <a:pt x="198" y="90"/>
                </a:lnTo>
                <a:lnTo>
                  <a:pt x="209" y="91"/>
                </a:lnTo>
                <a:lnTo>
                  <a:pt x="222" y="92"/>
                </a:lnTo>
                <a:lnTo>
                  <a:pt x="237" y="92"/>
                </a:lnTo>
                <a:lnTo>
                  <a:pt x="255" y="92"/>
                </a:lnTo>
                <a:lnTo>
                  <a:pt x="269" y="91"/>
                </a:lnTo>
                <a:lnTo>
                  <a:pt x="281" y="90"/>
                </a:lnTo>
                <a:lnTo>
                  <a:pt x="290" y="89"/>
                </a:lnTo>
                <a:lnTo>
                  <a:pt x="295" y="87"/>
                </a:lnTo>
                <a:lnTo>
                  <a:pt x="300" y="86"/>
                </a:lnTo>
                <a:lnTo>
                  <a:pt x="304" y="83"/>
                </a:lnTo>
                <a:lnTo>
                  <a:pt x="307" y="81"/>
                </a:lnTo>
                <a:lnTo>
                  <a:pt x="309" y="78"/>
                </a:lnTo>
                <a:lnTo>
                  <a:pt x="309" y="74"/>
                </a:lnTo>
                <a:lnTo>
                  <a:pt x="309" y="70"/>
                </a:lnTo>
                <a:lnTo>
                  <a:pt x="307" y="67"/>
                </a:lnTo>
                <a:lnTo>
                  <a:pt x="304" y="63"/>
                </a:lnTo>
                <a:lnTo>
                  <a:pt x="300" y="61"/>
                </a:lnTo>
                <a:lnTo>
                  <a:pt x="295" y="60"/>
                </a:lnTo>
                <a:lnTo>
                  <a:pt x="290" y="58"/>
                </a:lnTo>
                <a:lnTo>
                  <a:pt x="281" y="56"/>
                </a:lnTo>
                <a:lnTo>
                  <a:pt x="270" y="55"/>
                </a:lnTo>
                <a:lnTo>
                  <a:pt x="257" y="55"/>
                </a:lnTo>
                <a:lnTo>
                  <a:pt x="240" y="54"/>
                </a:lnTo>
                <a:lnTo>
                  <a:pt x="225" y="55"/>
                </a:lnTo>
                <a:lnTo>
                  <a:pt x="211" y="55"/>
                </a:lnTo>
                <a:lnTo>
                  <a:pt x="199" y="56"/>
                </a:lnTo>
                <a:lnTo>
                  <a:pt x="190" y="58"/>
                </a:lnTo>
                <a:lnTo>
                  <a:pt x="184" y="59"/>
                </a:lnTo>
                <a:lnTo>
                  <a:pt x="180" y="61"/>
                </a:lnTo>
                <a:lnTo>
                  <a:pt x="176" y="63"/>
                </a:lnTo>
                <a:lnTo>
                  <a:pt x="174" y="67"/>
                </a:lnTo>
                <a:lnTo>
                  <a:pt x="172" y="70"/>
                </a:lnTo>
                <a:lnTo>
                  <a:pt x="171" y="74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6" name="Freeform 110"/>
          <p:cNvSpPr>
            <a:spLocks/>
          </p:cNvSpPr>
          <p:nvPr/>
        </p:nvSpPr>
        <p:spPr bwMode="auto">
          <a:xfrm>
            <a:off x="521485" y="1173469"/>
            <a:ext cx="158750" cy="49213"/>
          </a:xfrm>
          <a:custGeom>
            <a:avLst/>
            <a:gdLst>
              <a:gd name="T0" fmla="*/ 402 w 402"/>
              <a:gd name="T1" fmla="*/ 126 h 126"/>
              <a:gd name="T2" fmla="*/ 392 w 402"/>
              <a:gd name="T3" fmla="*/ 126 h 126"/>
              <a:gd name="T4" fmla="*/ 384 w 402"/>
              <a:gd name="T5" fmla="*/ 116 h 126"/>
              <a:gd name="T6" fmla="*/ 376 w 402"/>
              <a:gd name="T7" fmla="*/ 106 h 126"/>
              <a:gd name="T8" fmla="*/ 369 w 402"/>
              <a:gd name="T9" fmla="*/ 98 h 126"/>
              <a:gd name="T10" fmla="*/ 362 w 402"/>
              <a:gd name="T11" fmla="*/ 92 h 126"/>
              <a:gd name="T12" fmla="*/ 351 w 402"/>
              <a:gd name="T13" fmla="*/ 85 h 126"/>
              <a:gd name="T14" fmla="*/ 338 w 402"/>
              <a:gd name="T15" fmla="*/ 79 h 126"/>
              <a:gd name="T16" fmla="*/ 325 w 402"/>
              <a:gd name="T17" fmla="*/ 74 h 126"/>
              <a:gd name="T18" fmla="*/ 310 w 402"/>
              <a:gd name="T19" fmla="*/ 70 h 126"/>
              <a:gd name="T20" fmla="*/ 288 w 402"/>
              <a:gd name="T21" fmla="*/ 65 h 126"/>
              <a:gd name="T22" fmla="*/ 263 w 402"/>
              <a:gd name="T23" fmla="*/ 61 h 126"/>
              <a:gd name="T24" fmla="*/ 234 w 402"/>
              <a:gd name="T25" fmla="*/ 59 h 126"/>
              <a:gd name="T26" fmla="*/ 200 w 402"/>
              <a:gd name="T27" fmla="*/ 58 h 126"/>
              <a:gd name="T28" fmla="*/ 170 w 402"/>
              <a:gd name="T29" fmla="*/ 59 h 126"/>
              <a:gd name="T30" fmla="*/ 142 w 402"/>
              <a:gd name="T31" fmla="*/ 61 h 126"/>
              <a:gd name="T32" fmla="*/ 118 w 402"/>
              <a:gd name="T33" fmla="*/ 63 h 126"/>
              <a:gd name="T34" fmla="*/ 98 w 402"/>
              <a:gd name="T35" fmla="*/ 69 h 126"/>
              <a:gd name="T36" fmla="*/ 81 w 402"/>
              <a:gd name="T37" fmla="*/ 74 h 126"/>
              <a:gd name="T38" fmla="*/ 65 w 402"/>
              <a:gd name="T39" fmla="*/ 80 h 126"/>
              <a:gd name="T40" fmla="*/ 51 w 402"/>
              <a:gd name="T41" fmla="*/ 86 h 126"/>
              <a:gd name="T42" fmla="*/ 39 w 402"/>
              <a:gd name="T43" fmla="*/ 94 h 126"/>
              <a:gd name="T44" fmla="*/ 31 w 402"/>
              <a:gd name="T45" fmla="*/ 100 h 126"/>
              <a:gd name="T46" fmla="*/ 24 w 402"/>
              <a:gd name="T47" fmla="*/ 107 h 126"/>
              <a:gd name="T48" fmla="*/ 18 w 402"/>
              <a:gd name="T49" fmla="*/ 117 h 126"/>
              <a:gd name="T50" fmla="*/ 11 w 402"/>
              <a:gd name="T51" fmla="*/ 126 h 126"/>
              <a:gd name="T52" fmla="*/ 0 w 402"/>
              <a:gd name="T53" fmla="*/ 126 h 126"/>
              <a:gd name="T54" fmla="*/ 5 w 402"/>
              <a:gd name="T55" fmla="*/ 113 h 126"/>
              <a:gd name="T56" fmla="*/ 11 w 402"/>
              <a:gd name="T57" fmla="*/ 100 h 126"/>
              <a:gd name="T58" fmla="*/ 20 w 402"/>
              <a:gd name="T59" fmla="*/ 89 h 126"/>
              <a:gd name="T60" fmla="*/ 28 w 402"/>
              <a:gd name="T61" fmla="*/ 78 h 126"/>
              <a:gd name="T62" fmla="*/ 38 w 402"/>
              <a:gd name="T63" fmla="*/ 67 h 126"/>
              <a:gd name="T64" fmla="*/ 48 w 402"/>
              <a:gd name="T65" fmla="*/ 56 h 126"/>
              <a:gd name="T66" fmla="*/ 60 w 402"/>
              <a:gd name="T67" fmla="*/ 46 h 126"/>
              <a:gd name="T68" fmla="*/ 74 w 402"/>
              <a:gd name="T69" fmla="*/ 37 h 126"/>
              <a:gd name="T70" fmla="*/ 88 w 402"/>
              <a:gd name="T71" fmla="*/ 28 h 126"/>
              <a:gd name="T72" fmla="*/ 103 w 402"/>
              <a:gd name="T73" fmla="*/ 21 h 126"/>
              <a:gd name="T74" fmla="*/ 119 w 402"/>
              <a:gd name="T75" fmla="*/ 14 h 126"/>
              <a:gd name="T76" fmla="*/ 134 w 402"/>
              <a:gd name="T77" fmla="*/ 9 h 126"/>
              <a:gd name="T78" fmla="*/ 150 w 402"/>
              <a:gd name="T79" fmla="*/ 5 h 126"/>
              <a:gd name="T80" fmla="*/ 167 w 402"/>
              <a:gd name="T81" fmla="*/ 2 h 126"/>
              <a:gd name="T82" fmla="*/ 184 w 402"/>
              <a:gd name="T83" fmla="*/ 1 h 126"/>
              <a:gd name="T84" fmla="*/ 202 w 402"/>
              <a:gd name="T85" fmla="*/ 0 h 126"/>
              <a:gd name="T86" fmla="*/ 220 w 402"/>
              <a:gd name="T87" fmla="*/ 1 h 126"/>
              <a:gd name="T88" fmla="*/ 237 w 402"/>
              <a:gd name="T89" fmla="*/ 2 h 126"/>
              <a:gd name="T90" fmla="*/ 254 w 402"/>
              <a:gd name="T91" fmla="*/ 5 h 126"/>
              <a:gd name="T92" fmla="*/ 270 w 402"/>
              <a:gd name="T93" fmla="*/ 9 h 126"/>
              <a:gd name="T94" fmla="*/ 285 w 402"/>
              <a:gd name="T95" fmla="*/ 14 h 126"/>
              <a:gd name="T96" fmla="*/ 300 w 402"/>
              <a:gd name="T97" fmla="*/ 21 h 126"/>
              <a:gd name="T98" fmla="*/ 315 w 402"/>
              <a:gd name="T99" fmla="*/ 28 h 126"/>
              <a:gd name="T100" fmla="*/ 328 w 402"/>
              <a:gd name="T101" fmla="*/ 37 h 126"/>
              <a:gd name="T102" fmla="*/ 341 w 402"/>
              <a:gd name="T103" fmla="*/ 46 h 126"/>
              <a:gd name="T104" fmla="*/ 354 w 402"/>
              <a:gd name="T105" fmla="*/ 56 h 126"/>
              <a:gd name="T106" fmla="*/ 365 w 402"/>
              <a:gd name="T107" fmla="*/ 67 h 126"/>
              <a:gd name="T108" fmla="*/ 374 w 402"/>
              <a:gd name="T109" fmla="*/ 78 h 126"/>
              <a:gd name="T110" fmla="*/ 383 w 402"/>
              <a:gd name="T111" fmla="*/ 89 h 126"/>
              <a:gd name="T112" fmla="*/ 391 w 402"/>
              <a:gd name="T113" fmla="*/ 100 h 126"/>
              <a:gd name="T114" fmla="*/ 397 w 402"/>
              <a:gd name="T115" fmla="*/ 113 h 126"/>
              <a:gd name="T116" fmla="*/ 402 w 402"/>
              <a:gd name="T117" fmla="*/ 126 h 1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02" h="126">
                <a:moveTo>
                  <a:pt x="402" y="126"/>
                </a:moveTo>
                <a:lnTo>
                  <a:pt x="392" y="126"/>
                </a:lnTo>
                <a:lnTo>
                  <a:pt x="384" y="116"/>
                </a:lnTo>
                <a:lnTo>
                  <a:pt x="376" y="106"/>
                </a:lnTo>
                <a:lnTo>
                  <a:pt x="369" y="98"/>
                </a:lnTo>
                <a:lnTo>
                  <a:pt x="362" y="92"/>
                </a:lnTo>
                <a:lnTo>
                  <a:pt x="351" y="85"/>
                </a:lnTo>
                <a:lnTo>
                  <a:pt x="338" y="79"/>
                </a:lnTo>
                <a:lnTo>
                  <a:pt x="325" y="74"/>
                </a:lnTo>
                <a:lnTo>
                  <a:pt x="310" y="70"/>
                </a:lnTo>
                <a:lnTo>
                  <a:pt x="288" y="65"/>
                </a:lnTo>
                <a:lnTo>
                  <a:pt x="263" y="61"/>
                </a:lnTo>
                <a:lnTo>
                  <a:pt x="234" y="59"/>
                </a:lnTo>
                <a:lnTo>
                  <a:pt x="200" y="58"/>
                </a:lnTo>
                <a:lnTo>
                  <a:pt x="170" y="59"/>
                </a:lnTo>
                <a:lnTo>
                  <a:pt x="142" y="61"/>
                </a:lnTo>
                <a:lnTo>
                  <a:pt x="118" y="63"/>
                </a:lnTo>
                <a:lnTo>
                  <a:pt x="98" y="69"/>
                </a:lnTo>
                <a:lnTo>
                  <a:pt x="81" y="74"/>
                </a:lnTo>
                <a:lnTo>
                  <a:pt x="65" y="80"/>
                </a:lnTo>
                <a:lnTo>
                  <a:pt x="51" y="86"/>
                </a:lnTo>
                <a:lnTo>
                  <a:pt x="39" y="94"/>
                </a:lnTo>
                <a:lnTo>
                  <a:pt x="31" y="100"/>
                </a:lnTo>
                <a:lnTo>
                  <a:pt x="24" y="107"/>
                </a:lnTo>
                <a:lnTo>
                  <a:pt x="18" y="117"/>
                </a:lnTo>
                <a:lnTo>
                  <a:pt x="11" y="126"/>
                </a:lnTo>
                <a:lnTo>
                  <a:pt x="0" y="126"/>
                </a:lnTo>
                <a:lnTo>
                  <a:pt x="5" y="113"/>
                </a:lnTo>
                <a:lnTo>
                  <a:pt x="11" y="100"/>
                </a:lnTo>
                <a:lnTo>
                  <a:pt x="20" y="89"/>
                </a:lnTo>
                <a:lnTo>
                  <a:pt x="28" y="78"/>
                </a:lnTo>
                <a:lnTo>
                  <a:pt x="38" y="67"/>
                </a:lnTo>
                <a:lnTo>
                  <a:pt x="48" y="56"/>
                </a:lnTo>
                <a:lnTo>
                  <a:pt x="60" y="46"/>
                </a:lnTo>
                <a:lnTo>
                  <a:pt x="74" y="37"/>
                </a:lnTo>
                <a:lnTo>
                  <a:pt x="88" y="28"/>
                </a:lnTo>
                <a:lnTo>
                  <a:pt x="103" y="21"/>
                </a:lnTo>
                <a:lnTo>
                  <a:pt x="119" y="14"/>
                </a:lnTo>
                <a:lnTo>
                  <a:pt x="134" y="9"/>
                </a:lnTo>
                <a:lnTo>
                  <a:pt x="150" y="5"/>
                </a:lnTo>
                <a:lnTo>
                  <a:pt x="167" y="2"/>
                </a:lnTo>
                <a:lnTo>
                  <a:pt x="184" y="1"/>
                </a:lnTo>
                <a:lnTo>
                  <a:pt x="202" y="0"/>
                </a:lnTo>
                <a:lnTo>
                  <a:pt x="220" y="1"/>
                </a:lnTo>
                <a:lnTo>
                  <a:pt x="237" y="2"/>
                </a:lnTo>
                <a:lnTo>
                  <a:pt x="254" y="5"/>
                </a:lnTo>
                <a:lnTo>
                  <a:pt x="270" y="9"/>
                </a:lnTo>
                <a:lnTo>
                  <a:pt x="285" y="14"/>
                </a:lnTo>
                <a:lnTo>
                  <a:pt x="300" y="21"/>
                </a:lnTo>
                <a:lnTo>
                  <a:pt x="315" y="28"/>
                </a:lnTo>
                <a:lnTo>
                  <a:pt x="328" y="37"/>
                </a:lnTo>
                <a:lnTo>
                  <a:pt x="341" y="46"/>
                </a:lnTo>
                <a:lnTo>
                  <a:pt x="354" y="56"/>
                </a:lnTo>
                <a:lnTo>
                  <a:pt x="365" y="67"/>
                </a:lnTo>
                <a:lnTo>
                  <a:pt x="374" y="78"/>
                </a:lnTo>
                <a:lnTo>
                  <a:pt x="383" y="89"/>
                </a:lnTo>
                <a:lnTo>
                  <a:pt x="391" y="100"/>
                </a:lnTo>
                <a:lnTo>
                  <a:pt x="397" y="113"/>
                </a:lnTo>
                <a:lnTo>
                  <a:pt x="402" y="126"/>
                </a:lnTo>
                <a:close/>
              </a:path>
            </a:pathLst>
          </a:custGeom>
          <a:solidFill>
            <a:srgbClr val="332C2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7" name="Rectangle 111"/>
          <p:cNvSpPr>
            <a:spLocks noChangeArrowheads="1"/>
          </p:cNvSpPr>
          <p:nvPr/>
        </p:nvSpPr>
        <p:spPr bwMode="auto">
          <a:xfrm>
            <a:off x="1340635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8" name="Rectangle 112"/>
          <p:cNvSpPr>
            <a:spLocks noChangeArrowheads="1"/>
          </p:cNvSpPr>
          <p:nvPr/>
        </p:nvSpPr>
        <p:spPr bwMode="auto">
          <a:xfrm>
            <a:off x="1813710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9" name="Rectangle 113"/>
          <p:cNvSpPr>
            <a:spLocks noChangeArrowheads="1"/>
          </p:cNvSpPr>
          <p:nvPr/>
        </p:nvSpPr>
        <p:spPr bwMode="auto">
          <a:xfrm>
            <a:off x="2288373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0" name="Rectangle 114"/>
          <p:cNvSpPr>
            <a:spLocks noChangeArrowheads="1"/>
          </p:cNvSpPr>
          <p:nvPr/>
        </p:nvSpPr>
        <p:spPr bwMode="auto">
          <a:xfrm>
            <a:off x="2761448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1" name="Rectangle 115"/>
          <p:cNvSpPr>
            <a:spLocks noChangeArrowheads="1"/>
          </p:cNvSpPr>
          <p:nvPr/>
        </p:nvSpPr>
        <p:spPr bwMode="auto">
          <a:xfrm>
            <a:off x="3237698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2" name="Rectangle 116"/>
          <p:cNvSpPr>
            <a:spLocks noChangeArrowheads="1"/>
          </p:cNvSpPr>
          <p:nvPr/>
        </p:nvSpPr>
        <p:spPr bwMode="auto">
          <a:xfrm>
            <a:off x="3720298" y="3330881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4" name="Rectangle 117"/>
          <p:cNvSpPr>
            <a:spLocks noChangeArrowheads="1"/>
          </p:cNvSpPr>
          <p:nvPr/>
        </p:nvSpPr>
        <p:spPr bwMode="auto">
          <a:xfrm>
            <a:off x="4206073" y="3510269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6" name="Rectangle 118"/>
          <p:cNvSpPr>
            <a:spLocks noChangeArrowheads="1"/>
          </p:cNvSpPr>
          <p:nvPr/>
        </p:nvSpPr>
        <p:spPr bwMode="auto">
          <a:xfrm>
            <a:off x="5153810" y="3510269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7" name="Rectangle 119"/>
          <p:cNvSpPr>
            <a:spLocks noChangeArrowheads="1"/>
          </p:cNvSpPr>
          <p:nvPr/>
        </p:nvSpPr>
        <p:spPr bwMode="auto">
          <a:xfrm>
            <a:off x="4633110" y="3510269"/>
            <a:ext cx="2019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.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8" name="Rectangle 120"/>
          <p:cNvSpPr>
            <a:spLocks noChangeArrowheads="1"/>
          </p:cNvSpPr>
          <p:nvPr/>
        </p:nvSpPr>
        <p:spPr bwMode="auto">
          <a:xfrm>
            <a:off x="4193373" y="3091169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9" name="Rectangle 121"/>
          <p:cNvSpPr>
            <a:spLocks noChangeArrowheads="1"/>
          </p:cNvSpPr>
          <p:nvPr/>
        </p:nvSpPr>
        <p:spPr bwMode="auto">
          <a:xfrm>
            <a:off x="1791485" y="326738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0" name="Rectangle 122"/>
          <p:cNvSpPr>
            <a:spLocks noChangeArrowheads="1"/>
          </p:cNvSpPr>
          <p:nvPr/>
        </p:nvSpPr>
        <p:spPr bwMode="auto">
          <a:xfrm>
            <a:off x="2277260" y="326738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1" name="Rectangle 123"/>
          <p:cNvSpPr>
            <a:spLocks noChangeArrowheads="1"/>
          </p:cNvSpPr>
          <p:nvPr/>
        </p:nvSpPr>
        <p:spPr bwMode="auto">
          <a:xfrm>
            <a:off x="2761448" y="326738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2" name="Rectangle 124"/>
          <p:cNvSpPr>
            <a:spLocks noChangeArrowheads="1"/>
          </p:cNvSpPr>
          <p:nvPr/>
        </p:nvSpPr>
        <p:spPr bwMode="auto">
          <a:xfrm>
            <a:off x="3224998" y="326738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3" name="Rectangle 125"/>
          <p:cNvSpPr>
            <a:spLocks noChangeArrowheads="1"/>
          </p:cNvSpPr>
          <p:nvPr/>
        </p:nvSpPr>
        <p:spPr bwMode="auto">
          <a:xfrm>
            <a:off x="3759985" y="3267381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4" name="Rectangle 126"/>
          <p:cNvSpPr>
            <a:spLocks noChangeArrowheads="1"/>
          </p:cNvSpPr>
          <p:nvPr/>
        </p:nvSpPr>
        <p:spPr bwMode="auto">
          <a:xfrm>
            <a:off x="4709310" y="3267381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5" name="Rectangle 127"/>
          <p:cNvSpPr>
            <a:spLocks noChangeArrowheads="1"/>
          </p:cNvSpPr>
          <p:nvPr/>
        </p:nvSpPr>
        <p:spPr bwMode="auto">
          <a:xfrm>
            <a:off x="5182385" y="3267381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6" name="Rectangle 128"/>
          <p:cNvSpPr>
            <a:spLocks noChangeArrowheads="1"/>
          </p:cNvSpPr>
          <p:nvPr/>
        </p:nvSpPr>
        <p:spPr bwMode="auto">
          <a:xfrm>
            <a:off x="5482423" y="3227694"/>
            <a:ext cx="89928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R-42  (</a:t>
            </a:r>
            <a:r>
              <a:rPr kumimoji="0" lang="zh-TW" altLang="en-US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7" name="Rectangle 129"/>
          <p:cNvSpPr>
            <a:spLocks noChangeArrowheads="1"/>
          </p:cNvSpPr>
          <p:nvPr/>
        </p:nvSpPr>
        <p:spPr bwMode="auto">
          <a:xfrm>
            <a:off x="6061863" y="3211818"/>
            <a:ext cx="1009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4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8" name="Rectangle 130"/>
          <p:cNvSpPr>
            <a:spLocks noChangeArrowheads="1"/>
          </p:cNvSpPr>
          <p:nvPr/>
        </p:nvSpPr>
        <p:spPr bwMode="auto">
          <a:xfrm>
            <a:off x="5482423" y="3467406"/>
            <a:ext cx="81111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C (</a:t>
            </a:r>
            <a:r>
              <a:rPr kumimoji="0" lang="en-US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0" name="Rectangle 132"/>
          <p:cNvSpPr>
            <a:spLocks noChangeArrowheads="1"/>
          </p:cNvSpPr>
          <p:nvPr/>
        </p:nvSpPr>
        <p:spPr bwMode="auto">
          <a:xfrm>
            <a:off x="7044268" y="501957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1" name="Rectangle 133"/>
          <p:cNvSpPr>
            <a:spLocks noChangeArrowheads="1"/>
          </p:cNvSpPr>
          <p:nvPr/>
        </p:nvSpPr>
        <p:spPr bwMode="auto">
          <a:xfrm>
            <a:off x="7044268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2" name="Rectangle 134"/>
          <p:cNvSpPr>
            <a:spLocks noChangeArrowheads="1"/>
          </p:cNvSpPr>
          <p:nvPr/>
        </p:nvSpPr>
        <p:spPr bwMode="auto">
          <a:xfrm>
            <a:off x="7517343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3" name="Rectangle 135"/>
          <p:cNvSpPr>
            <a:spLocks noChangeArrowheads="1"/>
          </p:cNvSpPr>
          <p:nvPr/>
        </p:nvSpPr>
        <p:spPr bwMode="auto">
          <a:xfrm>
            <a:off x="7992005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4" name="Rectangle 136"/>
          <p:cNvSpPr>
            <a:spLocks noChangeArrowheads="1"/>
          </p:cNvSpPr>
          <p:nvPr/>
        </p:nvSpPr>
        <p:spPr bwMode="auto">
          <a:xfrm>
            <a:off x="8465080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5" name="Rectangle 137"/>
          <p:cNvSpPr>
            <a:spLocks noChangeArrowheads="1"/>
          </p:cNvSpPr>
          <p:nvPr/>
        </p:nvSpPr>
        <p:spPr bwMode="auto">
          <a:xfrm>
            <a:off x="8941330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6" name="Rectangle 138"/>
          <p:cNvSpPr>
            <a:spLocks noChangeArrowheads="1"/>
          </p:cNvSpPr>
          <p:nvPr/>
        </p:nvSpPr>
        <p:spPr bwMode="auto">
          <a:xfrm>
            <a:off x="9423930" y="740082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7" name="Rectangle 139"/>
          <p:cNvSpPr>
            <a:spLocks noChangeArrowheads="1"/>
          </p:cNvSpPr>
          <p:nvPr/>
        </p:nvSpPr>
        <p:spPr bwMode="auto">
          <a:xfrm>
            <a:off x="9909705" y="917882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8" name="Rectangle 140"/>
          <p:cNvSpPr>
            <a:spLocks noChangeArrowheads="1"/>
          </p:cNvSpPr>
          <p:nvPr/>
        </p:nvSpPr>
        <p:spPr bwMode="auto">
          <a:xfrm>
            <a:off x="10857443" y="917882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9" name="Rectangle 141"/>
          <p:cNvSpPr>
            <a:spLocks noChangeArrowheads="1"/>
          </p:cNvSpPr>
          <p:nvPr/>
        </p:nvSpPr>
        <p:spPr bwMode="auto">
          <a:xfrm>
            <a:off x="10336743" y="917882"/>
            <a:ext cx="2019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.5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0" name="Rectangle 142"/>
          <p:cNvSpPr>
            <a:spLocks noChangeArrowheads="1"/>
          </p:cNvSpPr>
          <p:nvPr/>
        </p:nvSpPr>
        <p:spPr bwMode="auto">
          <a:xfrm>
            <a:off x="9897005" y="500369"/>
            <a:ext cx="12824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30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1" name="Rectangle 143"/>
          <p:cNvSpPr>
            <a:spLocks noChangeArrowheads="1"/>
          </p:cNvSpPr>
          <p:nvPr/>
        </p:nvSpPr>
        <p:spPr bwMode="auto">
          <a:xfrm>
            <a:off x="7495118" y="67658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2" name="Rectangle 144"/>
          <p:cNvSpPr>
            <a:spLocks noChangeArrowheads="1"/>
          </p:cNvSpPr>
          <p:nvPr/>
        </p:nvSpPr>
        <p:spPr bwMode="auto">
          <a:xfrm>
            <a:off x="7980893" y="67658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3" name="Rectangle 145"/>
          <p:cNvSpPr>
            <a:spLocks noChangeArrowheads="1"/>
          </p:cNvSpPr>
          <p:nvPr/>
        </p:nvSpPr>
        <p:spPr bwMode="auto">
          <a:xfrm>
            <a:off x="8463493" y="67658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4" name="Rectangle 146"/>
          <p:cNvSpPr>
            <a:spLocks noChangeArrowheads="1"/>
          </p:cNvSpPr>
          <p:nvPr/>
        </p:nvSpPr>
        <p:spPr bwMode="auto">
          <a:xfrm>
            <a:off x="8928630" y="67658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5" name="Rectangle 147"/>
          <p:cNvSpPr>
            <a:spLocks noChangeArrowheads="1"/>
          </p:cNvSpPr>
          <p:nvPr/>
        </p:nvSpPr>
        <p:spPr bwMode="auto">
          <a:xfrm>
            <a:off x="9463618" y="676582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6" name="Rectangle 148"/>
          <p:cNvSpPr>
            <a:spLocks noChangeArrowheads="1"/>
          </p:cNvSpPr>
          <p:nvPr/>
        </p:nvSpPr>
        <p:spPr bwMode="auto">
          <a:xfrm>
            <a:off x="10412943" y="676582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7" name="Rectangle 149"/>
          <p:cNvSpPr>
            <a:spLocks noChangeArrowheads="1"/>
          </p:cNvSpPr>
          <p:nvPr/>
        </p:nvSpPr>
        <p:spPr bwMode="auto">
          <a:xfrm>
            <a:off x="10886018" y="676582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900" b="1" i="0" u="none" strike="noStrike" cap="none" normalizeH="0" baseline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8" name="Rectangle 150"/>
          <p:cNvSpPr>
            <a:spLocks noChangeArrowheads="1"/>
          </p:cNvSpPr>
          <p:nvPr/>
        </p:nvSpPr>
        <p:spPr bwMode="auto">
          <a:xfrm>
            <a:off x="11186055" y="636894"/>
            <a:ext cx="89928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R-42  (</a:t>
            </a:r>
            <a:r>
              <a:rPr kumimoji="0" lang="en-US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9" name="Rectangle 151"/>
          <p:cNvSpPr>
            <a:spLocks noChangeArrowheads="1"/>
          </p:cNvSpPr>
          <p:nvPr/>
        </p:nvSpPr>
        <p:spPr bwMode="auto">
          <a:xfrm>
            <a:off x="11771721" y="621019"/>
            <a:ext cx="1009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4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2" name="Rectangle 154"/>
          <p:cNvSpPr>
            <a:spLocks noChangeArrowheads="1"/>
          </p:cNvSpPr>
          <p:nvPr/>
        </p:nvSpPr>
        <p:spPr bwMode="auto">
          <a:xfrm>
            <a:off x="72222" y="625781"/>
            <a:ext cx="2244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en-US" altLang="zh-TW" sz="1800" b="0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3" name="Rectangle 155"/>
          <p:cNvSpPr>
            <a:spLocks noChangeArrowheads="1"/>
          </p:cNvSpPr>
          <p:nvPr/>
        </p:nvSpPr>
        <p:spPr bwMode="auto">
          <a:xfrm>
            <a:off x="5783793" y="657532"/>
            <a:ext cx="2115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0" lang="en-US" altLang="zh-TW" sz="1800" b="0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30"/>
          <p:cNvSpPr>
            <a:spLocks noChangeArrowheads="1"/>
          </p:cNvSpPr>
          <p:nvPr/>
        </p:nvSpPr>
        <p:spPr bwMode="auto">
          <a:xfrm>
            <a:off x="11184880" y="929104"/>
            <a:ext cx="81111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C (</a:t>
            </a:r>
            <a:r>
              <a:rPr kumimoji="0" lang="en-US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0" lang="zh-TW" altLang="zh-TW" sz="13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91"/>
          <p:cNvSpPr>
            <a:spLocks noChangeArrowheads="1"/>
          </p:cNvSpPr>
          <p:nvPr/>
        </p:nvSpPr>
        <p:spPr bwMode="auto">
          <a:xfrm>
            <a:off x="6348028" y="1299403"/>
            <a:ext cx="46487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l-GR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kumimoji="0" lang="zh-TW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kumimoji="0" lang="en-US" altLang="zh-TW" sz="1200" b="1" i="0" u="none" strike="noStrike" cap="none" normalizeH="0" baseline="-2500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zh-TW" altLang="zh-TW" sz="12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X</a:t>
            </a:r>
            <a:endParaRPr kumimoji="0" lang="zh-TW" altLang="zh-TW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字方塊 152"/>
          <p:cNvSpPr txBox="1"/>
          <p:nvPr/>
        </p:nvSpPr>
        <p:spPr>
          <a:xfrm>
            <a:off x="2507941" y="4266962"/>
            <a:ext cx="71798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1. The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-42-mediated cytotoxicity and DNA damage could not be restored by NAC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OS scavenger NAC could not restore cell growth inhibited by AR-42 in BxPC-3 cells. Cells were treated with DMSO or indicated concentration of AR-42 with/without the presence of NAC for 24 h and cell viability was determined by MTT assays. Data are presented as mean </a:t>
            </a:r>
            <a:r>
              <a:rPr lang="zh-TW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deviation  from three individual experiments. *** P &lt; 0.001. (B) Effects of AR-42 with NAC on the expression of γH</a:t>
            </a:r>
            <a:r>
              <a:rPr lang="en-US" altLang="zh-TW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 in BxPC-3 cells. Cells were treated with DMSO or indicated concentration of AR-42 with/without the presence of NAC for 24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4298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9</TotalTime>
  <Words>219</Words>
  <Application>Microsoft Office PowerPoint</Application>
  <PresentationFormat>自訂</PresentationFormat>
  <Paragraphs>62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Brook Chen</dc:creator>
  <cp:lastModifiedBy>User</cp:lastModifiedBy>
  <cp:revision>22</cp:revision>
  <dcterms:created xsi:type="dcterms:W3CDTF">2017-03-10T03:09:11Z</dcterms:created>
  <dcterms:modified xsi:type="dcterms:W3CDTF">2017-03-12T15:56:07Z</dcterms:modified>
</cp:coreProperties>
</file>